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1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10FF"/>
    <a:srgbClr val="005300"/>
    <a:srgbClr val="00FFE4"/>
    <a:srgbClr val="FFAFBE"/>
    <a:srgbClr val="01077F"/>
    <a:srgbClr val="BCBDFF"/>
    <a:srgbClr val="FF6769"/>
    <a:srgbClr val="8086FF"/>
    <a:srgbClr val="6771FF"/>
    <a:srgbClr val="FFC9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2E708B4-8141-0742-A117-E709E0FBB52E}" v="3" dt="2025-11-15T15:18:46.27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379" autoAdjust="0"/>
    <p:restoredTop sz="95741"/>
  </p:normalViewPr>
  <p:slideViewPr>
    <p:cSldViewPr snapToGrid="0" snapToObjects="1">
      <p:cViewPr varScale="1">
        <p:scale>
          <a:sx n="78" d="100"/>
          <a:sy n="78" d="100"/>
        </p:scale>
        <p:origin x="872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yesha Shafi" userId="75ef1296-0a29-4795-a39c-cc19b40d46a0" providerId="ADAL" clId="{414BF8BE-ABAB-4A48-8DD8-C04F04EE880A}"/>
    <pc:docChg chg="undo custSel addSld modSld">
      <pc:chgData name="Ayesha Shafi" userId="75ef1296-0a29-4795-a39c-cc19b40d46a0" providerId="ADAL" clId="{414BF8BE-ABAB-4A48-8DD8-C04F04EE880A}" dt="2024-12-10T16:41:59.525" v="223" actId="1036"/>
      <pc:docMkLst>
        <pc:docMk/>
      </pc:docMkLst>
      <pc:sldChg chg="modSp mod">
        <pc:chgData name="Ayesha Shafi" userId="75ef1296-0a29-4795-a39c-cc19b40d46a0" providerId="ADAL" clId="{414BF8BE-ABAB-4A48-8DD8-C04F04EE880A}" dt="2024-12-10T16:39:47.380" v="176" actId="113"/>
        <pc:sldMkLst>
          <pc:docMk/>
          <pc:sldMk cId="2236825674" sldId="264"/>
        </pc:sldMkLst>
        <pc:spChg chg="mod">
          <ac:chgData name="Ayesha Shafi" userId="75ef1296-0a29-4795-a39c-cc19b40d46a0" providerId="ADAL" clId="{414BF8BE-ABAB-4A48-8DD8-C04F04EE880A}" dt="2024-12-10T16:39:47.380" v="176" actId="113"/>
          <ac:spMkLst>
            <pc:docMk/>
            <pc:sldMk cId="2236825674" sldId="264"/>
            <ac:spMk id="60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39:13.253" v="156" actId="1076"/>
          <ac:spMkLst>
            <pc:docMk/>
            <pc:sldMk cId="2236825674" sldId="264"/>
            <ac:spMk id="63" creationId="{00000000-0000-0000-0000-000000000000}"/>
          </ac:spMkLst>
        </pc:spChg>
      </pc:sldChg>
      <pc:sldChg chg="modSp mod">
        <pc:chgData name="Ayesha Shafi" userId="75ef1296-0a29-4795-a39c-cc19b40d46a0" providerId="ADAL" clId="{414BF8BE-ABAB-4A48-8DD8-C04F04EE880A}" dt="2024-12-10T16:39:59.482" v="178" actId="113"/>
        <pc:sldMkLst>
          <pc:docMk/>
          <pc:sldMk cId="2753215545" sldId="291"/>
        </pc:sldMkLst>
        <pc:spChg chg="mod">
          <ac:chgData name="Ayesha Shafi" userId="75ef1296-0a29-4795-a39c-cc19b40d46a0" providerId="ADAL" clId="{414BF8BE-ABAB-4A48-8DD8-C04F04EE880A}" dt="2024-12-10T16:39:59.482" v="178" actId="113"/>
          <ac:spMkLst>
            <pc:docMk/>
            <pc:sldMk cId="2753215545" sldId="291"/>
            <ac:spMk id="82" creationId="{E07F2A6C-3C4E-D841-81EA-90184A4C530B}"/>
          </ac:spMkLst>
        </pc:spChg>
      </pc:sldChg>
      <pc:sldChg chg="addSp delSp modSp mod">
        <pc:chgData name="Ayesha Shafi" userId="75ef1296-0a29-4795-a39c-cc19b40d46a0" providerId="ADAL" clId="{414BF8BE-ABAB-4A48-8DD8-C04F04EE880A}" dt="2024-12-10T16:41:59.525" v="223" actId="1036"/>
        <pc:sldMkLst>
          <pc:docMk/>
          <pc:sldMk cId="1713723769" sldId="293"/>
        </pc:sldMkLst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" creationId="{93235ECC-313C-A840-8745-B71E31A38D18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3" creationId="{191E8B60-1E02-2C41-9D7B-B06B22506841}"/>
          </ac:spMkLst>
        </pc:spChg>
        <pc:spChg chg="add del mod">
          <ac:chgData name="Ayesha Shafi" userId="75ef1296-0a29-4795-a39c-cc19b40d46a0" providerId="ADAL" clId="{414BF8BE-ABAB-4A48-8DD8-C04F04EE880A}" dt="2024-12-10T16:41:30.543" v="209"/>
          <ac:spMkLst>
            <pc:docMk/>
            <pc:sldMk cId="1713723769" sldId="293"/>
            <ac:spMk id="6" creationId="{0E899BC6-B97F-0FFD-D896-8B48B7190FEF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8" creationId="{FAE6485D-C704-7E4C-8DD5-1086BC5F9169}"/>
          </ac:spMkLst>
        </pc:spChg>
        <pc:spChg chg="add del mod">
          <ac:chgData name="Ayesha Shafi" userId="75ef1296-0a29-4795-a39c-cc19b40d46a0" providerId="ADAL" clId="{414BF8BE-ABAB-4A48-8DD8-C04F04EE880A}" dt="2024-12-10T16:41:30.543" v="209"/>
          <ac:spMkLst>
            <pc:docMk/>
            <pc:sldMk cId="1713723769" sldId="293"/>
            <ac:spMk id="9" creationId="{3081FB8A-B1B5-6292-668C-173511AE18D2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17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18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43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81" creationId="{466D49FF-0583-C043-A2CB-39D31746BB1F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82" creationId="{3C98BD2B-606A-0D42-B6CE-482507EDD398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83" creationId="{318424DF-7503-854A-BD18-42A09C1CB3EC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84" creationId="{3A743C78-8F13-5240-9E34-F5F5C1D795FB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85" creationId="{B3126CF8-DB9A-CA48-8B53-00B16531CAF6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91" creationId="{00E4F677-A7F4-EF45-A686-616852B4E1B4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100" creationId="{D4D27D21-43BE-AC48-A1DB-8346161566DC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126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140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151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157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10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20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26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46" creationId="{8A006526-1E04-4544-9000-801ABF544FCA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47" creationId="{4B6F6D1F-3517-F84E-A89C-A79CF451039A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56" creationId="{4BB976D2-318B-8D43-AE97-15DAEDE9FD55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58" creationId="{0DFEA98C-6455-6144-B9C9-5CEB0508E365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59" creationId="{5A7C34B9-8CE5-0642-8C45-8CD3C8C551C7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60" creationId="{6701E26D-7334-1D46-9CA9-8348810A4EE7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61" creationId="{141B2B6C-2E06-8744-9483-9A6DF767501C}"/>
          </ac:spMkLst>
        </pc:spChg>
        <pc:spChg chg="del mod">
          <ac:chgData name="Ayesha Shafi" userId="75ef1296-0a29-4795-a39c-cc19b40d46a0" providerId="ADAL" clId="{414BF8BE-ABAB-4A48-8DD8-C04F04EE880A}" dt="2024-12-10T16:41:40.971" v="213" actId="21"/>
          <ac:spMkLst>
            <pc:docMk/>
            <pc:sldMk cId="1713723769" sldId="293"/>
            <ac:spMk id="265" creationId="{13AF0A25-426E-084B-A5EC-69690C4284B4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72" creationId="{00000000-0000-0000-0000-000000000000}"/>
          </ac:spMkLst>
        </pc:spChg>
        <pc:spChg chg="mod">
          <ac:chgData name="Ayesha Shafi" userId="75ef1296-0a29-4795-a39c-cc19b40d46a0" providerId="ADAL" clId="{414BF8BE-ABAB-4A48-8DD8-C04F04EE880A}" dt="2024-12-10T16:41:59.525" v="223" actId="1036"/>
          <ac:spMkLst>
            <pc:docMk/>
            <pc:sldMk cId="1713723769" sldId="293"/>
            <ac:spMk id="275" creationId="{00000000-0000-0000-0000-000000000000}"/>
          </ac:spMkLst>
        </pc:s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4" creationId="{BF154D47-02DA-0948-9BC9-C44C9C60F65C}"/>
          </ac:grpSpMkLst>
        </pc:gr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30" creationId="{EC4C78DC-F3CB-4040-B8D7-B9BEF81CA40C}"/>
          </ac:grpSpMkLst>
        </pc:gr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33" creationId="{7989AA1A-AAD1-7840-A116-E67199D2E8FA}"/>
          </ac:grpSpMkLst>
        </pc:gr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34" creationId="{A685FF13-25D3-AB45-B98C-7B377C701C21}"/>
          </ac:grpSpMkLst>
        </pc:gr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39" creationId="{CEE7D504-D69B-974A-9646-3F5F5A188263}"/>
          </ac:grpSpMkLst>
        </pc:gr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40" creationId="{FF4D2750-DFCD-FF40-97F6-7A4ACD5C0973}"/>
          </ac:grpSpMkLst>
        </pc:gr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92" creationId="{4B49F44C-16FC-AE4C-A570-2BE2191F6AE3}"/>
          </ac:grpSpMkLst>
        </pc:grpChg>
        <pc:grpChg chg="mod">
          <ac:chgData name="Ayesha Shafi" userId="75ef1296-0a29-4795-a39c-cc19b40d46a0" providerId="ADAL" clId="{414BF8BE-ABAB-4A48-8DD8-C04F04EE880A}" dt="2024-12-10T16:41:59.525" v="223" actId="1036"/>
          <ac:grpSpMkLst>
            <pc:docMk/>
            <pc:sldMk cId="1713723769" sldId="293"/>
            <ac:grpSpMk id="248" creationId="{CD0414A6-5678-9240-9E01-72B57C4B576B}"/>
          </ac:grpSpMkLst>
        </pc:grpChg>
        <pc:picChg chg="mod">
          <ac:chgData name="Ayesha Shafi" userId="75ef1296-0a29-4795-a39c-cc19b40d46a0" providerId="ADAL" clId="{414BF8BE-ABAB-4A48-8DD8-C04F04EE880A}" dt="2024-12-10T16:41:59.525" v="223" actId="1036"/>
          <ac:picMkLst>
            <pc:docMk/>
            <pc:sldMk cId="1713723769" sldId="293"/>
            <ac:picMk id="5" creationId="{952C8920-B863-A44D-BC07-D021E00BAD37}"/>
          </ac:picMkLst>
        </pc:picChg>
        <pc:picChg chg="mod">
          <ac:chgData name="Ayesha Shafi" userId="75ef1296-0a29-4795-a39c-cc19b40d46a0" providerId="ADAL" clId="{414BF8BE-ABAB-4A48-8DD8-C04F04EE880A}" dt="2024-12-10T16:41:59.525" v="223" actId="1036"/>
          <ac:picMkLst>
            <pc:docMk/>
            <pc:sldMk cId="1713723769" sldId="293"/>
            <ac:picMk id="19" creationId="{37A8FFC7-5F43-1A40-8066-B62D0A7CC389}"/>
          </ac:picMkLst>
        </pc:picChg>
        <pc:picChg chg="mod">
          <ac:chgData name="Ayesha Shafi" userId="75ef1296-0a29-4795-a39c-cc19b40d46a0" providerId="ADAL" clId="{414BF8BE-ABAB-4A48-8DD8-C04F04EE880A}" dt="2024-12-10T16:41:59.525" v="223" actId="1036"/>
          <ac:picMkLst>
            <pc:docMk/>
            <pc:sldMk cId="1713723769" sldId="293"/>
            <ac:picMk id="31" creationId="{9FB09AFF-0746-F249-A8DE-8AB0ED0673E4}"/>
          </ac:picMkLst>
        </pc:picChg>
        <pc:picChg chg="mod">
          <ac:chgData name="Ayesha Shafi" userId="75ef1296-0a29-4795-a39c-cc19b40d46a0" providerId="ADAL" clId="{414BF8BE-ABAB-4A48-8DD8-C04F04EE880A}" dt="2024-12-10T16:41:59.525" v="223" actId="1036"/>
          <ac:picMkLst>
            <pc:docMk/>
            <pc:sldMk cId="1713723769" sldId="293"/>
            <ac:picMk id="36" creationId="{F4B042D0-A300-2441-8C71-6214D0D82C41}"/>
          </ac:picMkLst>
        </pc:picChg>
        <pc:picChg chg="mod">
          <ac:chgData name="Ayesha Shafi" userId="75ef1296-0a29-4795-a39c-cc19b40d46a0" providerId="ADAL" clId="{414BF8BE-ABAB-4A48-8DD8-C04F04EE880A}" dt="2024-12-10T16:41:59.525" v="223" actId="1036"/>
          <ac:picMkLst>
            <pc:docMk/>
            <pc:sldMk cId="1713723769" sldId="293"/>
            <ac:picMk id="38" creationId="{A1594E20-A446-F84A-86FE-14E8A75781AA}"/>
          </ac:picMkLst>
        </pc:picChg>
        <pc:picChg chg="mod">
          <ac:chgData name="Ayesha Shafi" userId="75ef1296-0a29-4795-a39c-cc19b40d46a0" providerId="ADAL" clId="{414BF8BE-ABAB-4A48-8DD8-C04F04EE880A}" dt="2024-12-10T16:41:59.525" v="223" actId="1036"/>
          <ac:picMkLst>
            <pc:docMk/>
            <pc:sldMk cId="1713723769" sldId="293"/>
            <ac:picMk id="44" creationId="{29CB4D45-95E2-D549-A4CD-5869FC5B713D}"/>
          </ac:picMkLst>
        </pc:picChg>
        <pc:cxnChg chg="mod">
          <ac:chgData name="Ayesha Shafi" userId="75ef1296-0a29-4795-a39c-cc19b40d46a0" providerId="ADAL" clId="{414BF8BE-ABAB-4A48-8DD8-C04F04EE880A}" dt="2024-12-10T16:41:59.525" v="223" actId="1036"/>
          <ac:cxnSpMkLst>
            <pc:docMk/>
            <pc:sldMk cId="1713723769" sldId="293"/>
            <ac:cxnSpMk id="7" creationId="{7C332275-E686-A149-8586-45FDEB93CA92}"/>
          </ac:cxnSpMkLst>
        </pc:cxnChg>
        <pc:cxnChg chg="mod">
          <ac:chgData name="Ayesha Shafi" userId="75ef1296-0a29-4795-a39c-cc19b40d46a0" providerId="ADAL" clId="{414BF8BE-ABAB-4A48-8DD8-C04F04EE880A}" dt="2024-12-10T16:41:59.525" v="223" actId="1036"/>
          <ac:cxnSpMkLst>
            <pc:docMk/>
            <pc:sldMk cId="1713723769" sldId="293"/>
            <ac:cxnSpMk id="42" creationId="{00000000-0000-0000-0000-000000000000}"/>
          </ac:cxnSpMkLst>
        </pc:cxnChg>
        <pc:cxnChg chg="mod">
          <ac:chgData name="Ayesha Shafi" userId="75ef1296-0a29-4795-a39c-cc19b40d46a0" providerId="ADAL" clId="{414BF8BE-ABAB-4A48-8DD8-C04F04EE880A}" dt="2024-12-10T16:41:59.525" v="223" actId="1036"/>
          <ac:cxnSpMkLst>
            <pc:docMk/>
            <pc:sldMk cId="1713723769" sldId="293"/>
            <ac:cxnSpMk id="99" creationId="{8B24F860-B1A6-7E43-9425-3044EE08026A}"/>
          </ac:cxnSpMkLst>
        </pc:cxnChg>
        <pc:cxnChg chg="mod">
          <ac:chgData name="Ayesha Shafi" userId="75ef1296-0a29-4795-a39c-cc19b40d46a0" providerId="ADAL" clId="{414BF8BE-ABAB-4A48-8DD8-C04F04EE880A}" dt="2024-12-10T16:41:59.525" v="223" actId="1036"/>
          <ac:cxnSpMkLst>
            <pc:docMk/>
            <pc:sldMk cId="1713723769" sldId="293"/>
            <ac:cxnSpMk id="219" creationId="{00000000-0000-0000-0000-000000000000}"/>
          </ac:cxnSpMkLst>
        </pc:cxnChg>
      </pc:sldChg>
      <pc:sldChg chg="modSp mod">
        <pc:chgData name="Ayesha Shafi" userId="75ef1296-0a29-4795-a39c-cc19b40d46a0" providerId="ADAL" clId="{414BF8BE-ABAB-4A48-8DD8-C04F04EE880A}" dt="2024-12-10T16:41:23.471" v="207" actId="113"/>
        <pc:sldMkLst>
          <pc:docMk/>
          <pc:sldMk cId="1290727870" sldId="298"/>
        </pc:sldMkLst>
        <pc:spChg chg="mod">
          <ac:chgData name="Ayesha Shafi" userId="75ef1296-0a29-4795-a39c-cc19b40d46a0" providerId="ADAL" clId="{414BF8BE-ABAB-4A48-8DD8-C04F04EE880A}" dt="2024-12-10T16:41:23.471" v="207" actId="113"/>
          <ac:spMkLst>
            <pc:docMk/>
            <pc:sldMk cId="1290727870" sldId="298"/>
            <ac:spMk id="7" creationId="{00000000-0000-0000-0000-000000000000}"/>
          </ac:spMkLst>
        </pc:spChg>
      </pc:sldChg>
      <pc:sldChg chg="modSp mod">
        <pc:chgData name="Ayesha Shafi" userId="75ef1296-0a29-4795-a39c-cc19b40d46a0" providerId="ADAL" clId="{414BF8BE-ABAB-4A48-8DD8-C04F04EE880A}" dt="2024-12-10T16:40:51.032" v="202" actId="113"/>
        <pc:sldMkLst>
          <pc:docMk/>
          <pc:sldMk cId="3784057363" sldId="304"/>
        </pc:sldMkLst>
        <pc:spChg chg="mod">
          <ac:chgData name="Ayesha Shafi" userId="75ef1296-0a29-4795-a39c-cc19b40d46a0" providerId="ADAL" clId="{414BF8BE-ABAB-4A48-8DD8-C04F04EE880A}" dt="2024-12-10T16:40:51.032" v="202" actId="113"/>
          <ac:spMkLst>
            <pc:docMk/>
            <pc:sldMk cId="3784057363" sldId="304"/>
            <ac:spMk id="5" creationId="{56944692-9272-E245-B7FE-103ED400F3E4}"/>
          </ac:spMkLst>
        </pc:spChg>
      </pc:sldChg>
      <pc:sldChg chg="addSp modSp mod">
        <pc:chgData name="Ayesha Shafi" userId="75ef1296-0a29-4795-a39c-cc19b40d46a0" providerId="ADAL" clId="{414BF8BE-ABAB-4A48-8DD8-C04F04EE880A}" dt="2024-12-10T16:39:35.848" v="174" actId="113"/>
        <pc:sldMkLst>
          <pc:docMk/>
          <pc:sldMk cId="1908151364" sldId="306"/>
        </pc:sldMkLst>
        <pc:spChg chg="add mod">
          <ac:chgData name="Ayesha Shafi" userId="75ef1296-0a29-4795-a39c-cc19b40d46a0" providerId="ADAL" clId="{414BF8BE-ABAB-4A48-8DD8-C04F04EE880A}" dt="2024-12-10T16:39:16.248" v="157"/>
          <ac:spMkLst>
            <pc:docMk/>
            <pc:sldMk cId="1908151364" sldId="306"/>
            <ac:spMk id="3" creationId="{DE242FEF-A4A9-99D4-2D43-F9727CC57463}"/>
          </ac:spMkLst>
        </pc:spChg>
        <pc:spChg chg="add mod">
          <ac:chgData name="Ayesha Shafi" userId="75ef1296-0a29-4795-a39c-cc19b40d46a0" providerId="ADAL" clId="{414BF8BE-ABAB-4A48-8DD8-C04F04EE880A}" dt="2024-12-10T16:39:16.248" v="157"/>
          <ac:spMkLst>
            <pc:docMk/>
            <pc:sldMk cId="1908151364" sldId="306"/>
            <ac:spMk id="5" creationId="{D7EC6B82-2D89-59DD-1C66-EB5D714F9EE6}"/>
          </ac:spMkLst>
        </pc:spChg>
        <pc:spChg chg="mod">
          <ac:chgData name="Ayesha Shafi" userId="75ef1296-0a29-4795-a39c-cc19b40d46a0" providerId="ADAL" clId="{414BF8BE-ABAB-4A48-8DD8-C04F04EE880A}" dt="2024-12-10T16:39:35.848" v="174" actId="113"/>
          <ac:spMkLst>
            <pc:docMk/>
            <pc:sldMk cId="1908151364" sldId="306"/>
            <ac:spMk id="68" creationId="{EDE3D16D-9337-5F4C-8DD0-9FF539A00BED}"/>
          </ac:spMkLst>
        </pc:spChg>
      </pc:sldChg>
      <pc:sldChg chg="modSp mod">
        <pc:chgData name="Ayesha Shafi" userId="75ef1296-0a29-4795-a39c-cc19b40d46a0" providerId="ADAL" clId="{414BF8BE-ABAB-4A48-8DD8-C04F04EE880A}" dt="2024-12-10T16:40:30.320" v="197" actId="1076"/>
        <pc:sldMkLst>
          <pc:docMk/>
          <pc:sldMk cId="3568589375" sldId="308"/>
        </pc:sldMkLst>
        <pc:spChg chg="mod">
          <ac:chgData name="Ayesha Shafi" userId="75ef1296-0a29-4795-a39c-cc19b40d46a0" providerId="ADAL" clId="{414BF8BE-ABAB-4A48-8DD8-C04F04EE880A}" dt="2024-12-10T16:40:30.320" v="197" actId="1076"/>
          <ac:spMkLst>
            <pc:docMk/>
            <pc:sldMk cId="3568589375" sldId="308"/>
            <ac:spMk id="8" creationId="{1C030516-598A-2BEA-9571-8AD95627B3D3}"/>
          </ac:spMkLst>
        </pc:spChg>
      </pc:sldChg>
      <pc:sldChg chg="addSp delSp modSp add mod">
        <pc:chgData name="Ayesha Shafi" userId="75ef1296-0a29-4795-a39c-cc19b40d46a0" providerId="ADAL" clId="{414BF8BE-ABAB-4A48-8DD8-C04F04EE880A}" dt="2024-12-10T16:41:49.607" v="216" actId="113"/>
        <pc:sldMkLst>
          <pc:docMk/>
          <pc:sldMk cId="2412576379" sldId="309"/>
        </pc:sldMkLst>
        <pc:spChg chg="add mod">
          <ac:chgData name="Ayesha Shafi" userId="75ef1296-0a29-4795-a39c-cc19b40d46a0" providerId="ADAL" clId="{414BF8BE-ABAB-4A48-8DD8-C04F04EE880A}" dt="2024-12-10T16:41:49.607" v="216" actId="113"/>
          <ac:spMkLst>
            <pc:docMk/>
            <pc:sldMk cId="2412576379" sldId="309"/>
            <ac:spMk id="2" creationId="{ABB205FB-416C-B9A7-A488-813AFC376279}"/>
          </ac:spMkLst>
        </pc:spChg>
        <pc:spChg chg="del mod">
          <ac:chgData name="Ayesha Shafi" userId="75ef1296-0a29-4795-a39c-cc19b40d46a0" providerId="ADAL" clId="{414BF8BE-ABAB-4A48-8DD8-C04F04EE880A}" dt="2024-12-10T16:41:37.155" v="212" actId="478"/>
          <ac:spMkLst>
            <pc:docMk/>
            <pc:sldMk cId="2412576379" sldId="309"/>
            <ac:spMk id="7" creationId="{00000000-0000-0000-0000-000000000000}"/>
          </ac:spMkLst>
        </pc:spChg>
      </pc:sldChg>
    </pc:docChg>
  </pc:docChgLst>
  <pc:docChgLst>
    <pc:chgData name="Ayesha Shafi" userId="75ef1296-0a29-4795-a39c-cc19b40d46a0" providerId="ADAL" clId="{39ECAFBE-B189-3548-B0DF-F72E4EAEA932}"/>
    <pc:docChg chg="undo custSel modSld">
      <pc:chgData name="Ayesha Shafi" userId="75ef1296-0a29-4795-a39c-cc19b40d46a0" providerId="ADAL" clId="{39ECAFBE-B189-3548-B0DF-F72E4EAEA932}" dt="2025-10-01T19:41:04.653" v="735" actId="207"/>
      <pc:docMkLst>
        <pc:docMk/>
      </pc:docMkLst>
      <pc:sldChg chg="addSp delSp modSp mod">
        <pc:chgData name="Ayesha Shafi" userId="75ef1296-0a29-4795-a39c-cc19b40d46a0" providerId="ADAL" clId="{39ECAFBE-B189-3548-B0DF-F72E4EAEA932}" dt="2025-10-01T18:00:48.360" v="319" actId="164"/>
        <pc:sldMkLst>
          <pc:docMk/>
          <pc:sldMk cId="1713723769" sldId="293"/>
        </pc:sldMkLst>
        <pc:spChg chg="add del mod">
          <ac:chgData name="Ayesha Shafi" userId="75ef1296-0a29-4795-a39c-cc19b40d46a0" providerId="ADAL" clId="{39ECAFBE-B189-3548-B0DF-F72E4EAEA932}" dt="2025-10-01T17:57:45.283" v="89"/>
          <ac:spMkLst>
            <pc:docMk/>
            <pc:sldMk cId="1713723769" sldId="293"/>
            <ac:spMk id="8" creationId="{7361214A-1997-B76D-DDE9-73B58690683A}"/>
          </ac:spMkLst>
        </pc:spChg>
        <pc:spChg chg="mod">
          <ac:chgData name="Ayesha Shafi" userId="75ef1296-0a29-4795-a39c-cc19b40d46a0" providerId="ADAL" clId="{39ECAFBE-B189-3548-B0DF-F72E4EAEA932}" dt="2025-10-01T17:50:33.558" v="51" actId="1038"/>
          <ac:spMkLst>
            <pc:docMk/>
            <pc:sldMk cId="1713723769" sldId="293"/>
            <ac:spMk id="15" creationId="{0459B727-250E-2F68-30D9-7137697415E6}"/>
          </ac:spMkLst>
        </pc:spChg>
        <pc:spChg chg="mod">
          <ac:chgData name="Ayesha Shafi" userId="75ef1296-0a29-4795-a39c-cc19b40d46a0" providerId="ADAL" clId="{39ECAFBE-B189-3548-B0DF-F72E4EAEA932}" dt="2025-10-01T17:50:40.401" v="52"/>
          <ac:spMkLst>
            <pc:docMk/>
            <pc:sldMk cId="1713723769" sldId="293"/>
            <ac:spMk id="23" creationId="{7DEBC512-5845-75D4-8C83-D47F50799484}"/>
          </ac:spMkLst>
        </pc:spChg>
        <pc:grpChg chg="mod">
          <ac:chgData name="Ayesha Shafi" userId="75ef1296-0a29-4795-a39c-cc19b40d46a0" providerId="ADAL" clId="{39ECAFBE-B189-3548-B0DF-F72E4EAEA932}" dt="2025-10-01T18:00:17.851" v="297" actId="1076"/>
          <ac:grpSpMkLst>
            <pc:docMk/>
            <pc:sldMk cId="1713723769" sldId="293"/>
            <ac:grpSpMk id="7" creationId="{DB031A50-FB1B-A8F7-FA56-4B6373563250}"/>
          </ac:grpSpMkLst>
        </pc:grpChg>
        <pc:grpChg chg="add mod">
          <ac:chgData name="Ayesha Shafi" userId="75ef1296-0a29-4795-a39c-cc19b40d46a0" providerId="ADAL" clId="{39ECAFBE-B189-3548-B0DF-F72E4EAEA932}" dt="2025-10-01T18:00:38.067" v="318" actId="1036"/>
          <ac:grpSpMkLst>
            <pc:docMk/>
            <pc:sldMk cId="1713723769" sldId="293"/>
            <ac:grpSpMk id="22" creationId="{BB010BAA-9B0B-4B50-238E-F7ED28B26C2E}"/>
          </ac:grpSpMkLst>
        </pc:grpChg>
        <pc:grpChg chg="add mod">
          <ac:chgData name="Ayesha Shafi" userId="75ef1296-0a29-4795-a39c-cc19b40d46a0" providerId="ADAL" clId="{39ECAFBE-B189-3548-B0DF-F72E4EAEA932}" dt="2025-10-01T18:00:17.851" v="297" actId="1076"/>
          <ac:grpSpMkLst>
            <pc:docMk/>
            <pc:sldMk cId="1713723769" sldId="293"/>
            <ac:grpSpMk id="30" creationId="{D4711A5C-D5E3-8B43-8824-E39BDE95125B}"/>
          </ac:grpSpMkLst>
        </pc:grpChg>
        <pc:grpChg chg="add">
          <ac:chgData name="Ayesha Shafi" userId="75ef1296-0a29-4795-a39c-cc19b40d46a0" providerId="ADAL" clId="{39ECAFBE-B189-3548-B0DF-F72E4EAEA932}" dt="2025-10-01T18:00:48.360" v="319" actId="164"/>
          <ac:grpSpMkLst>
            <pc:docMk/>
            <pc:sldMk cId="1713723769" sldId="293"/>
            <ac:grpSpMk id="40" creationId="{3739EC7A-0D7F-FF37-891F-CF0F95E89571}"/>
          </ac:grpSpMkLst>
        </pc:grpChg>
        <pc:cxnChg chg="add mod">
          <ac:chgData name="Ayesha Shafi" userId="75ef1296-0a29-4795-a39c-cc19b40d46a0" providerId="ADAL" clId="{39ECAFBE-B189-3548-B0DF-F72E4EAEA932}" dt="2025-10-01T17:59:32.969" v="224" actId="554"/>
          <ac:cxnSpMkLst>
            <pc:docMk/>
            <pc:sldMk cId="1713723769" sldId="293"/>
            <ac:cxnSpMk id="3" creationId="{53B54C1E-E9D5-573A-637F-319F51162026}"/>
          </ac:cxnSpMkLst>
        </pc:cxnChg>
        <pc:cxnChg chg="add mod">
          <ac:chgData name="Ayesha Shafi" userId="75ef1296-0a29-4795-a39c-cc19b40d46a0" providerId="ADAL" clId="{39ECAFBE-B189-3548-B0DF-F72E4EAEA932}" dt="2025-10-01T17:59:32.969" v="224" actId="554"/>
          <ac:cxnSpMkLst>
            <pc:docMk/>
            <pc:sldMk cId="1713723769" sldId="293"/>
            <ac:cxnSpMk id="12" creationId="{6A9C3E9C-78A1-EC1D-3DC4-1F91D3B9CDFD}"/>
          </ac:cxnSpMkLst>
        </pc:cxnChg>
        <pc:cxnChg chg="add mod">
          <ac:chgData name="Ayesha Shafi" userId="75ef1296-0a29-4795-a39c-cc19b40d46a0" providerId="ADAL" clId="{39ECAFBE-B189-3548-B0DF-F72E4EAEA932}" dt="2025-10-01T17:59:32.969" v="224" actId="554"/>
          <ac:cxnSpMkLst>
            <pc:docMk/>
            <pc:sldMk cId="1713723769" sldId="293"/>
            <ac:cxnSpMk id="17" creationId="{F392363D-56ED-4390-1F5D-A68DBF50DA81}"/>
          </ac:cxnSpMkLst>
        </pc:cxnChg>
        <pc:cxnChg chg="add mod">
          <ac:chgData name="Ayesha Shafi" userId="75ef1296-0a29-4795-a39c-cc19b40d46a0" providerId="ADAL" clId="{39ECAFBE-B189-3548-B0DF-F72E4EAEA932}" dt="2025-10-01T17:59:48.741" v="287" actId="1038"/>
          <ac:cxnSpMkLst>
            <pc:docMk/>
            <pc:sldMk cId="1713723769" sldId="293"/>
            <ac:cxnSpMk id="18" creationId="{77315439-F1DC-9D37-CE34-A8F796F73D0D}"/>
          </ac:cxnSpMkLst>
        </pc:cxnChg>
        <pc:cxnChg chg="add mod">
          <ac:chgData name="Ayesha Shafi" userId="75ef1296-0a29-4795-a39c-cc19b40d46a0" providerId="ADAL" clId="{39ECAFBE-B189-3548-B0DF-F72E4EAEA932}" dt="2025-10-01T17:59:48.741" v="287" actId="1038"/>
          <ac:cxnSpMkLst>
            <pc:docMk/>
            <pc:sldMk cId="1713723769" sldId="293"/>
            <ac:cxnSpMk id="19" creationId="{E045EE32-564C-44DA-43CD-2C2ABB5178F6}"/>
          </ac:cxnSpMkLst>
        </pc:cxnChg>
        <pc:cxnChg chg="add mod">
          <ac:chgData name="Ayesha Shafi" userId="75ef1296-0a29-4795-a39c-cc19b40d46a0" providerId="ADAL" clId="{39ECAFBE-B189-3548-B0DF-F72E4EAEA932}" dt="2025-10-01T17:59:48.741" v="287" actId="1038"/>
          <ac:cxnSpMkLst>
            <pc:docMk/>
            <pc:sldMk cId="1713723769" sldId="293"/>
            <ac:cxnSpMk id="20" creationId="{E600A8E2-E2EE-F8E5-80D9-C48C5BE9C538}"/>
          </ac:cxnSpMkLst>
        </pc:cxnChg>
        <pc:cxnChg chg="mod">
          <ac:chgData name="Ayesha Shafi" userId="75ef1296-0a29-4795-a39c-cc19b40d46a0" providerId="ADAL" clId="{39ECAFBE-B189-3548-B0DF-F72E4EAEA932}" dt="2025-10-01T18:00:25.511" v="300" actId="1036"/>
          <ac:cxnSpMkLst>
            <pc:docMk/>
            <pc:sldMk cId="1713723769" sldId="293"/>
            <ac:cxnSpMk id="31" creationId="{8A33E2B3-989A-02DD-8247-D18BD2AD8C3A}"/>
          </ac:cxnSpMkLst>
        </pc:cxnChg>
        <pc:cxnChg chg="mod">
          <ac:chgData name="Ayesha Shafi" userId="75ef1296-0a29-4795-a39c-cc19b40d46a0" providerId="ADAL" clId="{39ECAFBE-B189-3548-B0DF-F72E4EAEA932}" dt="2025-10-01T18:00:25.511" v="300" actId="1036"/>
          <ac:cxnSpMkLst>
            <pc:docMk/>
            <pc:sldMk cId="1713723769" sldId="293"/>
            <ac:cxnSpMk id="33" creationId="{A8F52231-1097-9F43-1524-0340B3F3AC74}"/>
          </ac:cxnSpMkLst>
        </pc:cxnChg>
        <pc:cxnChg chg="mod">
          <ac:chgData name="Ayesha Shafi" userId="75ef1296-0a29-4795-a39c-cc19b40d46a0" providerId="ADAL" clId="{39ECAFBE-B189-3548-B0DF-F72E4EAEA932}" dt="2025-10-01T18:00:25.511" v="300" actId="1036"/>
          <ac:cxnSpMkLst>
            <pc:docMk/>
            <pc:sldMk cId="1713723769" sldId="293"/>
            <ac:cxnSpMk id="34" creationId="{69141C00-0749-7AA8-D4CE-9065BF08B756}"/>
          </ac:cxnSpMkLst>
        </pc:cxnChg>
        <pc:cxnChg chg="mod">
          <ac:chgData name="Ayesha Shafi" userId="75ef1296-0a29-4795-a39c-cc19b40d46a0" providerId="ADAL" clId="{39ECAFBE-B189-3548-B0DF-F72E4EAEA932}" dt="2025-10-01T18:00:05.416" v="290"/>
          <ac:cxnSpMkLst>
            <pc:docMk/>
            <pc:sldMk cId="1713723769" sldId="293"/>
            <ac:cxnSpMk id="36" creationId="{3F0B687B-F4DA-D363-671D-DA3D268432BF}"/>
          </ac:cxnSpMkLst>
        </pc:cxnChg>
        <pc:cxnChg chg="mod">
          <ac:chgData name="Ayesha Shafi" userId="75ef1296-0a29-4795-a39c-cc19b40d46a0" providerId="ADAL" clId="{39ECAFBE-B189-3548-B0DF-F72E4EAEA932}" dt="2025-10-01T18:00:05.416" v="290"/>
          <ac:cxnSpMkLst>
            <pc:docMk/>
            <pc:sldMk cId="1713723769" sldId="293"/>
            <ac:cxnSpMk id="38" creationId="{C3D92211-B2F6-C17C-FC48-B429EAC11701}"/>
          </ac:cxnSpMkLst>
        </pc:cxnChg>
        <pc:cxnChg chg="mod">
          <ac:chgData name="Ayesha Shafi" userId="75ef1296-0a29-4795-a39c-cc19b40d46a0" providerId="ADAL" clId="{39ECAFBE-B189-3548-B0DF-F72E4EAEA932}" dt="2025-10-01T18:00:05.416" v="290"/>
          <ac:cxnSpMkLst>
            <pc:docMk/>
            <pc:sldMk cId="1713723769" sldId="293"/>
            <ac:cxnSpMk id="39" creationId="{F2CEA02A-60B2-F0A0-CEF0-7C7393F80AE0}"/>
          </ac:cxnSpMkLst>
        </pc:cxnChg>
      </pc:sldChg>
      <pc:sldChg chg="addSp delSp modSp mod">
        <pc:chgData name="Ayesha Shafi" userId="75ef1296-0a29-4795-a39c-cc19b40d46a0" providerId="ADAL" clId="{39ECAFBE-B189-3548-B0DF-F72E4EAEA932}" dt="2025-10-01T18:03:18.261" v="371" actId="164"/>
        <pc:sldMkLst>
          <pc:docMk/>
          <pc:sldMk cId="1122343288" sldId="294"/>
        </pc:sldMkLst>
        <pc:spChg chg="mod topLvl">
          <ac:chgData name="Ayesha Shafi" userId="75ef1296-0a29-4795-a39c-cc19b40d46a0" providerId="ADAL" clId="{39ECAFBE-B189-3548-B0DF-F72E4EAEA932}" dt="2025-10-01T18:02:13.256" v="355" actId="165"/>
          <ac:spMkLst>
            <pc:docMk/>
            <pc:sldMk cId="1122343288" sldId="294"/>
            <ac:spMk id="336" creationId="{F3B3A4AB-2E2E-E745-91BA-49C28347CC54}"/>
          </ac:spMkLst>
        </pc:spChg>
        <pc:spChg chg="mod topLvl">
          <ac:chgData name="Ayesha Shafi" userId="75ef1296-0a29-4795-a39c-cc19b40d46a0" providerId="ADAL" clId="{39ECAFBE-B189-3548-B0DF-F72E4EAEA932}" dt="2025-10-01T18:02:13.256" v="355" actId="165"/>
          <ac:spMkLst>
            <pc:docMk/>
            <pc:sldMk cId="1122343288" sldId="294"/>
            <ac:spMk id="797" creationId="{9F8A199D-98E9-7445-B009-F963CCFE95E8}"/>
          </ac:spMkLst>
        </pc:spChg>
        <pc:grpChg chg="add mod">
          <ac:chgData name="Ayesha Shafi" userId="75ef1296-0a29-4795-a39c-cc19b40d46a0" providerId="ADAL" clId="{39ECAFBE-B189-3548-B0DF-F72E4EAEA932}" dt="2025-10-01T18:00:59.706" v="328" actId="1037"/>
          <ac:grpSpMkLst>
            <pc:docMk/>
            <pc:sldMk cId="1122343288" sldId="294"/>
            <ac:grpSpMk id="3" creationId="{6C0F1D39-63FB-DE91-1BCA-5C454F2AE913}"/>
          </ac:grpSpMkLst>
        </pc:grpChg>
        <pc:grpChg chg="add del">
          <ac:chgData name="Ayesha Shafi" userId="75ef1296-0a29-4795-a39c-cc19b40d46a0" providerId="ADAL" clId="{39ECAFBE-B189-3548-B0DF-F72E4EAEA932}" dt="2025-10-01T18:02:13.256" v="355" actId="165"/>
          <ac:grpSpMkLst>
            <pc:docMk/>
            <pc:sldMk cId="1122343288" sldId="294"/>
            <ac:grpSpMk id="7" creationId="{7CE009B8-A230-DD5E-E137-C155919799FF}"/>
          </ac:grpSpMkLst>
        </pc:grpChg>
        <pc:grpChg chg="add mod">
          <ac:chgData name="Ayesha Shafi" userId="75ef1296-0a29-4795-a39c-cc19b40d46a0" providerId="ADAL" clId="{39ECAFBE-B189-3548-B0DF-F72E4EAEA932}" dt="2025-10-01T18:01:40.564" v="346" actId="1076"/>
          <ac:grpSpMkLst>
            <pc:docMk/>
            <pc:sldMk cId="1122343288" sldId="294"/>
            <ac:grpSpMk id="22" creationId="{0088ABC5-A109-0CE9-27AA-958AAA4A1EC8}"/>
          </ac:grpSpMkLst>
        </pc:grpChg>
        <pc:grpChg chg="mod topLvl">
          <ac:chgData name="Ayesha Shafi" userId="75ef1296-0a29-4795-a39c-cc19b40d46a0" providerId="ADAL" clId="{39ECAFBE-B189-3548-B0DF-F72E4EAEA932}" dt="2025-10-01T18:02:13.256" v="355" actId="165"/>
          <ac:grpSpMkLst>
            <pc:docMk/>
            <pc:sldMk cId="1122343288" sldId="294"/>
            <ac:grpSpMk id="34" creationId="{F7BD3EB5-E02D-5245-A1E2-1C61DD483B4C}"/>
          </ac:grpSpMkLst>
        </pc:grpChg>
        <pc:grpChg chg="add">
          <ac:chgData name="Ayesha Shafi" userId="75ef1296-0a29-4795-a39c-cc19b40d46a0" providerId="ADAL" clId="{39ECAFBE-B189-3548-B0DF-F72E4EAEA932}" dt="2025-10-01T18:01:47.441" v="347" actId="164"/>
          <ac:grpSpMkLst>
            <pc:docMk/>
            <pc:sldMk cId="1122343288" sldId="294"/>
            <ac:grpSpMk id="38" creationId="{2762E979-9E01-BE8C-5066-F18BC70776F0}"/>
          </ac:grpSpMkLst>
        </pc:grpChg>
        <pc:grpChg chg="add del mod">
          <ac:chgData name="Ayesha Shafi" userId="75ef1296-0a29-4795-a39c-cc19b40d46a0" providerId="ADAL" clId="{39ECAFBE-B189-3548-B0DF-F72E4EAEA932}" dt="2025-10-01T18:02:19.532" v="356" actId="165"/>
          <ac:grpSpMkLst>
            <pc:docMk/>
            <pc:sldMk cId="1122343288" sldId="294"/>
            <ac:grpSpMk id="39" creationId="{4CBCD526-4AD8-A86B-C5CA-03283A9F6151}"/>
          </ac:grpSpMkLst>
        </pc:grpChg>
        <pc:grpChg chg="mod topLvl">
          <ac:chgData name="Ayesha Shafi" userId="75ef1296-0a29-4795-a39c-cc19b40d46a0" providerId="ADAL" clId="{39ECAFBE-B189-3548-B0DF-F72E4EAEA932}" dt="2025-10-01T18:02:19.532" v="356" actId="165"/>
          <ac:grpSpMkLst>
            <pc:docMk/>
            <pc:sldMk cId="1122343288" sldId="294"/>
            <ac:grpSpMk id="40" creationId="{5FCCD321-23F4-D2AA-CD05-0E109692C5E3}"/>
          </ac:grpSpMkLst>
        </pc:grpChg>
        <pc:grpChg chg="mod topLvl">
          <ac:chgData name="Ayesha Shafi" userId="75ef1296-0a29-4795-a39c-cc19b40d46a0" providerId="ADAL" clId="{39ECAFBE-B189-3548-B0DF-F72E4EAEA932}" dt="2025-10-01T18:02:29.147" v="365" actId="1035"/>
          <ac:grpSpMkLst>
            <pc:docMk/>
            <pc:sldMk cId="1122343288" sldId="294"/>
            <ac:grpSpMk id="44" creationId="{6727F8AA-1CFF-F61B-E684-5A0F4C9CF085}"/>
          </ac:grpSpMkLst>
        </pc:grpChg>
        <pc:grpChg chg="add">
          <ac:chgData name="Ayesha Shafi" userId="75ef1296-0a29-4795-a39c-cc19b40d46a0" providerId="ADAL" clId="{39ECAFBE-B189-3548-B0DF-F72E4EAEA932}" dt="2025-10-01T18:02:39.252" v="366" actId="164"/>
          <ac:grpSpMkLst>
            <pc:docMk/>
            <pc:sldMk cId="1122343288" sldId="294"/>
            <ac:grpSpMk id="57" creationId="{4703CFC5-77C0-6D97-A046-F8D6FA6CE42A}"/>
          </ac:grpSpMkLst>
        </pc:grpChg>
        <pc:grpChg chg="add">
          <ac:chgData name="Ayesha Shafi" userId="75ef1296-0a29-4795-a39c-cc19b40d46a0" providerId="ADAL" clId="{39ECAFBE-B189-3548-B0DF-F72E4EAEA932}" dt="2025-10-01T18:03:06.543" v="370" actId="164"/>
          <ac:grpSpMkLst>
            <pc:docMk/>
            <pc:sldMk cId="1122343288" sldId="294"/>
            <ac:grpSpMk id="60" creationId="{437DE19D-F25C-7B1C-F1FE-00677E5D46E9}"/>
          </ac:grpSpMkLst>
        </pc:grpChg>
        <pc:grpChg chg="add">
          <ac:chgData name="Ayesha Shafi" userId="75ef1296-0a29-4795-a39c-cc19b40d46a0" providerId="ADAL" clId="{39ECAFBE-B189-3548-B0DF-F72E4EAEA932}" dt="2025-10-01T18:03:18.261" v="371" actId="164"/>
          <ac:grpSpMkLst>
            <pc:docMk/>
            <pc:sldMk cId="1122343288" sldId="294"/>
            <ac:grpSpMk id="61" creationId="{1001EBF0-E4ED-8108-A81F-865421E67D47}"/>
          </ac:grpSpMkLst>
        </pc:grpChg>
        <pc:picChg chg="mod topLvl">
          <ac:chgData name="Ayesha Shafi" userId="75ef1296-0a29-4795-a39c-cc19b40d46a0" providerId="ADAL" clId="{39ECAFBE-B189-3548-B0DF-F72E4EAEA932}" dt="2025-10-01T18:02:13.256" v="355" actId="165"/>
          <ac:picMkLst>
            <pc:docMk/>
            <pc:sldMk cId="1122343288" sldId="294"/>
            <ac:picMk id="6" creationId="{A66E9A8B-C557-B5B8-4CAC-EFFD7CD0F378}"/>
          </ac:picMkLst>
        </pc:picChg>
        <pc:cxnChg chg="mod">
          <ac:chgData name="Ayesha Shafi" userId="75ef1296-0a29-4795-a39c-cc19b40d46a0" providerId="ADAL" clId="{39ECAFBE-B189-3548-B0DF-F72E4EAEA932}" dt="2025-10-01T18:01:33.433" v="344" actId="1038"/>
          <ac:cxnSpMkLst>
            <pc:docMk/>
            <pc:sldMk cId="1122343288" sldId="294"/>
            <ac:cxnSpMk id="5" creationId="{7D017CA4-6F57-D686-AD6F-01E7E3BE549A}"/>
          </ac:cxnSpMkLst>
        </pc:cxnChg>
        <pc:cxnChg chg="mod">
          <ac:chgData name="Ayesha Shafi" userId="75ef1296-0a29-4795-a39c-cc19b40d46a0" providerId="ADAL" clId="{39ECAFBE-B189-3548-B0DF-F72E4EAEA932}" dt="2025-10-01T18:01:29.089" v="336" actId="1038"/>
          <ac:cxnSpMkLst>
            <pc:docMk/>
            <pc:sldMk cId="1122343288" sldId="294"/>
            <ac:cxnSpMk id="8" creationId="{9EF2E6F4-A814-CE16-2B05-45F079131B8A}"/>
          </ac:cxnSpMkLst>
        </pc:cxnChg>
        <pc:cxnChg chg="mod">
          <ac:chgData name="Ayesha Shafi" userId="75ef1296-0a29-4795-a39c-cc19b40d46a0" providerId="ADAL" clId="{39ECAFBE-B189-3548-B0DF-F72E4EAEA932}" dt="2025-10-01T18:00:51.727" v="320"/>
          <ac:cxnSpMkLst>
            <pc:docMk/>
            <pc:sldMk cId="1122343288" sldId="294"/>
            <ac:cxnSpMk id="15" creationId="{8AD305F4-06AC-F150-93E7-313A05AE2942}"/>
          </ac:cxnSpMkLst>
        </pc:cxnChg>
        <pc:cxnChg chg="mod">
          <ac:chgData name="Ayesha Shafi" userId="75ef1296-0a29-4795-a39c-cc19b40d46a0" providerId="ADAL" clId="{39ECAFBE-B189-3548-B0DF-F72E4EAEA932}" dt="2025-10-01T18:01:33.433" v="344" actId="1038"/>
          <ac:cxnSpMkLst>
            <pc:docMk/>
            <pc:sldMk cId="1122343288" sldId="294"/>
            <ac:cxnSpMk id="16" creationId="{535FE8E6-8727-037F-6A60-5CE92C1B8AB3}"/>
          </ac:cxnSpMkLst>
        </pc:cxnChg>
        <pc:cxnChg chg="mod">
          <ac:chgData name="Ayesha Shafi" userId="75ef1296-0a29-4795-a39c-cc19b40d46a0" providerId="ADAL" clId="{39ECAFBE-B189-3548-B0DF-F72E4EAEA932}" dt="2025-10-01T18:01:29.089" v="336" actId="1038"/>
          <ac:cxnSpMkLst>
            <pc:docMk/>
            <pc:sldMk cId="1122343288" sldId="294"/>
            <ac:cxnSpMk id="17" creationId="{7C3B902E-9ABB-5341-4DD8-A4E5A32B4503}"/>
          </ac:cxnSpMkLst>
        </pc:cxnChg>
        <pc:cxnChg chg="mod">
          <ac:chgData name="Ayesha Shafi" userId="75ef1296-0a29-4795-a39c-cc19b40d46a0" providerId="ADAL" clId="{39ECAFBE-B189-3548-B0DF-F72E4EAEA932}" dt="2025-10-01T18:00:51.727" v="320"/>
          <ac:cxnSpMkLst>
            <pc:docMk/>
            <pc:sldMk cId="1122343288" sldId="294"/>
            <ac:cxnSpMk id="19" creationId="{14DDB39A-9BC7-C766-4CE5-17D7C8DC6D60}"/>
          </ac:cxnSpMkLst>
        </pc:cxnChg>
        <pc:cxnChg chg="mod">
          <ac:chgData name="Ayesha Shafi" userId="75ef1296-0a29-4795-a39c-cc19b40d46a0" providerId="ADAL" clId="{39ECAFBE-B189-3548-B0DF-F72E4EAEA932}" dt="2025-10-01T18:01:36.161" v="345"/>
          <ac:cxnSpMkLst>
            <pc:docMk/>
            <pc:sldMk cId="1122343288" sldId="294"/>
            <ac:cxnSpMk id="23" creationId="{B6A9EE4C-E503-6BC2-9446-00444A7F2FA8}"/>
          </ac:cxnSpMkLst>
        </pc:cxnChg>
        <pc:cxnChg chg="mod">
          <ac:chgData name="Ayesha Shafi" userId="75ef1296-0a29-4795-a39c-cc19b40d46a0" providerId="ADAL" clId="{39ECAFBE-B189-3548-B0DF-F72E4EAEA932}" dt="2025-10-01T18:01:36.161" v="345"/>
          <ac:cxnSpMkLst>
            <pc:docMk/>
            <pc:sldMk cId="1122343288" sldId="294"/>
            <ac:cxnSpMk id="25" creationId="{6BC71073-161C-2BBA-78B2-0B6EB488153C}"/>
          </ac:cxnSpMkLst>
        </pc:cxnChg>
        <pc:cxnChg chg="mod">
          <ac:chgData name="Ayesha Shafi" userId="75ef1296-0a29-4795-a39c-cc19b40d46a0" providerId="ADAL" clId="{39ECAFBE-B189-3548-B0DF-F72E4EAEA932}" dt="2025-10-01T18:01:36.161" v="345"/>
          <ac:cxnSpMkLst>
            <pc:docMk/>
            <pc:sldMk cId="1122343288" sldId="294"/>
            <ac:cxnSpMk id="28" creationId="{C591D1C9-EEFE-9899-8593-524D57F6516A}"/>
          </ac:cxnSpMkLst>
        </pc:cxnChg>
        <pc:cxnChg chg="mod">
          <ac:chgData name="Ayesha Shafi" userId="75ef1296-0a29-4795-a39c-cc19b40d46a0" providerId="ADAL" clId="{39ECAFBE-B189-3548-B0DF-F72E4EAEA932}" dt="2025-10-01T18:01:36.161" v="345"/>
          <ac:cxnSpMkLst>
            <pc:docMk/>
            <pc:sldMk cId="1122343288" sldId="294"/>
            <ac:cxnSpMk id="29" creationId="{5C996B13-06E2-3B0A-05D4-248B4C0EB074}"/>
          </ac:cxnSpMkLst>
        </pc:cxnChg>
        <pc:cxnChg chg="mod">
          <ac:chgData name="Ayesha Shafi" userId="75ef1296-0a29-4795-a39c-cc19b40d46a0" providerId="ADAL" clId="{39ECAFBE-B189-3548-B0DF-F72E4EAEA932}" dt="2025-10-01T18:01:36.161" v="345"/>
          <ac:cxnSpMkLst>
            <pc:docMk/>
            <pc:sldMk cId="1122343288" sldId="294"/>
            <ac:cxnSpMk id="31" creationId="{E2676436-4800-F3CF-DC64-D409078A8D38}"/>
          </ac:cxnSpMkLst>
        </pc:cxnChg>
        <pc:cxnChg chg="mod">
          <ac:chgData name="Ayesha Shafi" userId="75ef1296-0a29-4795-a39c-cc19b40d46a0" providerId="ADAL" clId="{39ECAFBE-B189-3548-B0DF-F72E4EAEA932}" dt="2025-10-01T18:01:36.161" v="345"/>
          <ac:cxnSpMkLst>
            <pc:docMk/>
            <pc:sldMk cId="1122343288" sldId="294"/>
            <ac:cxnSpMk id="32" creationId="{2527434F-A3C6-744C-81EF-B3E94F35280F}"/>
          </ac:cxnSpMkLst>
        </pc:cxnChg>
        <pc:cxnChg chg="mod">
          <ac:chgData name="Ayesha Shafi" userId="75ef1296-0a29-4795-a39c-cc19b40d46a0" providerId="ADAL" clId="{39ECAFBE-B189-3548-B0DF-F72E4EAEA932}" dt="2025-10-01T18:02:49.068" v="369" actId="1036"/>
          <ac:cxnSpMkLst>
            <pc:docMk/>
            <pc:sldMk cId="1122343288" sldId="294"/>
            <ac:cxnSpMk id="45" creationId="{CD198099-A917-386B-9E1C-3D663B6E562E}"/>
          </ac:cxnSpMkLst>
        </pc:cxnChg>
        <pc:cxnChg chg="mod">
          <ac:chgData name="Ayesha Shafi" userId="75ef1296-0a29-4795-a39c-cc19b40d46a0" providerId="ADAL" clId="{39ECAFBE-B189-3548-B0DF-F72E4EAEA932}" dt="2025-10-01T18:02:49.068" v="369" actId="1036"/>
          <ac:cxnSpMkLst>
            <pc:docMk/>
            <pc:sldMk cId="1122343288" sldId="294"/>
            <ac:cxnSpMk id="46" creationId="{E4C699D2-EFBD-D5F4-5D5D-E54515E61895}"/>
          </ac:cxnSpMkLst>
        </pc:cxnChg>
        <pc:cxnChg chg="mod">
          <ac:chgData name="Ayesha Shafi" userId="75ef1296-0a29-4795-a39c-cc19b40d46a0" providerId="ADAL" clId="{39ECAFBE-B189-3548-B0DF-F72E4EAEA932}" dt="2025-10-01T18:02:49.068" v="369" actId="1036"/>
          <ac:cxnSpMkLst>
            <pc:docMk/>
            <pc:sldMk cId="1122343288" sldId="294"/>
            <ac:cxnSpMk id="47" creationId="{1FFD36A9-7D42-1DB9-BEB0-21540C94B266}"/>
          </ac:cxnSpMkLst>
        </pc:cxnChg>
        <pc:cxnChg chg="mod">
          <ac:chgData name="Ayesha Shafi" userId="75ef1296-0a29-4795-a39c-cc19b40d46a0" providerId="ADAL" clId="{39ECAFBE-B189-3548-B0DF-F72E4EAEA932}" dt="2025-10-01T18:01:49.229" v="348"/>
          <ac:cxnSpMkLst>
            <pc:docMk/>
            <pc:sldMk cId="1122343288" sldId="294"/>
            <ac:cxnSpMk id="48" creationId="{EFD7B1DE-82B0-913A-8C27-B71DC5406F09}"/>
          </ac:cxnSpMkLst>
        </pc:cxnChg>
        <pc:cxnChg chg="mod">
          <ac:chgData name="Ayesha Shafi" userId="75ef1296-0a29-4795-a39c-cc19b40d46a0" providerId="ADAL" clId="{39ECAFBE-B189-3548-B0DF-F72E4EAEA932}" dt="2025-10-01T18:01:49.229" v="348"/>
          <ac:cxnSpMkLst>
            <pc:docMk/>
            <pc:sldMk cId="1122343288" sldId="294"/>
            <ac:cxnSpMk id="49" creationId="{6527B624-C66B-AABB-E6D9-244851AD7B61}"/>
          </ac:cxnSpMkLst>
        </pc:cxnChg>
        <pc:cxnChg chg="mod">
          <ac:chgData name="Ayesha Shafi" userId="75ef1296-0a29-4795-a39c-cc19b40d46a0" providerId="ADAL" clId="{39ECAFBE-B189-3548-B0DF-F72E4EAEA932}" dt="2025-10-01T18:01:49.229" v="348"/>
          <ac:cxnSpMkLst>
            <pc:docMk/>
            <pc:sldMk cId="1122343288" sldId="294"/>
            <ac:cxnSpMk id="50" creationId="{88D544C7-A682-1818-ABA2-3E257C5749F5}"/>
          </ac:cxnSpMkLst>
        </pc:cxnChg>
        <pc:cxnChg chg="mod">
          <ac:chgData name="Ayesha Shafi" userId="75ef1296-0a29-4795-a39c-cc19b40d46a0" providerId="ADAL" clId="{39ECAFBE-B189-3548-B0DF-F72E4EAEA932}" dt="2025-10-01T18:02:49.068" v="369" actId="1036"/>
          <ac:cxnSpMkLst>
            <pc:docMk/>
            <pc:sldMk cId="1122343288" sldId="294"/>
            <ac:cxnSpMk id="51" creationId="{0091859D-5E17-3B2A-2974-F75911C4EE67}"/>
          </ac:cxnSpMkLst>
        </pc:cxnChg>
        <pc:cxnChg chg="mod">
          <ac:chgData name="Ayesha Shafi" userId="75ef1296-0a29-4795-a39c-cc19b40d46a0" providerId="ADAL" clId="{39ECAFBE-B189-3548-B0DF-F72E4EAEA932}" dt="2025-10-01T18:02:49.068" v="369" actId="1036"/>
          <ac:cxnSpMkLst>
            <pc:docMk/>
            <pc:sldMk cId="1122343288" sldId="294"/>
            <ac:cxnSpMk id="52" creationId="{DB107CE8-95BB-027C-E15E-8E079BDD07A2}"/>
          </ac:cxnSpMkLst>
        </pc:cxnChg>
        <pc:cxnChg chg="mod">
          <ac:chgData name="Ayesha Shafi" userId="75ef1296-0a29-4795-a39c-cc19b40d46a0" providerId="ADAL" clId="{39ECAFBE-B189-3548-B0DF-F72E4EAEA932}" dt="2025-10-01T18:02:49.068" v="369" actId="1036"/>
          <ac:cxnSpMkLst>
            <pc:docMk/>
            <pc:sldMk cId="1122343288" sldId="294"/>
            <ac:cxnSpMk id="53" creationId="{AC68E698-54C1-DBAC-E68D-CD0B8341D92D}"/>
          </ac:cxnSpMkLst>
        </pc:cxnChg>
        <pc:cxnChg chg="mod">
          <ac:chgData name="Ayesha Shafi" userId="75ef1296-0a29-4795-a39c-cc19b40d46a0" providerId="ADAL" clId="{39ECAFBE-B189-3548-B0DF-F72E4EAEA932}" dt="2025-10-01T18:01:49.229" v="348"/>
          <ac:cxnSpMkLst>
            <pc:docMk/>
            <pc:sldMk cId="1122343288" sldId="294"/>
            <ac:cxnSpMk id="54" creationId="{CBD532BD-F4D8-48D6-0EA2-A956364DA64E}"/>
          </ac:cxnSpMkLst>
        </pc:cxnChg>
        <pc:cxnChg chg="mod">
          <ac:chgData name="Ayesha Shafi" userId="75ef1296-0a29-4795-a39c-cc19b40d46a0" providerId="ADAL" clId="{39ECAFBE-B189-3548-B0DF-F72E4EAEA932}" dt="2025-10-01T18:01:49.229" v="348"/>
          <ac:cxnSpMkLst>
            <pc:docMk/>
            <pc:sldMk cId="1122343288" sldId="294"/>
            <ac:cxnSpMk id="55" creationId="{4935548C-5B87-A525-30FE-2E9A315F34BC}"/>
          </ac:cxnSpMkLst>
        </pc:cxnChg>
        <pc:cxnChg chg="mod">
          <ac:chgData name="Ayesha Shafi" userId="75ef1296-0a29-4795-a39c-cc19b40d46a0" providerId="ADAL" clId="{39ECAFBE-B189-3548-B0DF-F72E4EAEA932}" dt="2025-10-01T18:01:49.229" v="348"/>
          <ac:cxnSpMkLst>
            <pc:docMk/>
            <pc:sldMk cId="1122343288" sldId="294"/>
            <ac:cxnSpMk id="56" creationId="{6E8344E3-B279-8374-8668-CC9D443EFBD8}"/>
          </ac:cxnSpMkLst>
        </pc:cxnChg>
        <pc:cxnChg chg="mod topLvl">
          <ac:chgData name="Ayesha Shafi" userId="75ef1296-0a29-4795-a39c-cc19b40d46a0" providerId="ADAL" clId="{39ECAFBE-B189-3548-B0DF-F72E4EAEA932}" dt="2025-10-01T18:02:13.256" v="355" actId="165"/>
          <ac:cxnSpMkLst>
            <pc:docMk/>
            <pc:sldMk cId="1122343288" sldId="294"/>
            <ac:cxnSpMk id="335" creationId="{ACBE6C60-C9AB-C847-A4A9-E27D61B938A2}"/>
          </ac:cxnSpMkLst>
        </pc:cxnChg>
      </pc:sldChg>
      <pc:sldChg chg="modSp mod">
        <pc:chgData name="Ayesha Shafi" userId="75ef1296-0a29-4795-a39c-cc19b40d46a0" providerId="ADAL" clId="{39ECAFBE-B189-3548-B0DF-F72E4EAEA932}" dt="2025-10-01T18:47:25.809" v="400" actId="14100"/>
        <pc:sldMkLst>
          <pc:docMk/>
          <pc:sldMk cId="1290727870" sldId="298"/>
        </pc:sldMkLst>
        <pc:spChg chg="mod">
          <ac:chgData name="Ayesha Shafi" userId="75ef1296-0a29-4795-a39c-cc19b40d46a0" providerId="ADAL" clId="{39ECAFBE-B189-3548-B0DF-F72E4EAEA932}" dt="2025-10-01T18:47:25.809" v="400" actId="14100"/>
          <ac:spMkLst>
            <pc:docMk/>
            <pc:sldMk cId="1290727870" sldId="298"/>
            <ac:spMk id="7" creationId="{00000000-0000-0000-0000-000000000000}"/>
          </ac:spMkLst>
        </pc:spChg>
      </pc:sldChg>
      <pc:sldChg chg="modSp mod">
        <pc:chgData name="Ayesha Shafi" userId="75ef1296-0a29-4795-a39c-cc19b40d46a0" providerId="ADAL" clId="{39ECAFBE-B189-3548-B0DF-F72E4EAEA932}" dt="2025-10-01T18:58:58.004" v="707" actId="207"/>
        <pc:sldMkLst>
          <pc:docMk/>
          <pc:sldMk cId="3784057363" sldId="304"/>
        </pc:sldMkLst>
        <pc:spChg chg="mod">
          <ac:chgData name="Ayesha Shafi" userId="75ef1296-0a29-4795-a39c-cc19b40d46a0" providerId="ADAL" clId="{39ECAFBE-B189-3548-B0DF-F72E4EAEA932}" dt="2025-10-01T18:58:58.004" v="707" actId="207"/>
          <ac:spMkLst>
            <pc:docMk/>
            <pc:sldMk cId="3784057363" sldId="304"/>
            <ac:spMk id="5" creationId="{56944692-9272-E245-B7FE-103ED400F3E4}"/>
          </ac:spMkLst>
        </pc:spChg>
      </pc:sldChg>
      <pc:sldChg chg="modSp mod">
        <pc:chgData name="Ayesha Shafi" userId="75ef1296-0a29-4795-a39c-cc19b40d46a0" providerId="ADAL" clId="{39ECAFBE-B189-3548-B0DF-F72E4EAEA932}" dt="2025-10-01T19:00:55.933" v="715" actId="207"/>
        <pc:sldMkLst>
          <pc:docMk/>
          <pc:sldMk cId="1908151364" sldId="306"/>
        </pc:sldMkLst>
        <pc:spChg chg="mod">
          <ac:chgData name="Ayesha Shafi" userId="75ef1296-0a29-4795-a39c-cc19b40d46a0" providerId="ADAL" clId="{39ECAFBE-B189-3548-B0DF-F72E4EAEA932}" dt="2025-10-01T19:00:55.933" v="715" actId="207"/>
          <ac:spMkLst>
            <pc:docMk/>
            <pc:sldMk cId="1908151364" sldId="306"/>
            <ac:spMk id="68" creationId="{EDE3D16D-9337-5F4C-8DD0-9FF539A00BED}"/>
          </ac:spMkLst>
        </pc:spChg>
      </pc:sldChg>
      <pc:sldChg chg="modSp mod">
        <pc:chgData name="Ayesha Shafi" userId="75ef1296-0a29-4795-a39c-cc19b40d46a0" providerId="ADAL" clId="{39ECAFBE-B189-3548-B0DF-F72E4EAEA932}" dt="2025-10-01T18:45:40.818" v="396"/>
        <pc:sldMkLst>
          <pc:docMk/>
          <pc:sldMk cId="2412576379" sldId="309"/>
        </pc:sldMkLst>
        <pc:spChg chg="mod">
          <ac:chgData name="Ayesha Shafi" userId="75ef1296-0a29-4795-a39c-cc19b40d46a0" providerId="ADAL" clId="{39ECAFBE-B189-3548-B0DF-F72E4EAEA932}" dt="2025-10-01T18:45:40.818" v="396"/>
          <ac:spMkLst>
            <pc:docMk/>
            <pc:sldMk cId="2412576379" sldId="309"/>
            <ac:spMk id="2" creationId="{ABB205FB-416C-B9A7-A488-813AFC376279}"/>
          </ac:spMkLst>
        </pc:spChg>
      </pc:sldChg>
      <pc:sldChg chg="modSp mod">
        <pc:chgData name="Ayesha Shafi" userId="75ef1296-0a29-4795-a39c-cc19b40d46a0" providerId="ADAL" clId="{39ECAFBE-B189-3548-B0DF-F72E4EAEA932}" dt="2025-10-01T19:41:04.653" v="735" actId="207"/>
        <pc:sldMkLst>
          <pc:docMk/>
          <pc:sldMk cId="4103562211" sldId="311"/>
        </pc:sldMkLst>
        <pc:spChg chg="mod">
          <ac:chgData name="Ayesha Shafi" userId="75ef1296-0a29-4795-a39c-cc19b40d46a0" providerId="ADAL" clId="{39ECAFBE-B189-3548-B0DF-F72E4EAEA932}" dt="2025-10-01T19:41:04.653" v="735" actId="207"/>
          <ac:spMkLst>
            <pc:docMk/>
            <pc:sldMk cId="4103562211" sldId="311"/>
            <ac:spMk id="60" creationId="{00000000-0000-0000-0000-000000000000}"/>
          </ac:spMkLst>
        </pc:spChg>
      </pc:sldChg>
      <pc:sldChg chg="addSp modSp mod">
        <pc:chgData name="Ayesha Shafi" userId="75ef1296-0a29-4795-a39c-cc19b40d46a0" providerId="ADAL" clId="{39ECAFBE-B189-3548-B0DF-F72E4EAEA932}" dt="2025-10-01T19:02:41.610" v="734" actId="164"/>
        <pc:sldMkLst>
          <pc:docMk/>
          <pc:sldMk cId="737448264" sldId="312"/>
        </pc:sldMkLst>
        <pc:spChg chg="add mod">
          <ac:chgData name="Ayesha Shafi" userId="75ef1296-0a29-4795-a39c-cc19b40d46a0" providerId="ADAL" clId="{39ECAFBE-B189-3548-B0DF-F72E4EAEA932}" dt="2025-10-01T19:02:38.136" v="733" actId="1035"/>
          <ac:spMkLst>
            <pc:docMk/>
            <pc:sldMk cId="737448264" sldId="312"/>
            <ac:spMk id="7" creationId="{1250B386-31DB-A4C5-24C9-7AD8ECEE9FD2}"/>
          </ac:spMkLst>
        </pc:spChg>
        <pc:grpChg chg="add">
          <ac:chgData name="Ayesha Shafi" userId="75ef1296-0a29-4795-a39c-cc19b40d46a0" providerId="ADAL" clId="{39ECAFBE-B189-3548-B0DF-F72E4EAEA932}" dt="2025-10-01T19:02:41.610" v="734" actId="164"/>
          <ac:grpSpMkLst>
            <pc:docMk/>
            <pc:sldMk cId="737448264" sldId="312"/>
            <ac:grpSpMk id="9" creationId="{93A1FA35-82B8-1952-AB74-613CBE27F2B0}"/>
          </ac:grpSpMkLst>
        </pc:grpChg>
        <pc:grpChg chg="mod">
          <ac:chgData name="Ayesha Shafi" userId="75ef1296-0a29-4795-a39c-cc19b40d46a0" providerId="ADAL" clId="{39ECAFBE-B189-3548-B0DF-F72E4EAEA932}" dt="2025-10-01T19:02:31.986" v="726" actId="1076"/>
          <ac:grpSpMkLst>
            <pc:docMk/>
            <pc:sldMk cId="737448264" sldId="312"/>
            <ac:grpSpMk id="12" creationId="{44052050-323E-C846-A884-516C11A95714}"/>
          </ac:grpSpMkLst>
        </pc:grpChg>
        <pc:picChg chg="mod">
          <ac:chgData name="Ayesha Shafi" userId="75ef1296-0a29-4795-a39c-cc19b40d46a0" providerId="ADAL" clId="{39ECAFBE-B189-3548-B0DF-F72E4EAEA932}" dt="2025-10-01T19:02:35.420" v="729" actId="1035"/>
          <ac:picMkLst>
            <pc:docMk/>
            <pc:sldMk cId="737448264" sldId="312"/>
            <ac:picMk id="30" creationId="{D7CE952D-B9BD-384E-B25B-C72D90ED7D17}"/>
          </ac:picMkLst>
        </pc:picChg>
      </pc:sldChg>
    </pc:docChg>
  </pc:docChgLst>
  <pc:docChgLst>
    <pc:chgData name="Ayesha Shafi" userId="75ef1296-0a29-4795-a39c-cc19b40d46a0" providerId="ADAL" clId="{D4681D09-16D9-9E47-95ED-83F2D0E60DF8}"/>
    <pc:docChg chg="undo redo custSel modSld">
      <pc:chgData name="Ayesha Shafi" userId="75ef1296-0a29-4795-a39c-cc19b40d46a0" providerId="ADAL" clId="{D4681D09-16D9-9E47-95ED-83F2D0E60DF8}" dt="2025-03-17T14:02:31.232" v="346" actId="14100"/>
      <pc:docMkLst>
        <pc:docMk/>
      </pc:docMkLst>
      <pc:sldChg chg="addSp modSp mod">
        <pc:chgData name="Ayesha Shafi" userId="75ef1296-0a29-4795-a39c-cc19b40d46a0" providerId="ADAL" clId="{D4681D09-16D9-9E47-95ED-83F2D0E60DF8}" dt="2025-03-17T14:02:31.232" v="346" actId="14100"/>
        <pc:sldMkLst>
          <pc:docMk/>
          <pc:sldMk cId="2236825674" sldId="264"/>
        </pc:sldMkLst>
        <pc:spChg chg="add mod">
          <ac:chgData name="Ayesha Shafi" userId="75ef1296-0a29-4795-a39c-cc19b40d46a0" providerId="ADAL" clId="{D4681D09-16D9-9E47-95ED-83F2D0E60DF8}" dt="2025-03-17T13:47:01.261" v="94" actId="553"/>
          <ac:spMkLst>
            <pc:docMk/>
            <pc:sldMk cId="2236825674" sldId="264"/>
            <ac:spMk id="3" creationId="{CF51E434-9050-48E0-24F6-C3904EE54652}"/>
          </ac:spMkLst>
        </pc:spChg>
        <pc:spChg chg="mod">
          <ac:chgData name="Ayesha Shafi" userId="75ef1296-0a29-4795-a39c-cc19b40d46a0" providerId="ADAL" clId="{D4681D09-16D9-9E47-95ED-83F2D0E60DF8}" dt="2025-03-17T14:02:31.232" v="346" actId="14100"/>
          <ac:spMkLst>
            <pc:docMk/>
            <pc:sldMk cId="2236825674" sldId="264"/>
            <ac:spMk id="60" creationId="{00000000-0000-0000-0000-000000000000}"/>
          </ac:spMkLst>
        </pc:spChg>
        <pc:spChg chg="mod">
          <ac:chgData name="Ayesha Shafi" userId="75ef1296-0a29-4795-a39c-cc19b40d46a0" providerId="ADAL" clId="{D4681D09-16D9-9E47-95ED-83F2D0E60DF8}" dt="2025-03-17T13:47:01.261" v="94" actId="553"/>
          <ac:spMkLst>
            <pc:docMk/>
            <pc:sldMk cId="2236825674" sldId="264"/>
            <ac:spMk id="62" creationId="{00000000-0000-0000-0000-000000000000}"/>
          </ac:spMkLst>
        </pc:spChg>
        <pc:picChg chg="add mod">
          <ac:chgData name="Ayesha Shafi" userId="75ef1296-0a29-4795-a39c-cc19b40d46a0" providerId="ADAL" clId="{D4681D09-16D9-9E47-95ED-83F2D0E60DF8}" dt="2025-03-17T14:00:56.875" v="252" actId="1076"/>
          <ac:picMkLst>
            <pc:docMk/>
            <pc:sldMk cId="2236825674" sldId="264"/>
            <ac:picMk id="5" creationId="{CBFAF190-4308-B128-6CD1-7A12579C9DF2}"/>
          </ac:picMkLst>
        </pc:picChg>
        <pc:picChg chg="add mod">
          <ac:chgData name="Ayesha Shafi" userId="75ef1296-0a29-4795-a39c-cc19b40d46a0" providerId="ADAL" clId="{D4681D09-16D9-9E47-95ED-83F2D0E60DF8}" dt="2025-03-17T14:00:56.875" v="252" actId="1076"/>
          <ac:picMkLst>
            <pc:docMk/>
            <pc:sldMk cId="2236825674" sldId="264"/>
            <ac:picMk id="6" creationId="{D03343DF-4D29-61B6-09D9-4071BEF5A838}"/>
          </ac:picMkLst>
        </pc:picChg>
      </pc:sldChg>
      <pc:sldChg chg="addSp modSp mod">
        <pc:chgData name="Ayesha Shafi" userId="75ef1296-0a29-4795-a39c-cc19b40d46a0" providerId="ADAL" clId="{D4681D09-16D9-9E47-95ED-83F2D0E60DF8}" dt="2025-03-17T13:40:37.053" v="90" actId="1076"/>
        <pc:sldMkLst>
          <pc:docMk/>
          <pc:sldMk cId="1908151364" sldId="306"/>
        </pc:sldMkLst>
        <pc:spChg chg="mod">
          <ac:chgData name="Ayesha Shafi" userId="75ef1296-0a29-4795-a39c-cc19b40d46a0" providerId="ADAL" clId="{D4681D09-16D9-9E47-95ED-83F2D0E60DF8}" dt="2025-03-17T13:38:13.502" v="36" actId="1038"/>
          <ac:spMkLst>
            <pc:docMk/>
            <pc:sldMk cId="1908151364" sldId="306"/>
            <ac:spMk id="3" creationId="{DE242FEF-A4A9-99D4-2D43-F9727CC57463}"/>
          </ac:spMkLst>
        </pc:spChg>
        <pc:spChg chg="mod">
          <ac:chgData name="Ayesha Shafi" userId="75ef1296-0a29-4795-a39c-cc19b40d46a0" providerId="ADAL" clId="{D4681D09-16D9-9E47-95ED-83F2D0E60DF8}" dt="2025-03-17T13:38:07.584" v="22" actId="14100"/>
          <ac:spMkLst>
            <pc:docMk/>
            <pc:sldMk cId="1908151364" sldId="306"/>
            <ac:spMk id="5" creationId="{D7EC6B82-2D89-59DD-1C66-EB5D714F9EE6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6" creationId="{3B16C0F5-182D-A349-8BB8-CF90AA3F4483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7" creationId="{912220AB-BC5B-B444-B5F5-AFCAE832761E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9" creationId="{4BFBA279-3429-3541-B89C-00C198A1307B}"/>
          </ac:spMkLst>
        </pc:spChg>
        <pc:spChg chg="add mod">
          <ac:chgData name="Ayesha Shafi" userId="75ef1296-0a29-4795-a39c-cc19b40d46a0" providerId="ADAL" clId="{D4681D09-16D9-9E47-95ED-83F2D0E60DF8}" dt="2025-03-17T13:38:50.236" v="70" actId="20577"/>
          <ac:spMkLst>
            <pc:docMk/>
            <pc:sldMk cId="1908151364" sldId="306"/>
            <ac:spMk id="10" creationId="{D6407FC1-1F66-5627-68A2-5A6BD7856B24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11" creationId="{3A40C4A2-3B3D-9847-A7C9-F05C13490961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17" creationId="{08C761A3-2386-2B42-8240-BC0A078DAB9D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18" creationId="{65027256-7D88-8543-9B1B-5EEAD84C42CB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19" creationId="{8F7FF203-FDD4-9544-A583-1D67C0D662FA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23" creationId="{88372E3F-E260-7845-873A-44D6CA3EC66D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37" creationId="{FA87F893-CDDC-9A44-9A34-C5B6FF0CEDC5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38" creationId="{DF02F23E-4D1C-6644-AD59-18F982934E51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39" creationId="{DCD567B6-8AAC-3C44-9CE8-F6EFD9DB49AB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45" creationId="{72273C61-C458-4047-8820-A31C369CCE6C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46" creationId="{D783E32D-1A46-C541-A1E3-C196AC9CB77B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47" creationId="{F3A26A47-9D66-3D42-A61D-2F12C3181D7F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48" creationId="{CCB8137B-A5A9-2B41-B14D-92DB0B682014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56" creationId="{9A2B2F31-DE9F-EB44-9729-8B7054738BDB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57" creationId="{1885D6FF-3351-074A-8FC5-79475B825A07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58" creationId="{BFBCECEC-D82A-5B45-9D95-DFA24D64C7B1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59" creationId="{4BB49993-27FA-8C42-8528-431135E1CD20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60" creationId="{08029DE7-B62F-5B41-8678-F045845ACEAE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61" creationId="{686AEFDC-D0A3-EE40-945E-918AA72C628D}"/>
          </ac:spMkLst>
        </pc:spChg>
        <pc:spChg chg="mod">
          <ac:chgData name="Ayesha Shafi" userId="75ef1296-0a29-4795-a39c-cc19b40d46a0" providerId="ADAL" clId="{D4681D09-16D9-9E47-95ED-83F2D0E60DF8}" dt="2025-03-17T13:37:37.836" v="13" actId="403"/>
          <ac:spMkLst>
            <pc:docMk/>
            <pc:sldMk cId="1908151364" sldId="306"/>
            <ac:spMk id="64" creationId="{9ED6D1F8-770D-014B-BBDC-6C32883398AB}"/>
          </ac:spMkLst>
        </pc:spChg>
        <pc:spChg chg="mod">
          <ac:chgData name="Ayesha Shafi" userId="75ef1296-0a29-4795-a39c-cc19b40d46a0" providerId="ADAL" clId="{D4681D09-16D9-9E47-95ED-83F2D0E60DF8}" dt="2025-03-17T13:40:37.053" v="90" actId="1076"/>
          <ac:spMkLst>
            <pc:docMk/>
            <pc:sldMk cId="1908151364" sldId="306"/>
            <ac:spMk id="68" creationId="{EDE3D16D-9337-5F4C-8DD0-9FF539A00BED}"/>
          </ac:spMkLst>
        </pc:spChg>
        <pc:grpChg chg="mod">
          <ac:chgData name="Ayesha Shafi" userId="75ef1296-0a29-4795-a39c-cc19b40d46a0" providerId="ADAL" clId="{D4681D09-16D9-9E47-95ED-83F2D0E60DF8}" dt="2025-03-17T13:38:24.758" v="63" actId="1036"/>
          <ac:grpSpMkLst>
            <pc:docMk/>
            <pc:sldMk cId="1908151364" sldId="306"/>
            <ac:grpSpMk id="8" creationId="{B194BEE5-BC6E-084D-8074-9C2A4142F451}"/>
          </ac:grpSpMkLst>
        </pc:grpChg>
        <pc:grpChg chg="mod">
          <ac:chgData name="Ayesha Shafi" userId="75ef1296-0a29-4795-a39c-cc19b40d46a0" providerId="ADAL" clId="{D4681D09-16D9-9E47-95ED-83F2D0E60DF8}" dt="2025-03-17T13:38:39.133" v="67" actId="1076"/>
          <ac:grpSpMkLst>
            <pc:docMk/>
            <pc:sldMk cId="1908151364" sldId="306"/>
            <ac:grpSpMk id="12" creationId="{44052050-323E-C846-A884-516C11A95714}"/>
          </ac:grpSpMkLst>
        </pc:grpChg>
        <pc:grpChg chg="mod">
          <ac:chgData name="Ayesha Shafi" userId="75ef1296-0a29-4795-a39c-cc19b40d46a0" providerId="ADAL" clId="{D4681D09-16D9-9E47-95ED-83F2D0E60DF8}" dt="2025-03-17T13:38:29.406" v="64" actId="1076"/>
          <ac:grpSpMkLst>
            <pc:docMk/>
            <pc:sldMk cId="1908151364" sldId="306"/>
            <ac:grpSpMk id="62" creationId="{55158565-3CC8-CB4C-945F-FD675158F4C8}"/>
          </ac:grpSpMkLst>
        </pc:grpChg>
        <pc:picChg chg="add mod">
          <ac:chgData name="Ayesha Shafi" userId="75ef1296-0a29-4795-a39c-cc19b40d46a0" providerId="ADAL" clId="{D4681D09-16D9-9E47-95ED-83F2D0E60DF8}" dt="2025-03-17T13:39:02.513" v="72" actId="1076"/>
          <ac:picMkLst>
            <pc:docMk/>
            <pc:sldMk cId="1908151364" sldId="306"/>
            <ac:picMk id="33" creationId="{9344C093-ADD6-80FF-0AE5-038D4950B1AA}"/>
          </ac:picMkLst>
        </pc:picChg>
        <pc:picChg chg="mod">
          <ac:chgData name="Ayesha Shafi" userId="75ef1296-0a29-4795-a39c-cc19b40d46a0" providerId="ADAL" clId="{D4681D09-16D9-9E47-95ED-83F2D0E60DF8}" dt="2025-03-17T13:38:33.424" v="65" actId="1076"/>
          <ac:picMkLst>
            <pc:docMk/>
            <pc:sldMk cId="1908151364" sldId="306"/>
            <ac:picMk id="66" creationId="{2BDAE686-2080-C640-B212-4F97297E3DC5}"/>
          </ac:picMkLst>
        </pc:picChg>
      </pc:sldChg>
    </pc:docChg>
  </pc:docChgLst>
  <pc:docChgLst>
    <pc:chgData name="Ayesha Shafi" userId="75ef1296-0a29-4795-a39c-cc19b40d46a0" providerId="ADAL" clId="{EACF1C03-F437-5F41-BC64-855881C53078}"/>
    <pc:docChg chg="undo custSel modSld">
      <pc:chgData name="Ayesha Shafi" userId="75ef1296-0a29-4795-a39c-cc19b40d46a0" providerId="ADAL" clId="{EACF1C03-F437-5F41-BC64-855881C53078}" dt="2024-12-10T20:19:03.804" v="49" actId="1037"/>
      <pc:docMkLst>
        <pc:docMk/>
      </pc:docMkLst>
      <pc:sldChg chg="addSp modSp mod">
        <pc:chgData name="Ayesha Shafi" userId="75ef1296-0a29-4795-a39c-cc19b40d46a0" providerId="ADAL" clId="{EACF1C03-F437-5F41-BC64-855881C53078}" dt="2024-12-10T20:19:03.804" v="49" actId="1037"/>
        <pc:sldMkLst>
          <pc:docMk/>
          <pc:sldMk cId="1124846986" sldId="307"/>
        </pc:sldMkLst>
        <pc:spChg chg="add mod">
          <ac:chgData name="Ayesha Shafi" userId="75ef1296-0a29-4795-a39c-cc19b40d46a0" providerId="ADAL" clId="{EACF1C03-F437-5F41-BC64-855881C53078}" dt="2024-12-10T20:18:47.569" v="35" actId="554"/>
          <ac:spMkLst>
            <pc:docMk/>
            <pc:sldMk cId="1124846986" sldId="307"/>
            <ac:spMk id="4" creationId="{4BE4E6E8-D280-3093-F4DD-B0F81AB375BB}"/>
          </ac:spMkLst>
        </pc:spChg>
        <pc:spChg chg="mod">
          <ac:chgData name="Ayesha Shafi" userId="75ef1296-0a29-4795-a39c-cc19b40d46a0" providerId="ADAL" clId="{EACF1C03-F437-5F41-BC64-855881C53078}" dt="2024-12-10T20:19:03.804" v="49" actId="1037"/>
          <ac:spMkLst>
            <pc:docMk/>
            <pc:sldMk cId="1124846986" sldId="307"/>
            <ac:spMk id="5" creationId="{00000000-0000-0000-0000-000000000000}"/>
          </ac:spMkLst>
        </pc:spChg>
        <pc:picChg chg="mod">
          <ac:chgData name="Ayesha Shafi" userId="75ef1296-0a29-4795-a39c-cc19b40d46a0" providerId="ADAL" clId="{EACF1C03-F437-5F41-BC64-855881C53078}" dt="2024-12-10T20:18:28.893" v="33" actId="1038"/>
          <ac:picMkLst>
            <pc:docMk/>
            <pc:sldMk cId="1124846986" sldId="307"/>
            <ac:picMk id="90" creationId="{00000000-0000-0000-0000-000000000000}"/>
          </ac:picMkLst>
        </pc:picChg>
        <pc:picChg chg="mod">
          <ac:chgData name="Ayesha Shafi" userId="75ef1296-0a29-4795-a39c-cc19b40d46a0" providerId="ADAL" clId="{EACF1C03-F437-5F41-BC64-855881C53078}" dt="2024-12-10T20:18:52.992" v="36" actId="554"/>
          <ac:picMkLst>
            <pc:docMk/>
            <pc:sldMk cId="1124846986" sldId="307"/>
            <ac:picMk id="140" creationId="{77D1C33A-310F-7649-81AB-92C5D467DE72}"/>
          </ac:picMkLst>
        </pc:picChg>
        <pc:picChg chg="mod">
          <ac:chgData name="Ayesha Shafi" userId="75ef1296-0a29-4795-a39c-cc19b40d46a0" providerId="ADAL" clId="{EACF1C03-F437-5F41-BC64-855881C53078}" dt="2024-12-10T20:18:52.992" v="36" actId="554"/>
          <ac:picMkLst>
            <pc:docMk/>
            <pc:sldMk cId="1124846986" sldId="307"/>
            <ac:picMk id="153" creationId="{00000000-0000-0000-0000-000000000000}"/>
          </ac:picMkLst>
        </pc:picChg>
        <pc:picChg chg="mod">
          <ac:chgData name="Ayesha Shafi" userId="75ef1296-0a29-4795-a39c-cc19b40d46a0" providerId="ADAL" clId="{EACF1C03-F437-5F41-BC64-855881C53078}" dt="2024-12-10T20:18:19.741" v="26" actId="1035"/>
          <ac:picMkLst>
            <pc:docMk/>
            <pc:sldMk cId="1124846986" sldId="307"/>
            <ac:picMk id="160" creationId="{794E7E8B-A631-3442-B290-D9A81F64A2A6}"/>
          </ac:picMkLst>
        </pc:picChg>
      </pc:sldChg>
    </pc:docChg>
  </pc:docChgLst>
  <pc:docChgLst>
    <pc:chgData name="Ayesha Shafi" userId="75ef1296-0a29-4795-a39c-cc19b40d46a0" providerId="ADAL" clId="{DD682CFB-8527-1347-85A8-55B86B78DAF8}"/>
    <pc:docChg chg="custSel modSld">
      <pc:chgData name="Ayesha Shafi" userId="75ef1296-0a29-4795-a39c-cc19b40d46a0" providerId="ADAL" clId="{DD682CFB-8527-1347-85A8-55B86B78DAF8}" dt="2025-03-17T13:09:15.049" v="11" actId="1076"/>
      <pc:docMkLst>
        <pc:docMk/>
      </pc:docMkLst>
      <pc:sldChg chg="addSp delSp modSp mod">
        <pc:chgData name="Ayesha Shafi" userId="75ef1296-0a29-4795-a39c-cc19b40d46a0" providerId="ADAL" clId="{DD682CFB-8527-1347-85A8-55B86B78DAF8}" dt="2025-03-17T13:09:15.049" v="11" actId="1076"/>
        <pc:sldMkLst>
          <pc:docMk/>
          <pc:sldMk cId="1124846986" sldId="307"/>
        </pc:sldMkLst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13" creationId="{F07C43B7-6444-C089-83BA-6674DB50F82E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14" creationId="{559B0589-4FD2-1E0E-042E-38223521C8C5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15" creationId="{4EF17B06-24B3-67BB-991C-3A4923928A8F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16" creationId="{15B02FC7-441F-F6F8-3EC4-2157BC219DFC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17" creationId="{24CA47B4-F863-8165-B7F1-CC95154AC431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18" creationId="{4F4AC765-C137-205B-148E-E45E9ED09BE0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19" creationId="{E34B50FE-2184-8F17-C30D-0B25600EFC70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20" creationId="{7CD89FD1-7413-DDA7-4AB5-FA7BD12B33B2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21" creationId="{2C1E0898-04D6-CB37-7762-1C809687ACB7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22" creationId="{90C4F112-161B-EF39-093F-9A7247D88183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24" creationId="{21B83158-7C1D-1AB3-823F-DA8AAB4926D3}"/>
          </ac:spMkLst>
        </pc:spChg>
        <pc:spChg chg="mod">
          <ac:chgData name="Ayesha Shafi" userId="75ef1296-0a29-4795-a39c-cc19b40d46a0" providerId="ADAL" clId="{DD682CFB-8527-1347-85A8-55B86B78DAF8}" dt="2025-03-17T13:09:03.324" v="4"/>
          <ac:spMkLst>
            <pc:docMk/>
            <pc:sldMk cId="1124846986" sldId="307"/>
            <ac:spMk id="25" creationId="{3CBC1039-D39D-EE8F-58EE-C0888DC185B2}"/>
          </ac:spMkLst>
        </pc:spChg>
        <pc:grpChg chg="add mod">
          <ac:chgData name="Ayesha Shafi" userId="75ef1296-0a29-4795-a39c-cc19b40d46a0" providerId="ADAL" clId="{DD682CFB-8527-1347-85A8-55B86B78DAF8}" dt="2025-03-17T13:09:01.797" v="3" actId="1076"/>
          <ac:grpSpMkLst>
            <pc:docMk/>
            <pc:sldMk cId="1124846986" sldId="307"/>
            <ac:grpSpMk id="6" creationId="{C4124963-69A9-C58B-53B3-1D36BAFB0F87}"/>
          </ac:grpSpMkLst>
        </pc:grpChg>
        <pc:grpChg chg="add del">
          <ac:chgData name="Ayesha Shafi" userId="75ef1296-0a29-4795-a39c-cc19b40d46a0" providerId="ADAL" clId="{DD682CFB-8527-1347-85A8-55B86B78DAF8}" dt="2025-03-17T13:08:57.455" v="2" actId="21"/>
          <ac:grpSpMkLst>
            <pc:docMk/>
            <pc:sldMk cId="1124846986" sldId="307"/>
            <ac:grpSpMk id="8" creationId="{12596746-58B5-5D94-49EA-5AC52F6F071E}"/>
          </ac:grpSpMkLst>
        </pc:grpChg>
        <pc:grpChg chg="add mod">
          <ac:chgData name="Ayesha Shafi" userId="75ef1296-0a29-4795-a39c-cc19b40d46a0" providerId="ADAL" clId="{DD682CFB-8527-1347-85A8-55B86B78DAF8}" dt="2025-03-17T13:09:15.049" v="11" actId="1076"/>
          <ac:grpSpMkLst>
            <pc:docMk/>
            <pc:sldMk cId="1124846986" sldId="307"/>
            <ac:grpSpMk id="10" creationId="{881902A5-B610-6B37-E8FD-C93DEA884C3C}"/>
          </ac:grpSpMkLst>
        </pc:grpChg>
        <pc:picChg chg="mod">
          <ac:chgData name="Ayesha Shafi" userId="75ef1296-0a29-4795-a39c-cc19b40d46a0" providerId="ADAL" clId="{DD682CFB-8527-1347-85A8-55B86B78DAF8}" dt="2025-03-17T13:09:03.324" v="4"/>
          <ac:picMkLst>
            <pc:docMk/>
            <pc:sldMk cId="1124846986" sldId="307"/>
            <ac:picMk id="12" creationId="{A4B1D925-F05E-E4C8-34E1-FFAA34148028}"/>
          </ac:picMkLst>
        </pc:picChg>
        <pc:cxnChg chg="mod">
          <ac:chgData name="Ayesha Shafi" userId="75ef1296-0a29-4795-a39c-cc19b40d46a0" providerId="ADAL" clId="{DD682CFB-8527-1347-85A8-55B86B78DAF8}" dt="2025-03-17T13:09:03.324" v="4"/>
          <ac:cxnSpMkLst>
            <pc:docMk/>
            <pc:sldMk cId="1124846986" sldId="307"/>
            <ac:cxnSpMk id="26" creationId="{7314992D-EF54-386D-528A-EC652E2E8019}"/>
          </ac:cxnSpMkLst>
        </pc:cxnChg>
        <pc:cxnChg chg="mod">
          <ac:chgData name="Ayesha Shafi" userId="75ef1296-0a29-4795-a39c-cc19b40d46a0" providerId="ADAL" clId="{DD682CFB-8527-1347-85A8-55B86B78DAF8}" dt="2025-03-17T13:09:03.324" v="4"/>
          <ac:cxnSpMkLst>
            <pc:docMk/>
            <pc:sldMk cId="1124846986" sldId="307"/>
            <ac:cxnSpMk id="30" creationId="{270681F3-BE02-6079-80FF-9EACCDF6D0DD}"/>
          </ac:cxnSpMkLst>
        </pc:cxnChg>
      </pc:sldChg>
    </pc:docChg>
  </pc:docChgLst>
  <pc:docChgLst>
    <pc:chgData name="Ayesha Shafi" userId="75ef1296-0a29-4795-a39c-cc19b40d46a0" providerId="ADAL" clId="{5188A86C-7251-B54B-B174-47901E5927A2}"/>
    <pc:docChg chg="modSld">
      <pc:chgData name="Ayesha Shafi" userId="75ef1296-0a29-4795-a39c-cc19b40d46a0" providerId="ADAL" clId="{5188A86C-7251-B54B-B174-47901E5927A2}" dt="2025-07-22T14:49:04.516" v="4" actId="207"/>
      <pc:docMkLst>
        <pc:docMk/>
      </pc:docMkLst>
      <pc:sldChg chg="modSp mod">
        <pc:chgData name="Ayesha Shafi" userId="75ef1296-0a29-4795-a39c-cc19b40d46a0" providerId="ADAL" clId="{5188A86C-7251-B54B-B174-47901E5927A2}" dt="2025-07-22T14:48:54.949" v="2" actId="207"/>
        <pc:sldMkLst>
          <pc:docMk/>
          <pc:sldMk cId="2753215545" sldId="291"/>
        </pc:sldMkLst>
        <pc:spChg chg="mod">
          <ac:chgData name="Ayesha Shafi" userId="75ef1296-0a29-4795-a39c-cc19b40d46a0" providerId="ADAL" clId="{5188A86C-7251-B54B-B174-47901E5927A2}" dt="2025-07-22T14:48:54.949" v="2" actId="207"/>
          <ac:spMkLst>
            <pc:docMk/>
            <pc:sldMk cId="2753215545" sldId="291"/>
            <ac:spMk id="82" creationId="{E07F2A6C-3C4E-D841-81EA-90184A4C530B}"/>
          </ac:spMkLst>
        </pc:spChg>
      </pc:sldChg>
      <pc:sldChg chg="modSp mod">
        <pc:chgData name="Ayesha Shafi" userId="75ef1296-0a29-4795-a39c-cc19b40d46a0" providerId="ADAL" clId="{5188A86C-7251-B54B-B174-47901E5927A2}" dt="2025-07-22T14:48:43.875" v="0" actId="207"/>
        <pc:sldMkLst>
          <pc:docMk/>
          <pc:sldMk cId="1290727870" sldId="298"/>
        </pc:sldMkLst>
        <pc:spChg chg="mod">
          <ac:chgData name="Ayesha Shafi" userId="75ef1296-0a29-4795-a39c-cc19b40d46a0" providerId="ADAL" clId="{5188A86C-7251-B54B-B174-47901E5927A2}" dt="2025-07-22T14:48:43.875" v="0" actId="207"/>
          <ac:spMkLst>
            <pc:docMk/>
            <pc:sldMk cId="1290727870" sldId="298"/>
            <ac:spMk id="7" creationId="{00000000-0000-0000-0000-000000000000}"/>
          </ac:spMkLst>
        </pc:spChg>
      </pc:sldChg>
      <pc:sldChg chg="modSp mod">
        <pc:chgData name="Ayesha Shafi" userId="75ef1296-0a29-4795-a39c-cc19b40d46a0" providerId="ADAL" clId="{5188A86C-7251-B54B-B174-47901E5927A2}" dt="2025-07-22T14:48:50.082" v="1" actId="207"/>
        <pc:sldMkLst>
          <pc:docMk/>
          <pc:sldMk cId="3784057363" sldId="304"/>
        </pc:sldMkLst>
        <pc:spChg chg="mod">
          <ac:chgData name="Ayesha Shafi" userId="75ef1296-0a29-4795-a39c-cc19b40d46a0" providerId="ADAL" clId="{5188A86C-7251-B54B-B174-47901E5927A2}" dt="2025-07-22T14:48:50.082" v="1" actId="207"/>
          <ac:spMkLst>
            <pc:docMk/>
            <pc:sldMk cId="3784057363" sldId="304"/>
            <ac:spMk id="5" creationId="{56944692-9272-E245-B7FE-103ED400F3E4}"/>
          </ac:spMkLst>
        </pc:spChg>
      </pc:sldChg>
      <pc:sldChg chg="modSp mod">
        <pc:chgData name="Ayesha Shafi" userId="75ef1296-0a29-4795-a39c-cc19b40d46a0" providerId="ADAL" clId="{5188A86C-7251-B54B-B174-47901E5927A2}" dt="2025-07-22T14:49:04.516" v="4" actId="207"/>
        <pc:sldMkLst>
          <pc:docMk/>
          <pc:sldMk cId="1908151364" sldId="306"/>
        </pc:sldMkLst>
        <pc:spChg chg="mod">
          <ac:chgData name="Ayesha Shafi" userId="75ef1296-0a29-4795-a39c-cc19b40d46a0" providerId="ADAL" clId="{5188A86C-7251-B54B-B174-47901E5927A2}" dt="2025-07-22T14:49:04.516" v="4" actId="207"/>
          <ac:spMkLst>
            <pc:docMk/>
            <pc:sldMk cId="1908151364" sldId="306"/>
            <ac:spMk id="68" creationId="{EDE3D16D-9337-5F4C-8DD0-9FF539A00BED}"/>
          </ac:spMkLst>
        </pc:spChg>
      </pc:sldChg>
      <pc:sldChg chg="modSp mod">
        <pc:chgData name="Ayesha Shafi" userId="75ef1296-0a29-4795-a39c-cc19b40d46a0" providerId="ADAL" clId="{5188A86C-7251-B54B-B174-47901E5927A2}" dt="2025-07-22T14:49:00.342" v="3" actId="207"/>
        <pc:sldMkLst>
          <pc:docMk/>
          <pc:sldMk cId="4103562211" sldId="311"/>
        </pc:sldMkLst>
        <pc:spChg chg="mod">
          <ac:chgData name="Ayesha Shafi" userId="75ef1296-0a29-4795-a39c-cc19b40d46a0" providerId="ADAL" clId="{5188A86C-7251-B54B-B174-47901E5927A2}" dt="2025-07-22T14:49:00.342" v="3" actId="207"/>
          <ac:spMkLst>
            <pc:docMk/>
            <pc:sldMk cId="4103562211" sldId="311"/>
            <ac:spMk id="60" creationId="{00000000-0000-0000-0000-000000000000}"/>
          </ac:spMkLst>
        </pc:spChg>
      </pc:sldChg>
    </pc:docChg>
  </pc:docChgLst>
  <pc:docChgLst>
    <pc:chgData name="Ayesha Shafi" userId="75ef1296-0a29-4795-a39c-cc19b40d46a0" providerId="ADAL" clId="{82E708B4-8141-0742-A117-E709E0FBB52E}"/>
    <pc:docChg chg="undo custSel modSld">
      <pc:chgData name="Ayesha Shafi" userId="75ef1296-0a29-4795-a39c-cc19b40d46a0" providerId="ADAL" clId="{82E708B4-8141-0742-A117-E709E0FBB52E}" dt="2025-11-15T15:19:01.593" v="9" actId="1076"/>
      <pc:docMkLst>
        <pc:docMk/>
      </pc:docMkLst>
      <pc:sldChg chg="addSp delSp modSp mod">
        <pc:chgData name="Ayesha Shafi" userId="75ef1296-0a29-4795-a39c-cc19b40d46a0" providerId="ADAL" clId="{82E708B4-8141-0742-A117-E709E0FBB52E}" dt="2025-11-15T15:19:01.593" v="9" actId="1076"/>
        <pc:sldMkLst>
          <pc:docMk/>
          <pc:sldMk cId="3163178404" sldId="310"/>
        </pc:sldMkLst>
        <pc:graphicFrameChg chg="add del mod">
          <ac:chgData name="Ayesha Shafi" userId="75ef1296-0a29-4795-a39c-cc19b40d46a0" providerId="ADAL" clId="{82E708B4-8141-0742-A117-E709E0FBB52E}" dt="2025-11-15T15:18:45.947" v="2"/>
          <ac:graphicFrameMkLst>
            <pc:docMk/>
            <pc:sldMk cId="3163178404" sldId="310"/>
            <ac:graphicFrameMk id="3" creationId="{B3B2275B-03B9-5FDE-C49C-5C199E565276}"/>
          </ac:graphicFrameMkLst>
        </pc:graphicFrameChg>
        <pc:graphicFrameChg chg="add mod modGraphic">
          <ac:chgData name="Ayesha Shafi" userId="75ef1296-0a29-4795-a39c-cc19b40d46a0" providerId="ADAL" clId="{82E708B4-8141-0742-A117-E709E0FBB52E}" dt="2025-11-15T15:19:01.593" v="9" actId="1076"/>
          <ac:graphicFrameMkLst>
            <pc:docMk/>
            <pc:sldMk cId="3163178404" sldId="310"/>
            <ac:graphicFrameMk id="4" creationId="{8C0FFEF6-2C6E-0275-2888-B187B145C82F}"/>
          </ac:graphicFrameMkLst>
        </pc:graphicFrameChg>
        <pc:picChg chg="del">
          <ac:chgData name="Ayesha Shafi" userId="75ef1296-0a29-4795-a39c-cc19b40d46a0" providerId="ADAL" clId="{82E708B4-8141-0742-A117-E709E0FBB52E}" dt="2025-11-15T15:18:34.398" v="0" actId="478"/>
          <ac:picMkLst>
            <pc:docMk/>
            <pc:sldMk cId="3163178404" sldId="310"/>
            <ac:picMk id="2" creationId="{A58DC3F5-62E9-A312-A29C-93E3DB3FC131}"/>
          </ac:picMkLst>
        </pc:picChg>
      </pc:sldChg>
    </pc:docChg>
  </pc:docChgLst>
  <pc:docChgLst>
    <pc:chgData name="Ayesha Shafi" userId="75ef1296-0a29-4795-a39c-cc19b40d46a0" providerId="ADAL" clId="{5C6D021E-1CA2-6442-B645-9AAE8B5A41EA}"/>
    <pc:docChg chg="delSld">
      <pc:chgData name="Ayesha Shafi" userId="75ef1296-0a29-4795-a39c-cc19b40d46a0" providerId="ADAL" clId="{5C6D021E-1CA2-6442-B645-9AAE8B5A41EA}" dt="2025-10-17T15:24:29.177" v="5" actId="2696"/>
      <pc:docMkLst>
        <pc:docMk/>
      </pc:docMkLst>
      <pc:sldChg chg="del">
        <pc:chgData name="Ayesha Shafi" userId="75ef1296-0a29-4795-a39c-cc19b40d46a0" providerId="ADAL" clId="{5C6D021E-1CA2-6442-B645-9AAE8B5A41EA}" dt="2025-10-17T15:24:29.067" v="1" actId="2696"/>
        <pc:sldMkLst>
          <pc:docMk/>
          <pc:sldMk cId="2236825674" sldId="264"/>
        </pc:sldMkLst>
      </pc:sldChg>
      <pc:sldChg chg="del">
        <pc:chgData name="Ayesha Shafi" userId="75ef1296-0a29-4795-a39c-cc19b40d46a0" providerId="ADAL" clId="{5C6D021E-1CA2-6442-B645-9AAE8B5A41EA}" dt="2025-10-17T15:24:26.385" v="0" actId="2696"/>
        <pc:sldMkLst>
          <pc:docMk/>
          <pc:sldMk cId="2753215545" sldId="291"/>
        </pc:sldMkLst>
      </pc:sldChg>
      <pc:sldChg chg="del">
        <pc:chgData name="Ayesha Shafi" userId="75ef1296-0a29-4795-a39c-cc19b40d46a0" providerId="ADAL" clId="{5C6D021E-1CA2-6442-B645-9AAE8B5A41EA}" dt="2025-10-17T15:24:29.177" v="5" actId="2696"/>
        <pc:sldMkLst>
          <pc:docMk/>
          <pc:sldMk cId="1908151364" sldId="306"/>
        </pc:sldMkLst>
      </pc:sldChg>
      <pc:sldChg chg="del">
        <pc:chgData name="Ayesha Shafi" userId="75ef1296-0a29-4795-a39c-cc19b40d46a0" providerId="ADAL" clId="{5C6D021E-1CA2-6442-B645-9AAE8B5A41EA}" dt="2025-10-17T15:24:29.095" v="2" actId="2696"/>
        <pc:sldMkLst>
          <pc:docMk/>
          <pc:sldMk cId="4103562211" sldId="311"/>
        </pc:sldMkLst>
      </pc:sldChg>
      <pc:sldChg chg="del">
        <pc:chgData name="Ayesha Shafi" userId="75ef1296-0a29-4795-a39c-cc19b40d46a0" providerId="ADAL" clId="{5C6D021E-1CA2-6442-B645-9AAE8B5A41EA}" dt="2025-10-17T15:24:29.168" v="4" actId="2696"/>
        <pc:sldMkLst>
          <pc:docMk/>
          <pc:sldMk cId="737448264" sldId="312"/>
        </pc:sldMkLst>
      </pc:sldChg>
      <pc:sldMasterChg chg="delSldLayout">
        <pc:chgData name="Ayesha Shafi" userId="75ef1296-0a29-4795-a39c-cc19b40d46a0" providerId="ADAL" clId="{5C6D021E-1CA2-6442-B645-9AAE8B5A41EA}" dt="2025-10-17T15:24:29.098" v="3" actId="2696"/>
        <pc:sldMasterMkLst>
          <pc:docMk/>
          <pc:sldMasterMk cId="2135936384" sldId="2147483648"/>
        </pc:sldMasterMkLst>
        <pc:sldLayoutChg chg="del">
          <pc:chgData name="Ayesha Shafi" userId="75ef1296-0a29-4795-a39c-cc19b40d46a0" providerId="ADAL" clId="{5C6D021E-1CA2-6442-B645-9AAE8B5A41EA}" dt="2025-10-17T15:24:29.098" v="3" actId="2696"/>
          <pc:sldLayoutMkLst>
            <pc:docMk/>
            <pc:sldMasterMk cId="2135936384" sldId="2147483648"/>
            <pc:sldLayoutMk cId="693871684" sldId="2147483660"/>
          </pc:sldLayoutMkLst>
        </pc:sldLayoutChg>
      </pc:sldMasterChg>
    </pc:docChg>
  </pc:docChgLst>
  <pc:docChgLst>
    <pc:chgData name="Ayesha Shafi" userId="75ef1296-0a29-4795-a39c-cc19b40d46a0" providerId="ADAL" clId="{4AB1ABF1-9252-B14C-9BDA-6A739F6C8897}"/>
    <pc:docChg chg="delSld">
      <pc:chgData name="Ayesha Shafi" userId="75ef1296-0a29-4795-a39c-cc19b40d46a0" providerId="ADAL" clId="{4AB1ABF1-9252-B14C-9BDA-6A739F6C8897}" dt="2025-10-17T15:23:14.816" v="5" actId="2696"/>
      <pc:docMkLst>
        <pc:docMk/>
      </pc:docMkLst>
      <pc:sldChg chg="del">
        <pc:chgData name="Ayesha Shafi" userId="75ef1296-0a29-4795-a39c-cc19b40d46a0" providerId="ADAL" clId="{4AB1ABF1-9252-B14C-9BDA-6A739F6C8897}" dt="2025-10-17T15:23:13.947" v="0" actId="2696"/>
        <pc:sldMkLst>
          <pc:docMk/>
          <pc:sldMk cId="1713723769" sldId="293"/>
        </pc:sldMkLst>
      </pc:sldChg>
      <pc:sldChg chg="del">
        <pc:chgData name="Ayesha Shafi" userId="75ef1296-0a29-4795-a39c-cc19b40d46a0" providerId="ADAL" clId="{4AB1ABF1-9252-B14C-9BDA-6A739F6C8897}" dt="2025-10-17T15:23:14.237" v="2" actId="2696"/>
        <pc:sldMkLst>
          <pc:docMk/>
          <pc:sldMk cId="1122343288" sldId="294"/>
        </pc:sldMkLst>
      </pc:sldChg>
      <pc:sldChg chg="del">
        <pc:chgData name="Ayesha Shafi" userId="75ef1296-0a29-4795-a39c-cc19b40d46a0" providerId="ADAL" clId="{4AB1ABF1-9252-B14C-9BDA-6A739F6C8897}" dt="2025-10-17T15:23:14.679" v="3" actId="2696"/>
        <pc:sldMkLst>
          <pc:docMk/>
          <pc:sldMk cId="1290727870" sldId="298"/>
        </pc:sldMkLst>
      </pc:sldChg>
      <pc:sldChg chg="del">
        <pc:chgData name="Ayesha Shafi" userId="75ef1296-0a29-4795-a39c-cc19b40d46a0" providerId="ADAL" clId="{4AB1ABF1-9252-B14C-9BDA-6A739F6C8897}" dt="2025-10-17T15:23:14.816" v="5" actId="2696"/>
        <pc:sldMkLst>
          <pc:docMk/>
          <pc:sldMk cId="3784057363" sldId="304"/>
        </pc:sldMkLst>
      </pc:sldChg>
      <pc:sldChg chg="del">
        <pc:chgData name="Ayesha Shafi" userId="75ef1296-0a29-4795-a39c-cc19b40d46a0" providerId="ADAL" clId="{4AB1ABF1-9252-B14C-9BDA-6A739F6C8897}" dt="2025-10-17T15:23:14.738" v="4" actId="2696"/>
        <pc:sldMkLst>
          <pc:docMk/>
          <pc:sldMk cId="1124846986" sldId="307"/>
        </pc:sldMkLst>
      </pc:sldChg>
      <pc:sldChg chg="del">
        <pc:chgData name="Ayesha Shafi" userId="75ef1296-0a29-4795-a39c-cc19b40d46a0" providerId="ADAL" clId="{4AB1ABF1-9252-B14C-9BDA-6A739F6C8897}" dt="2025-10-17T15:23:14.131" v="1" actId="2696"/>
        <pc:sldMkLst>
          <pc:docMk/>
          <pc:sldMk cId="2412576379" sldId="309"/>
        </pc:sldMkLst>
      </pc:sldChg>
    </pc:docChg>
  </pc:docChgLst>
  <pc:docChgLst>
    <pc:chgData name="Ayesha Shafi" userId="75ef1296-0a29-4795-a39c-cc19b40d46a0" providerId="ADAL" clId="{37E9DFE0-8B56-A840-BDA9-B062D7628A2C}"/>
    <pc:docChg chg="undo redo custSel addSld delSld modSld">
      <pc:chgData name="Ayesha Shafi" userId="75ef1296-0a29-4795-a39c-cc19b40d46a0" providerId="ADAL" clId="{37E9DFE0-8B56-A840-BDA9-B062D7628A2C}" dt="2025-06-27T20:27:54.378" v="954" actId="552"/>
      <pc:docMkLst>
        <pc:docMk/>
      </pc:docMkLst>
      <pc:sldChg chg="addSp delSp modSp mod">
        <pc:chgData name="Ayesha Shafi" userId="75ef1296-0a29-4795-a39c-cc19b40d46a0" providerId="ADAL" clId="{37E9DFE0-8B56-A840-BDA9-B062D7628A2C}" dt="2025-06-27T20:27:54.378" v="954" actId="552"/>
        <pc:sldMkLst>
          <pc:docMk/>
          <pc:sldMk cId="2236825674" sldId="264"/>
        </pc:sldMkLst>
        <pc:spChg chg="del mod">
          <ac:chgData name="Ayesha Shafi" userId="75ef1296-0a29-4795-a39c-cc19b40d46a0" providerId="ADAL" clId="{37E9DFE0-8B56-A840-BDA9-B062D7628A2C}" dt="2025-06-27T19:58:30.764" v="268" actId="21"/>
          <ac:spMkLst>
            <pc:docMk/>
            <pc:sldMk cId="2236825674" sldId="264"/>
            <ac:spMk id="3" creationId="{CF51E434-9050-48E0-24F6-C3904EE54652}"/>
          </ac:spMkLst>
        </pc:spChg>
        <pc:spChg chg="add del mod">
          <ac:chgData name="Ayesha Shafi" userId="75ef1296-0a29-4795-a39c-cc19b40d46a0" providerId="ADAL" clId="{37E9DFE0-8B56-A840-BDA9-B062D7628A2C}" dt="2025-06-27T19:51:27.966" v="185" actId="21"/>
          <ac:spMkLst>
            <pc:docMk/>
            <pc:sldMk cId="2236825674" sldId="264"/>
            <ac:spMk id="7" creationId="{D3F83D29-D894-FDBB-8557-A2376F36C8DF}"/>
          </ac:spMkLst>
        </pc:spChg>
        <pc:spChg chg="add del mod">
          <ac:chgData name="Ayesha Shafi" userId="75ef1296-0a29-4795-a39c-cc19b40d46a0" providerId="ADAL" clId="{37E9DFE0-8B56-A840-BDA9-B062D7628A2C}" dt="2025-06-27T19:51:30.991" v="187" actId="21"/>
          <ac:spMkLst>
            <pc:docMk/>
            <pc:sldMk cId="2236825674" sldId="264"/>
            <ac:spMk id="8" creationId="{4B740720-A77F-779D-CAF4-C7A0CD223C15}"/>
          </ac:spMkLst>
        </pc:spChg>
        <pc:spChg chg="add del mod">
          <ac:chgData name="Ayesha Shafi" userId="75ef1296-0a29-4795-a39c-cc19b40d46a0" providerId="ADAL" clId="{37E9DFE0-8B56-A840-BDA9-B062D7628A2C}" dt="2025-06-27T19:51:30.991" v="187" actId="21"/>
          <ac:spMkLst>
            <pc:docMk/>
            <pc:sldMk cId="2236825674" sldId="264"/>
            <ac:spMk id="9" creationId="{A21FA34E-87DE-0086-95B8-7F847AD9AD30}"/>
          </ac:spMkLst>
        </pc:spChg>
        <pc:spChg chg="add del mod">
          <ac:chgData name="Ayesha Shafi" userId="75ef1296-0a29-4795-a39c-cc19b40d46a0" providerId="ADAL" clId="{37E9DFE0-8B56-A840-BDA9-B062D7628A2C}" dt="2025-06-27T20:16:03.110" v="759" actId="21"/>
          <ac:spMkLst>
            <pc:docMk/>
            <pc:sldMk cId="2236825674" sldId="264"/>
            <ac:spMk id="12" creationId="{AA54527A-52C5-BBF3-7D48-A87FD27AD812}"/>
          </ac:spMkLst>
        </pc:spChg>
        <pc:spChg chg="add mod topLvl">
          <ac:chgData name="Ayesha Shafi" userId="75ef1296-0a29-4795-a39c-cc19b40d46a0" providerId="ADAL" clId="{37E9DFE0-8B56-A840-BDA9-B062D7628A2C}" dt="2025-06-27T20:26:42.643" v="938" actId="1076"/>
          <ac:spMkLst>
            <pc:docMk/>
            <pc:sldMk cId="2236825674" sldId="264"/>
            <ac:spMk id="13" creationId="{E81D3355-49CC-6F7C-BC4C-3363EC0973B8}"/>
          </ac:spMkLst>
        </pc:spChg>
        <pc:spChg chg="add del mod">
          <ac:chgData name="Ayesha Shafi" userId="75ef1296-0a29-4795-a39c-cc19b40d46a0" providerId="ADAL" clId="{37E9DFE0-8B56-A840-BDA9-B062D7628A2C}" dt="2025-06-27T20:10:46.285" v="620" actId="21"/>
          <ac:spMkLst>
            <pc:docMk/>
            <pc:sldMk cId="2236825674" sldId="264"/>
            <ac:spMk id="14" creationId="{0D94C023-D78B-D311-8AD1-88F86B05CEF8}"/>
          </ac:spMkLst>
        </pc:spChg>
        <pc:spChg chg="add del mod">
          <ac:chgData name="Ayesha Shafi" userId="75ef1296-0a29-4795-a39c-cc19b40d46a0" providerId="ADAL" clId="{37E9DFE0-8B56-A840-BDA9-B062D7628A2C}" dt="2025-06-27T20:16:03.110" v="759" actId="21"/>
          <ac:spMkLst>
            <pc:docMk/>
            <pc:sldMk cId="2236825674" sldId="264"/>
            <ac:spMk id="15" creationId="{5EB790EB-3115-B1EA-2903-F1390F3BF454}"/>
          </ac:spMkLst>
        </pc:spChg>
        <pc:spChg chg="add del mod">
          <ac:chgData name="Ayesha Shafi" userId="75ef1296-0a29-4795-a39c-cc19b40d46a0" providerId="ADAL" clId="{37E9DFE0-8B56-A840-BDA9-B062D7628A2C}" dt="2025-06-27T19:53:09.265" v="241" actId="21"/>
          <ac:spMkLst>
            <pc:docMk/>
            <pc:sldMk cId="2236825674" sldId="264"/>
            <ac:spMk id="16" creationId="{2F9BFD1B-C50A-0205-62F0-45C04305830B}"/>
          </ac:spMkLst>
        </pc:spChg>
        <pc:spChg chg="add del mod">
          <ac:chgData name="Ayesha Shafi" userId="75ef1296-0a29-4795-a39c-cc19b40d46a0" providerId="ADAL" clId="{37E9DFE0-8B56-A840-BDA9-B062D7628A2C}" dt="2025-06-27T19:53:09.265" v="241" actId="21"/>
          <ac:spMkLst>
            <pc:docMk/>
            <pc:sldMk cId="2236825674" sldId="264"/>
            <ac:spMk id="17" creationId="{DE2E7517-EAB9-8C45-3A99-4F9816B9639B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20" creationId="{00000000-0000-0000-0000-000000000000}"/>
          </ac:spMkLst>
        </pc:spChg>
        <pc:spChg chg="add mod">
          <ac:chgData name="Ayesha Shafi" userId="75ef1296-0a29-4795-a39c-cc19b40d46a0" providerId="ADAL" clId="{37E9DFE0-8B56-A840-BDA9-B062D7628A2C}" dt="2025-06-27T20:26:42.643" v="938" actId="1076"/>
          <ac:spMkLst>
            <pc:docMk/>
            <pc:sldMk cId="2236825674" sldId="264"/>
            <ac:spMk id="23" creationId="{99F3484C-0266-18EA-E929-7A3EF97E18E4}"/>
          </ac:spMkLst>
        </pc:spChg>
        <pc:spChg chg="add mod">
          <ac:chgData name="Ayesha Shafi" userId="75ef1296-0a29-4795-a39c-cc19b40d46a0" providerId="ADAL" clId="{37E9DFE0-8B56-A840-BDA9-B062D7628A2C}" dt="2025-06-27T20:26:42.643" v="938" actId="1076"/>
          <ac:spMkLst>
            <pc:docMk/>
            <pc:sldMk cId="2236825674" sldId="264"/>
            <ac:spMk id="24" creationId="{BE9BCFD1-9EE6-9B35-B83C-A2CF6191C00D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25" creationId="{00000000-0000-0000-0000-000000000000}"/>
          </ac:spMkLst>
        </pc:spChg>
        <pc:spChg chg="add del mod">
          <ac:chgData name="Ayesha Shafi" userId="75ef1296-0a29-4795-a39c-cc19b40d46a0" providerId="ADAL" clId="{37E9DFE0-8B56-A840-BDA9-B062D7628A2C}" dt="2025-06-27T20:24:20.438" v="870" actId="21"/>
          <ac:spMkLst>
            <pc:docMk/>
            <pc:sldMk cId="2236825674" sldId="264"/>
            <ac:spMk id="26" creationId="{7A0F1CBD-821E-C70B-5018-2A18133D17D8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28" creationId="{00000000-0000-0000-0000-000000000000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33" creationId="{00000000-0000-0000-0000-000000000000}"/>
          </ac:spMkLst>
        </pc:spChg>
        <pc:spChg chg="mod">
          <ac:chgData name="Ayesha Shafi" userId="75ef1296-0a29-4795-a39c-cc19b40d46a0" providerId="ADAL" clId="{37E9DFE0-8B56-A840-BDA9-B062D7628A2C}" dt="2025-06-27T20:23:21.661" v="789" actId="404"/>
          <ac:spMkLst>
            <pc:docMk/>
            <pc:sldMk cId="2236825674" sldId="264"/>
            <ac:spMk id="35" creationId="{00000000-0000-0000-0000-000000000000}"/>
          </ac:spMkLst>
        </pc:spChg>
        <pc:spChg chg="mod">
          <ac:chgData name="Ayesha Shafi" userId="75ef1296-0a29-4795-a39c-cc19b40d46a0" providerId="ADAL" clId="{37E9DFE0-8B56-A840-BDA9-B062D7628A2C}" dt="2025-06-27T20:23:21.661" v="789" actId="404"/>
          <ac:spMkLst>
            <pc:docMk/>
            <pc:sldMk cId="2236825674" sldId="264"/>
            <ac:spMk id="37" creationId="{00000000-0000-0000-0000-000000000000}"/>
          </ac:spMkLst>
        </pc:spChg>
        <pc:spChg chg="add mod">
          <ac:chgData name="Ayesha Shafi" userId="75ef1296-0a29-4795-a39c-cc19b40d46a0" providerId="ADAL" clId="{37E9DFE0-8B56-A840-BDA9-B062D7628A2C}" dt="2025-06-27T20:23:54.945" v="816" actId="1035"/>
          <ac:spMkLst>
            <pc:docMk/>
            <pc:sldMk cId="2236825674" sldId="264"/>
            <ac:spMk id="39" creationId="{B836B065-FE5F-B397-629F-C1F63BAA4262}"/>
          </ac:spMkLst>
        </pc:spChg>
        <pc:spChg chg="add mod">
          <ac:chgData name="Ayesha Shafi" userId="75ef1296-0a29-4795-a39c-cc19b40d46a0" providerId="ADAL" clId="{37E9DFE0-8B56-A840-BDA9-B062D7628A2C}" dt="2025-06-27T20:23:54.945" v="816" actId="1035"/>
          <ac:spMkLst>
            <pc:docMk/>
            <pc:sldMk cId="2236825674" sldId="264"/>
            <ac:spMk id="40" creationId="{AA638429-8EF1-EC50-7C68-8B94898FA707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42" creationId="{00000000-0000-0000-0000-000000000000}"/>
          </ac:spMkLst>
        </pc:spChg>
        <pc:spChg chg="add mod topLvl">
          <ac:chgData name="Ayesha Shafi" userId="75ef1296-0a29-4795-a39c-cc19b40d46a0" providerId="ADAL" clId="{37E9DFE0-8B56-A840-BDA9-B062D7628A2C}" dt="2025-06-27T20:26:42.643" v="938" actId="1076"/>
          <ac:spMkLst>
            <pc:docMk/>
            <pc:sldMk cId="2236825674" sldId="264"/>
            <ac:spMk id="43" creationId="{44982313-B1A4-0F8B-FDAD-99C2C09B0B6C}"/>
          </ac:spMkLst>
        </pc:spChg>
        <pc:spChg chg="add mod">
          <ac:chgData name="Ayesha Shafi" userId="75ef1296-0a29-4795-a39c-cc19b40d46a0" providerId="ADAL" clId="{37E9DFE0-8B56-A840-BDA9-B062D7628A2C}" dt="2025-06-27T20:27:54.378" v="954" actId="552"/>
          <ac:spMkLst>
            <pc:docMk/>
            <pc:sldMk cId="2236825674" sldId="264"/>
            <ac:spMk id="45" creationId="{A5F0FF25-1ABF-809E-5B79-F2B255A809C2}"/>
          </ac:spMkLst>
        </pc:spChg>
        <pc:spChg chg="add mod">
          <ac:chgData name="Ayesha Shafi" userId="75ef1296-0a29-4795-a39c-cc19b40d46a0" providerId="ADAL" clId="{37E9DFE0-8B56-A840-BDA9-B062D7628A2C}" dt="2025-06-27T20:27:54.378" v="954" actId="552"/>
          <ac:spMkLst>
            <pc:docMk/>
            <pc:sldMk cId="2236825674" sldId="264"/>
            <ac:spMk id="46" creationId="{F6EB3F6F-2773-3159-CFD1-2FBB1C828E1F}"/>
          </ac:spMkLst>
        </pc:spChg>
        <pc:spChg chg="add del mod">
          <ac:chgData name="Ayesha Shafi" userId="75ef1296-0a29-4795-a39c-cc19b40d46a0" providerId="ADAL" clId="{37E9DFE0-8B56-A840-BDA9-B062D7628A2C}" dt="2025-06-27T20:24:20.438" v="870" actId="21"/>
          <ac:spMkLst>
            <pc:docMk/>
            <pc:sldMk cId="2236825674" sldId="264"/>
            <ac:spMk id="47" creationId="{219DC16F-13A4-3231-842B-3DB2CC17DA6B}"/>
          </ac:spMkLst>
        </pc:spChg>
        <pc:spChg chg="add del mod">
          <ac:chgData name="Ayesha Shafi" userId="75ef1296-0a29-4795-a39c-cc19b40d46a0" providerId="ADAL" clId="{37E9DFE0-8B56-A840-BDA9-B062D7628A2C}" dt="2025-06-27T20:17:01.686" v="773" actId="21"/>
          <ac:spMkLst>
            <pc:docMk/>
            <pc:sldMk cId="2236825674" sldId="264"/>
            <ac:spMk id="48" creationId="{717F4065-0D5D-8654-AA7A-5D095AC23FD5}"/>
          </ac:spMkLst>
        </pc:spChg>
        <pc:spChg chg="add del mod">
          <ac:chgData name="Ayesha Shafi" userId="75ef1296-0a29-4795-a39c-cc19b40d46a0" providerId="ADAL" clId="{37E9DFE0-8B56-A840-BDA9-B062D7628A2C}" dt="2025-06-27T20:17:01.686" v="773" actId="21"/>
          <ac:spMkLst>
            <pc:docMk/>
            <pc:sldMk cId="2236825674" sldId="264"/>
            <ac:spMk id="49" creationId="{054FB5EC-949A-C8B0-0B4D-857B22167452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51" creationId="{00000000-0000-0000-0000-000000000000}"/>
          </ac:spMkLst>
        </pc:spChg>
        <pc:spChg chg="add mod">
          <ac:chgData name="Ayesha Shafi" userId="75ef1296-0a29-4795-a39c-cc19b40d46a0" providerId="ADAL" clId="{37E9DFE0-8B56-A840-BDA9-B062D7628A2C}" dt="2025-06-27T20:24:41.490" v="875" actId="1036"/>
          <ac:spMkLst>
            <pc:docMk/>
            <pc:sldMk cId="2236825674" sldId="264"/>
            <ac:spMk id="54" creationId="{4756FF3E-74BC-03C9-901B-F72E06A6D77C}"/>
          </ac:spMkLst>
        </pc:spChg>
        <pc:spChg chg="add mod">
          <ac:chgData name="Ayesha Shafi" userId="75ef1296-0a29-4795-a39c-cc19b40d46a0" providerId="ADAL" clId="{37E9DFE0-8B56-A840-BDA9-B062D7628A2C}" dt="2025-06-27T20:24:41.490" v="875" actId="1036"/>
          <ac:spMkLst>
            <pc:docMk/>
            <pc:sldMk cId="2236825674" sldId="264"/>
            <ac:spMk id="55" creationId="{4CDDF824-8D62-BC5F-058C-6EB0D9B8940E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57" creationId="{00000000-0000-0000-0000-000000000000}"/>
          </ac:spMkLst>
        </pc:spChg>
        <pc:spChg chg="mod">
          <ac:chgData name="Ayesha Shafi" userId="75ef1296-0a29-4795-a39c-cc19b40d46a0" providerId="ADAL" clId="{37E9DFE0-8B56-A840-BDA9-B062D7628A2C}" dt="2025-06-27T20:23:17.995" v="788" actId="404"/>
          <ac:spMkLst>
            <pc:docMk/>
            <pc:sldMk cId="2236825674" sldId="264"/>
            <ac:spMk id="59" creationId="{00000000-0000-0000-0000-000000000000}"/>
          </ac:spMkLst>
        </pc:spChg>
        <pc:spChg chg="add del mod">
          <ac:chgData name="Ayesha Shafi" userId="75ef1296-0a29-4795-a39c-cc19b40d46a0" providerId="ADAL" clId="{37E9DFE0-8B56-A840-BDA9-B062D7628A2C}" dt="2025-06-27T20:15:56.627" v="758" actId="478"/>
          <ac:spMkLst>
            <pc:docMk/>
            <pc:sldMk cId="2236825674" sldId="264"/>
            <ac:spMk id="60" creationId="{00000000-0000-0000-0000-000000000000}"/>
          </ac:spMkLst>
        </pc:spChg>
        <pc:spChg chg="add mod">
          <ac:chgData name="Ayesha Shafi" userId="75ef1296-0a29-4795-a39c-cc19b40d46a0" providerId="ADAL" clId="{37E9DFE0-8B56-A840-BDA9-B062D7628A2C}" dt="2025-06-27T20:27:54.378" v="954" actId="552"/>
          <ac:spMkLst>
            <pc:docMk/>
            <pc:sldMk cId="2236825674" sldId="264"/>
            <ac:spMk id="61" creationId="{7701D7EF-9B6B-8FF4-D02E-EF52617301E1}"/>
          </ac:spMkLst>
        </pc:spChg>
        <pc:spChg chg="mod">
          <ac:chgData name="Ayesha Shafi" userId="75ef1296-0a29-4795-a39c-cc19b40d46a0" providerId="ADAL" clId="{37E9DFE0-8B56-A840-BDA9-B062D7628A2C}" dt="2025-06-27T20:27:54.378" v="954" actId="552"/>
          <ac:spMkLst>
            <pc:docMk/>
            <pc:sldMk cId="2236825674" sldId="264"/>
            <ac:spMk id="62" creationId="{00000000-0000-0000-0000-000000000000}"/>
          </ac:spMkLst>
        </pc:spChg>
        <pc:spChg chg="mod">
          <ac:chgData name="Ayesha Shafi" userId="75ef1296-0a29-4795-a39c-cc19b40d46a0" providerId="ADAL" clId="{37E9DFE0-8B56-A840-BDA9-B062D7628A2C}" dt="2025-06-27T20:23:47.271" v="801" actId="1036"/>
          <ac:spMkLst>
            <pc:docMk/>
            <pc:sldMk cId="2236825674" sldId="264"/>
            <ac:spMk id="63" creationId="{00000000-0000-0000-0000-000000000000}"/>
          </ac:spMkLst>
        </pc:spChg>
        <pc:spChg chg="add mod">
          <ac:chgData name="Ayesha Shafi" userId="75ef1296-0a29-4795-a39c-cc19b40d46a0" providerId="ADAL" clId="{37E9DFE0-8B56-A840-BDA9-B062D7628A2C}" dt="2025-06-27T20:27:54.378" v="954" actId="552"/>
          <ac:spMkLst>
            <pc:docMk/>
            <pc:sldMk cId="2236825674" sldId="264"/>
            <ac:spMk id="64" creationId="{9EB15094-7E15-B1CA-36DC-E261A237F44B}"/>
          </ac:spMkLst>
        </pc:spChg>
        <pc:spChg chg="add mod">
          <ac:chgData name="Ayesha Shafi" userId="75ef1296-0a29-4795-a39c-cc19b40d46a0" providerId="ADAL" clId="{37E9DFE0-8B56-A840-BDA9-B062D7628A2C}" dt="2025-06-27T20:27:03.731" v="943" actId="555"/>
          <ac:spMkLst>
            <pc:docMk/>
            <pc:sldMk cId="2236825674" sldId="264"/>
            <ac:spMk id="65" creationId="{277D677B-A15C-C572-0AAD-664E5CD52FC6}"/>
          </ac:spMkLst>
        </pc:spChg>
        <pc:spChg chg="add mod">
          <ac:chgData name="Ayesha Shafi" userId="75ef1296-0a29-4795-a39c-cc19b40d46a0" providerId="ADAL" clId="{37E9DFE0-8B56-A840-BDA9-B062D7628A2C}" dt="2025-06-27T20:27:38.096" v="953" actId="1035"/>
          <ac:spMkLst>
            <pc:docMk/>
            <pc:sldMk cId="2236825674" sldId="264"/>
            <ac:spMk id="68" creationId="{9DDC6768-0825-752B-F5FA-82DFFBF9E29A}"/>
          </ac:spMkLst>
        </pc:spChg>
        <pc:spChg chg="add mod">
          <ac:chgData name="Ayesha Shafi" userId="75ef1296-0a29-4795-a39c-cc19b40d46a0" providerId="ADAL" clId="{37E9DFE0-8B56-A840-BDA9-B062D7628A2C}" dt="2025-06-27T20:27:38.096" v="953" actId="1035"/>
          <ac:spMkLst>
            <pc:docMk/>
            <pc:sldMk cId="2236825674" sldId="264"/>
            <ac:spMk id="69" creationId="{AEF9E5DB-4AA5-AFBC-31B4-FF50B171B21F}"/>
          </ac:spMkLst>
        </pc:spChg>
        <pc:grpChg chg="mod">
          <ac:chgData name="Ayesha Shafi" userId="75ef1296-0a29-4795-a39c-cc19b40d46a0" providerId="ADAL" clId="{37E9DFE0-8B56-A840-BDA9-B062D7628A2C}" dt="2025-06-27T20:23:47.271" v="801" actId="1036"/>
          <ac:grpSpMkLst>
            <pc:docMk/>
            <pc:sldMk cId="2236825674" sldId="264"/>
            <ac:grpSpMk id="31" creationId="{00000000-0000-0000-0000-000000000000}"/>
          </ac:grpSpMkLst>
        </pc:grpChg>
        <pc:grpChg chg="mod">
          <ac:chgData name="Ayesha Shafi" userId="75ef1296-0a29-4795-a39c-cc19b40d46a0" providerId="ADAL" clId="{37E9DFE0-8B56-A840-BDA9-B062D7628A2C}" dt="2025-06-27T20:23:47.271" v="801" actId="1036"/>
          <ac:grpSpMkLst>
            <pc:docMk/>
            <pc:sldMk cId="2236825674" sldId="264"/>
            <ac:grpSpMk id="32" creationId="{00000000-0000-0000-0000-000000000000}"/>
          </ac:grpSpMkLst>
        </pc:grpChg>
        <pc:grpChg chg="add del mod">
          <ac:chgData name="Ayesha Shafi" userId="75ef1296-0a29-4795-a39c-cc19b40d46a0" providerId="ADAL" clId="{37E9DFE0-8B56-A840-BDA9-B062D7628A2C}" dt="2025-06-27T20:15:31.696" v="742" actId="164"/>
          <ac:grpSpMkLst>
            <pc:docMk/>
            <pc:sldMk cId="2236825674" sldId="264"/>
            <ac:grpSpMk id="44" creationId="{449FAB5B-CA25-0FE8-F050-77C38019B5EE}"/>
          </ac:grpSpMkLst>
        </pc:grpChg>
        <pc:grpChg chg="mod">
          <ac:chgData name="Ayesha Shafi" userId="75ef1296-0a29-4795-a39c-cc19b40d46a0" providerId="ADAL" clId="{37E9DFE0-8B56-A840-BDA9-B062D7628A2C}" dt="2025-06-27T20:23:47.271" v="801" actId="1036"/>
          <ac:grpSpMkLst>
            <pc:docMk/>
            <pc:sldMk cId="2236825674" sldId="264"/>
            <ac:grpSpMk id="56" creationId="{00000000-0000-0000-0000-000000000000}"/>
          </ac:grpSpMkLst>
        </pc:grpChg>
        <pc:picChg chg="mod">
          <ac:chgData name="Ayesha Shafi" userId="75ef1296-0a29-4795-a39c-cc19b40d46a0" providerId="ADAL" clId="{37E9DFE0-8B56-A840-BDA9-B062D7628A2C}" dt="2025-06-27T20:23:47.271" v="801" actId="1036"/>
          <ac:picMkLst>
            <pc:docMk/>
            <pc:sldMk cId="2236825674" sldId="264"/>
            <ac:picMk id="2" creationId="{00000000-0000-0000-0000-000000000000}"/>
          </ac:picMkLst>
        </pc:picChg>
        <pc:picChg chg="mod">
          <ac:chgData name="Ayesha Shafi" userId="75ef1296-0a29-4795-a39c-cc19b40d46a0" providerId="ADAL" clId="{37E9DFE0-8B56-A840-BDA9-B062D7628A2C}" dt="2025-06-27T20:23:47.271" v="801" actId="1036"/>
          <ac:picMkLst>
            <pc:docMk/>
            <pc:sldMk cId="2236825674" sldId="264"/>
            <ac:picMk id="4" creationId="{00000000-0000-0000-0000-000000000000}"/>
          </ac:picMkLst>
        </pc:picChg>
        <pc:picChg chg="del mod">
          <ac:chgData name="Ayesha Shafi" userId="75ef1296-0a29-4795-a39c-cc19b40d46a0" providerId="ADAL" clId="{37E9DFE0-8B56-A840-BDA9-B062D7628A2C}" dt="2025-06-27T19:58:30.764" v="268" actId="21"/>
          <ac:picMkLst>
            <pc:docMk/>
            <pc:sldMk cId="2236825674" sldId="264"/>
            <ac:picMk id="5" creationId="{CBFAF190-4308-B128-6CD1-7A12579C9DF2}"/>
          </ac:picMkLst>
        </pc:picChg>
        <pc:picChg chg="del mod">
          <ac:chgData name="Ayesha Shafi" userId="75ef1296-0a29-4795-a39c-cc19b40d46a0" providerId="ADAL" clId="{37E9DFE0-8B56-A840-BDA9-B062D7628A2C}" dt="2025-06-27T19:58:30.764" v="268" actId="21"/>
          <ac:picMkLst>
            <pc:docMk/>
            <pc:sldMk cId="2236825674" sldId="264"/>
            <ac:picMk id="6" creationId="{D03343DF-4D29-61B6-09D9-4071BEF5A838}"/>
          </ac:picMkLst>
        </pc:picChg>
        <pc:picChg chg="add del mod topLvl">
          <ac:chgData name="Ayesha Shafi" userId="75ef1296-0a29-4795-a39c-cc19b40d46a0" providerId="ADAL" clId="{37E9DFE0-8B56-A840-BDA9-B062D7628A2C}" dt="2025-06-27T20:26:42.643" v="938" actId="1076"/>
          <ac:picMkLst>
            <pc:docMk/>
            <pc:sldMk cId="2236825674" sldId="264"/>
            <ac:picMk id="10" creationId="{3146C480-B6C4-18B1-CE39-DC5FEA78E4BB}"/>
          </ac:picMkLst>
        </pc:picChg>
        <pc:picChg chg="add mod topLvl">
          <ac:chgData name="Ayesha Shafi" userId="75ef1296-0a29-4795-a39c-cc19b40d46a0" providerId="ADAL" clId="{37E9DFE0-8B56-A840-BDA9-B062D7628A2C}" dt="2025-06-27T20:26:42.643" v="938" actId="1076"/>
          <ac:picMkLst>
            <pc:docMk/>
            <pc:sldMk cId="2236825674" sldId="264"/>
            <ac:picMk id="11" creationId="{4E8E1AF0-BE8B-7741-EFA6-DFF2DAD10B9B}"/>
          </ac:picMkLst>
        </pc:picChg>
        <pc:picChg chg="add del mod">
          <ac:chgData name="Ayesha Shafi" userId="75ef1296-0a29-4795-a39c-cc19b40d46a0" providerId="ADAL" clId="{37E9DFE0-8B56-A840-BDA9-B062D7628A2C}" dt="2025-06-27T19:52:45.658" v="223" actId="21"/>
          <ac:picMkLst>
            <pc:docMk/>
            <pc:sldMk cId="2236825674" sldId="264"/>
            <ac:picMk id="18" creationId="{8237AFE6-8CDE-A84F-E8E7-E73CF34161D0}"/>
          </ac:picMkLst>
        </pc:picChg>
        <pc:picChg chg="add del mod">
          <ac:chgData name="Ayesha Shafi" userId="75ef1296-0a29-4795-a39c-cc19b40d46a0" providerId="ADAL" clId="{37E9DFE0-8B56-A840-BDA9-B062D7628A2C}" dt="2025-06-27T19:52:45.658" v="223" actId="21"/>
          <ac:picMkLst>
            <pc:docMk/>
            <pc:sldMk cId="2236825674" sldId="264"/>
            <ac:picMk id="19" creationId="{BBE527F7-2A16-2D58-5F14-7B420C0A127D}"/>
          </ac:picMkLst>
        </pc:picChg>
        <pc:picChg chg="add mod">
          <ac:chgData name="Ayesha Shafi" userId="75ef1296-0a29-4795-a39c-cc19b40d46a0" providerId="ADAL" clId="{37E9DFE0-8B56-A840-BDA9-B062D7628A2C}" dt="2025-06-27T20:26:42.643" v="938" actId="1076"/>
          <ac:picMkLst>
            <pc:docMk/>
            <pc:sldMk cId="2236825674" sldId="264"/>
            <ac:picMk id="21" creationId="{B814F992-5B4B-5069-06C7-FF5A968BDF00}"/>
          </ac:picMkLst>
        </pc:picChg>
        <pc:picChg chg="add mod">
          <ac:chgData name="Ayesha Shafi" userId="75ef1296-0a29-4795-a39c-cc19b40d46a0" providerId="ADAL" clId="{37E9DFE0-8B56-A840-BDA9-B062D7628A2C}" dt="2025-06-27T20:26:42.643" v="938" actId="1076"/>
          <ac:picMkLst>
            <pc:docMk/>
            <pc:sldMk cId="2236825674" sldId="264"/>
            <ac:picMk id="22" creationId="{F1AB533E-8BE3-AFE1-D2FD-74BFD9E925C9}"/>
          </ac:picMkLst>
        </pc:picChg>
        <pc:picChg chg="add del mod">
          <ac:chgData name="Ayesha Shafi" userId="75ef1296-0a29-4795-a39c-cc19b40d46a0" providerId="ADAL" clId="{37E9DFE0-8B56-A840-BDA9-B062D7628A2C}" dt="2025-06-27T20:09:48.779" v="594" actId="478"/>
          <ac:picMkLst>
            <pc:docMk/>
            <pc:sldMk cId="2236825674" sldId="264"/>
            <ac:picMk id="27" creationId="{CC9AF4DA-1720-79F0-7F57-D59886CF2155}"/>
          </ac:picMkLst>
        </pc:picChg>
        <pc:picChg chg="add del mod">
          <ac:chgData name="Ayesha Shafi" userId="75ef1296-0a29-4795-a39c-cc19b40d46a0" providerId="ADAL" clId="{37E9DFE0-8B56-A840-BDA9-B062D7628A2C}" dt="2025-06-27T20:09:49.802" v="595" actId="478"/>
          <ac:picMkLst>
            <pc:docMk/>
            <pc:sldMk cId="2236825674" sldId="264"/>
            <ac:picMk id="29" creationId="{CCD213E1-C6C2-2F71-AF41-F8865E3084F7}"/>
          </ac:picMkLst>
        </pc:picChg>
        <pc:picChg chg="add mod">
          <ac:chgData name="Ayesha Shafi" userId="75ef1296-0a29-4795-a39c-cc19b40d46a0" providerId="ADAL" clId="{37E9DFE0-8B56-A840-BDA9-B062D7628A2C}" dt="2025-06-27T20:24:33.145" v="872" actId="14100"/>
          <ac:picMkLst>
            <pc:docMk/>
            <pc:sldMk cId="2236825674" sldId="264"/>
            <ac:picMk id="30" creationId="{E25E21BC-88FE-ECE6-7936-590BFD97563C}"/>
          </ac:picMkLst>
        </pc:picChg>
        <pc:picChg chg="add mod">
          <ac:chgData name="Ayesha Shafi" userId="75ef1296-0a29-4795-a39c-cc19b40d46a0" providerId="ADAL" clId="{37E9DFE0-8B56-A840-BDA9-B062D7628A2C}" dt="2025-06-27T20:24:33.145" v="872" actId="14100"/>
          <ac:picMkLst>
            <pc:docMk/>
            <pc:sldMk cId="2236825674" sldId="264"/>
            <ac:picMk id="38" creationId="{B363F136-A101-69F2-37BB-F268D1AE826A}"/>
          </ac:picMkLst>
        </pc:picChg>
        <pc:picChg chg="mod">
          <ac:chgData name="Ayesha Shafi" userId="75ef1296-0a29-4795-a39c-cc19b40d46a0" providerId="ADAL" clId="{37E9DFE0-8B56-A840-BDA9-B062D7628A2C}" dt="2025-06-27T20:23:47.271" v="801" actId="1036"/>
          <ac:picMkLst>
            <pc:docMk/>
            <pc:sldMk cId="2236825674" sldId="264"/>
            <ac:picMk id="41" creationId="{00000000-0000-0000-0000-000000000000}"/>
          </ac:picMkLst>
        </pc:picChg>
        <pc:picChg chg="add mod">
          <ac:chgData name="Ayesha Shafi" userId="75ef1296-0a29-4795-a39c-cc19b40d46a0" providerId="ADAL" clId="{37E9DFE0-8B56-A840-BDA9-B062D7628A2C}" dt="2025-06-27T20:24:58.654" v="879" actId="14100"/>
          <ac:picMkLst>
            <pc:docMk/>
            <pc:sldMk cId="2236825674" sldId="264"/>
            <ac:picMk id="50" creationId="{4DDAAD91-7743-13EB-CE67-0168040D3747}"/>
          </ac:picMkLst>
        </pc:picChg>
        <pc:picChg chg="add mod">
          <ac:chgData name="Ayesha Shafi" userId="75ef1296-0a29-4795-a39c-cc19b40d46a0" providerId="ADAL" clId="{37E9DFE0-8B56-A840-BDA9-B062D7628A2C}" dt="2025-06-27T20:24:50.697" v="877" actId="1076"/>
          <ac:picMkLst>
            <pc:docMk/>
            <pc:sldMk cId="2236825674" sldId="264"/>
            <ac:picMk id="52" creationId="{21A86466-2C04-FA1B-C7FE-E00197B97177}"/>
          </ac:picMkLst>
        </pc:picChg>
        <pc:picChg chg="mod">
          <ac:chgData name="Ayesha Shafi" userId="75ef1296-0a29-4795-a39c-cc19b40d46a0" providerId="ADAL" clId="{37E9DFE0-8B56-A840-BDA9-B062D7628A2C}" dt="2025-06-27T20:23:47.271" v="801" actId="1036"/>
          <ac:picMkLst>
            <pc:docMk/>
            <pc:sldMk cId="2236825674" sldId="264"/>
            <ac:picMk id="53" creationId="{00000000-0000-0000-0000-000000000000}"/>
          </ac:picMkLst>
        </pc:picChg>
        <pc:picChg chg="add mod">
          <ac:chgData name="Ayesha Shafi" userId="75ef1296-0a29-4795-a39c-cc19b40d46a0" providerId="ADAL" clId="{37E9DFE0-8B56-A840-BDA9-B062D7628A2C}" dt="2025-06-27T20:27:20.216" v="947" actId="1076"/>
          <ac:picMkLst>
            <pc:docMk/>
            <pc:sldMk cId="2236825674" sldId="264"/>
            <ac:picMk id="66" creationId="{95B29F77-A3EF-FA44-4FA8-8E2984DD9718}"/>
          </ac:picMkLst>
        </pc:picChg>
        <pc:picChg chg="add mod">
          <ac:chgData name="Ayesha Shafi" userId="75ef1296-0a29-4795-a39c-cc19b40d46a0" providerId="ADAL" clId="{37E9DFE0-8B56-A840-BDA9-B062D7628A2C}" dt="2025-06-27T20:27:16.599" v="946" actId="1076"/>
          <ac:picMkLst>
            <pc:docMk/>
            <pc:sldMk cId="2236825674" sldId="264"/>
            <ac:picMk id="67" creationId="{209C35F7-9B3A-43FB-0D90-24FD1B6F35FB}"/>
          </ac:picMkLst>
        </pc:picChg>
      </pc:sldChg>
      <pc:sldChg chg="addSp delSp modSp mod">
        <pc:chgData name="Ayesha Shafi" userId="75ef1296-0a29-4795-a39c-cc19b40d46a0" providerId="ADAL" clId="{37E9DFE0-8B56-A840-BDA9-B062D7628A2C}" dt="2025-06-27T20:02:10.359" v="469" actId="1076"/>
        <pc:sldMkLst>
          <pc:docMk/>
          <pc:sldMk cId="2753215545" sldId="291"/>
        </pc:sldMkLst>
        <pc:spChg chg="add del mod">
          <ac:chgData name="Ayesha Shafi" userId="75ef1296-0a29-4795-a39c-cc19b40d46a0" providerId="ADAL" clId="{37E9DFE0-8B56-A840-BDA9-B062D7628A2C}" dt="2025-06-27T20:02:07.018" v="467" actId="21"/>
          <ac:spMkLst>
            <pc:docMk/>
            <pc:sldMk cId="2753215545" sldId="291"/>
            <ac:spMk id="2" creationId="{5EDFDF9C-E399-546B-E937-F54EB94A3C7A}"/>
          </ac:spMkLst>
        </pc:spChg>
        <pc:spChg chg="add mod">
          <ac:chgData name="Ayesha Shafi" userId="75ef1296-0a29-4795-a39c-cc19b40d46a0" providerId="ADAL" clId="{37E9DFE0-8B56-A840-BDA9-B062D7628A2C}" dt="2025-06-27T20:02:10.359" v="469" actId="1076"/>
          <ac:spMkLst>
            <pc:docMk/>
            <pc:sldMk cId="2753215545" sldId="291"/>
            <ac:spMk id="6" creationId="{FF1BBB8D-C038-CB0F-79B2-4A2211482D72}"/>
          </ac:spMkLst>
        </pc:spChg>
        <pc:spChg chg="mod">
          <ac:chgData name="Ayesha Shafi" userId="75ef1296-0a29-4795-a39c-cc19b40d46a0" providerId="ADAL" clId="{37E9DFE0-8B56-A840-BDA9-B062D7628A2C}" dt="2025-06-27T20:00:41.921" v="327" actId="1076"/>
          <ac:spMkLst>
            <pc:docMk/>
            <pc:sldMk cId="2753215545" sldId="291"/>
            <ac:spMk id="63" creationId="{3C91044F-AF0B-404A-96E0-572ADAAAC4DA}"/>
          </ac:spMkLst>
        </pc:spChg>
        <pc:spChg chg="mod">
          <ac:chgData name="Ayesha Shafi" userId="75ef1296-0a29-4795-a39c-cc19b40d46a0" providerId="ADAL" clId="{37E9DFE0-8B56-A840-BDA9-B062D7628A2C}" dt="2025-06-27T20:00:41.921" v="327" actId="1076"/>
          <ac:spMkLst>
            <pc:docMk/>
            <pc:sldMk cId="2753215545" sldId="291"/>
            <ac:spMk id="64" creationId="{30753471-E9B4-F347-A1B0-6D8990438574}"/>
          </ac:spMkLst>
        </pc:spChg>
        <pc:spChg chg="mod">
          <ac:chgData name="Ayesha Shafi" userId="75ef1296-0a29-4795-a39c-cc19b40d46a0" providerId="ADAL" clId="{37E9DFE0-8B56-A840-BDA9-B062D7628A2C}" dt="2025-06-27T20:00:41.921" v="327" actId="1076"/>
          <ac:spMkLst>
            <pc:docMk/>
            <pc:sldMk cId="2753215545" sldId="291"/>
            <ac:spMk id="65" creationId="{A1EA6ADC-070A-8D45-B119-8CD19F6A01C5}"/>
          </ac:spMkLst>
        </pc:spChg>
        <pc:spChg chg="mod">
          <ac:chgData name="Ayesha Shafi" userId="75ef1296-0a29-4795-a39c-cc19b40d46a0" providerId="ADAL" clId="{37E9DFE0-8B56-A840-BDA9-B062D7628A2C}" dt="2025-06-27T20:00:41.921" v="327" actId="1076"/>
          <ac:spMkLst>
            <pc:docMk/>
            <pc:sldMk cId="2753215545" sldId="291"/>
            <ac:spMk id="66" creationId="{DD464212-883B-6C4B-BC29-9D175B69DDEE}"/>
          </ac:spMkLst>
        </pc:spChg>
        <pc:spChg chg="mod">
          <ac:chgData name="Ayesha Shafi" userId="75ef1296-0a29-4795-a39c-cc19b40d46a0" providerId="ADAL" clId="{37E9DFE0-8B56-A840-BDA9-B062D7628A2C}" dt="2025-06-27T20:00:46.539" v="328" actId="1076"/>
          <ac:spMkLst>
            <pc:docMk/>
            <pc:sldMk cId="2753215545" sldId="291"/>
            <ac:spMk id="68" creationId="{B2615537-9C82-F14C-9654-40572B359FDC}"/>
          </ac:spMkLst>
        </pc:spChg>
        <pc:spChg chg="mod">
          <ac:chgData name="Ayesha Shafi" userId="75ef1296-0a29-4795-a39c-cc19b40d46a0" providerId="ADAL" clId="{37E9DFE0-8B56-A840-BDA9-B062D7628A2C}" dt="2025-06-27T20:00:46.539" v="328" actId="1076"/>
          <ac:spMkLst>
            <pc:docMk/>
            <pc:sldMk cId="2753215545" sldId="291"/>
            <ac:spMk id="74" creationId="{4014B660-1517-8A45-91E3-C4295DF93A38}"/>
          </ac:spMkLst>
        </pc:spChg>
        <pc:spChg chg="mod">
          <ac:chgData name="Ayesha Shafi" userId="75ef1296-0a29-4795-a39c-cc19b40d46a0" providerId="ADAL" clId="{37E9DFE0-8B56-A840-BDA9-B062D7628A2C}" dt="2025-06-27T20:00:46.539" v="328" actId="1076"/>
          <ac:spMkLst>
            <pc:docMk/>
            <pc:sldMk cId="2753215545" sldId="291"/>
            <ac:spMk id="79" creationId="{D7394F83-0B5D-2F43-B294-5E8CF5CE4E6E}"/>
          </ac:spMkLst>
        </pc:spChg>
        <pc:spChg chg="mod">
          <ac:chgData name="Ayesha Shafi" userId="75ef1296-0a29-4795-a39c-cc19b40d46a0" providerId="ADAL" clId="{37E9DFE0-8B56-A840-BDA9-B062D7628A2C}" dt="2025-06-27T20:00:46.539" v="328" actId="1076"/>
          <ac:spMkLst>
            <pc:docMk/>
            <pc:sldMk cId="2753215545" sldId="291"/>
            <ac:spMk id="80" creationId="{7FE15E11-FB8D-474A-97F3-49E331FFF0A2}"/>
          </ac:spMkLst>
        </pc:spChg>
        <pc:spChg chg="mod">
          <ac:chgData name="Ayesha Shafi" userId="75ef1296-0a29-4795-a39c-cc19b40d46a0" providerId="ADAL" clId="{37E9DFE0-8B56-A840-BDA9-B062D7628A2C}" dt="2025-06-27T20:01:40.571" v="461" actId="207"/>
          <ac:spMkLst>
            <pc:docMk/>
            <pc:sldMk cId="2753215545" sldId="291"/>
            <ac:spMk id="82" creationId="{E07F2A6C-3C4E-D841-81EA-90184A4C530B}"/>
          </ac:spMkLst>
        </pc:spChg>
        <pc:picChg chg="add mod">
          <ac:chgData name="Ayesha Shafi" userId="75ef1296-0a29-4795-a39c-cc19b40d46a0" providerId="ADAL" clId="{37E9DFE0-8B56-A840-BDA9-B062D7628A2C}" dt="2025-06-27T20:02:10.359" v="469" actId="1076"/>
          <ac:picMkLst>
            <pc:docMk/>
            <pc:sldMk cId="2753215545" sldId="291"/>
            <ac:picMk id="5" creationId="{59A211A0-F989-A48D-54BC-02887C29E9EF}"/>
          </ac:picMkLst>
        </pc:picChg>
        <pc:picChg chg="mod">
          <ac:chgData name="Ayesha Shafi" userId="75ef1296-0a29-4795-a39c-cc19b40d46a0" providerId="ADAL" clId="{37E9DFE0-8B56-A840-BDA9-B062D7628A2C}" dt="2025-06-27T20:00:41.921" v="327" actId="1076"/>
          <ac:picMkLst>
            <pc:docMk/>
            <pc:sldMk cId="2753215545" sldId="291"/>
            <ac:picMk id="61" creationId="{B4B3FB4B-6E36-3240-8335-F94C7F3F3D5C}"/>
          </ac:picMkLst>
        </pc:picChg>
        <pc:picChg chg="mod">
          <ac:chgData name="Ayesha Shafi" userId="75ef1296-0a29-4795-a39c-cc19b40d46a0" providerId="ADAL" clId="{37E9DFE0-8B56-A840-BDA9-B062D7628A2C}" dt="2025-06-27T20:00:46.539" v="328" actId="1076"/>
          <ac:picMkLst>
            <pc:docMk/>
            <pc:sldMk cId="2753215545" sldId="291"/>
            <ac:picMk id="67" creationId="{CAF2E142-1BB8-5049-BC01-EA7ACC9D722F}"/>
          </ac:picMkLst>
        </pc:picChg>
      </pc:sldChg>
      <pc:sldChg chg="modSp mod">
        <pc:chgData name="Ayesha Shafi" userId="75ef1296-0a29-4795-a39c-cc19b40d46a0" providerId="ADAL" clId="{37E9DFE0-8B56-A840-BDA9-B062D7628A2C}" dt="2025-06-27T19:59:49.043" v="322" actId="20577"/>
        <pc:sldMkLst>
          <pc:docMk/>
          <pc:sldMk cId="1713723769" sldId="293"/>
        </pc:sldMkLst>
        <pc:spChg chg="mod">
          <ac:chgData name="Ayesha Shafi" userId="75ef1296-0a29-4795-a39c-cc19b40d46a0" providerId="ADAL" clId="{37E9DFE0-8B56-A840-BDA9-B062D7628A2C}" dt="2025-06-27T19:59:49.043" v="322" actId="20577"/>
          <ac:spMkLst>
            <pc:docMk/>
            <pc:sldMk cId="1713723769" sldId="293"/>
            <ac:spMk id="26" creationId="{BEC673EC-599E-A45E-E755-BED3D8663333}"/>
          </ac:spMkLst>
        </pc:spChg>
      </pc:sldChg>
      <pc:sldChg chg="modSp mod">
        <pc:chgData name="Ayesha Shafi" userId="75ef1296-0a29-4795-a39c-cc19b40d46a0" providerId="ADAL" clId="{37E9DFE0-8B56-A840-BDA9-B062D7628A2C}" dt="2025-06-27T19:59:59.846" v="325" actId="207"/>
        <pc:sldMkLst>
          <pc:docMk/>
          <pc:sldMk cId="2412576379" sldId="309"/>
        </pc:sldMkLst>
        <pc:spChg chg="mod">
          <ac:chgData name="Ayesha Shafi" userId="75ef1296-0a29-4795-a39c-cc19b40d46a0" providerId="ADAL" clId="{37E9DFE0-8B56-A840-BDA9-B062D7628A2C}" dt="2025-06-27T19:59:59.846" v="325" actId="207"/>
          <ac:spMkLst>
            <pc:docMk/>
            <pc:sldMk cId="2412576379" sldId="309"/>
            <ac:spMk id="2" creationId="{ABB205FB-416C-B9A7-A488-813AFC376279}"/>
          </ac:spMkLst>
        </pc:spChg>
      </pc:sldChg>
      <pc:sldChg chg="addSp delSp modSp add mod">
        <pc:chgData name="Ayesha Shafi" userId="75ef1296-0a29-4795-a39c-cc19b40d46a0" providerId="ADAL" clId="{37E9DFE0-8B56-A840-BDA9-B062D7628A2C}" dt="2025-06-27T20:06:23.272" v="593" actId="403"/>
        <pc:sldMkLst>
          <pc:docMk/>
          <pc:sldMk cId="3163178404" sldId="310"/>
        </pc:sldMkLst>
        <pc:spChg chg="add del mod">
          <ac:chgData name="Ayesha Shafi" userId="75ef1296-0a29-4795-a39c-cc19b40d46a0" providerId="ADAL" clId="{37E9DFE0-8B56-A840-BDA9-B062D7628A2C}" dt="2025-06-27T20:05:58.701" v="584" actId="478"/>
          <ac:spMkLst>
            <pc:docMk/>
            <pc:sldMk cId="3163178404" sldId="310"/>
            <ac:spMk id="4" creationId="{E7EF90F7-FBAD-6F6D-A1A1-970D4BB29C7E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6" creationId="{FF1BBB8D-C038-CB0F-79B2-4A2211482D72}"/>
          </ac:spMkLst>
        </pc:spChg>
        <pc:spChg chg="add del mod">
          <ac:chgData name="Ayesha Shafi" userId="75ef1296-0a29-4795-a39c-cc19b40d46a0" providerId="ADAL" clId="{37E9DFE0-8B56-A840-BDA9-B062D7628A2C}" dt="2025-06-27T20:05:59.492" v="585" actId="478"/>
          <ac:spMkLst>
            <pc:docMk/>
            <pc:sldMk cId="3163178404" sldId="310"/>
            <ac:spMk id="8" creationId="{F4583BA4-6AB0-AC47-79CA-B4B72C1BF756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4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5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8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20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36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59" creationId="{877BC943-8A7D-6F49-A42B-F2C7D9910FB3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63" creationId="{3C91044F-AF0B-404A-96E0-572ADAAAC4DA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64" creationId="{30753471-E9B4-F347-A1B0-6D8990438574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65" creationId="{A1EA6ADC-070A-8D45-B119-8CD19F6A01C5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66" creationId="{DD464212-883B-6C4B-BC29-9D175B69DDEE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68" creationId="{B2615537-9C82-F14C-9654-40572B359FDC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74" creationId="{4014B660-1517-8A45-91E3-C4295DF93A38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79" creationId="{D7394F83-0B5D-2F43-B294-5E8CF5CE4E6E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80" creationId="{7FE15E11-FB8D-474A-97F3-49E331FFF0A2}"/>
          </ac:spMkLst>
        </pc:spChg>
        <pc:spChg chg="mod">
          <ac:chgData name="Ayesha Shafi" userId="75ef1296-0a29-4795-a39c-cc19b40d46a0" providerId="ADAL" clId="{37E9DFE0-8B56-A840-BDA9-B062D7628A2C}" dt="2025-06-27T20:06:23.272" v="593" actId="403"/>
          <ac:spMkLst>
            <pc:docMk/>
            <pc:sldMk cId="3163178404" sldId="310"/>
            <ac:spMk id="82" creationId="{E07F2A6C-3C4E-D841-81EA-90184A4C530B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91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93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95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97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00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01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02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32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05:55.792" v="583" actId="478"/>
          <ac:spMkLst>
            <pc:docMk/>
            <pc:sldMk cId="3163178404" sldId="310"/>
            <ac:spMk id="146" creationId="{00000000-0000-0000-0000-000000000000}"/>
          </ac:spMkLst>
        </pc:spChg>
        <pc:grpChg chg="del">
          <ac:chgData name="Ayesha Shafi" userId="75ef1296-0a29-4795-a39c-cc19b40d46a0" providerId="ADAL" clId="{37E9DFE0-8B56-A840-BDA9-B062D7628A2C}" dt="2025-06-27T20:05:55.792" v="583" actId="478"/>
          <ac:grpSpMkLst>
            <pc:docMk/>
            <pc:sldMk cId="3163178404" sldId="310"/>
            <ac:grpSpMk id="3" creationId="{00000000-0000-0000-0000-000000000000}"/>
          </ac:grpSpMkLst>
        </pc:grpChg>
        <pc:grpChg chg="del">
          <ac:chgData name="Ayesha Shafi" userId="75ef1296-0a29-4795-a39c-cc19b40d46a0" providerId="ADAL" clId="{37E9DFE0-8B56-A840-BDA9-B062D7628A2C}" dt="2025-06-27T20:05:55.792" v="583" actId="478"/>
          <ac:grpSpMkLst>
            <pc:docMk/>
            <pc:sldMk cId="3163178404" sldId="310"/>
            <ac:grpSpMk id="10" creationId="{00000000-0000-0000-0000-000000000000}"/>
          </ac:grpSpMkLst>
        </pc:grpChg>
        <pc:grpChg chg="del">
          <ac:chgData name="Ayesha Shafi" userId="75ef1296-0a29-4795-a39c-cc19b40d46a0" providerId="ADAL" clId="{37E9DFE0-8B56-A840-BDA9-B062D7628A2C}" dt="2025-06-27T20:05:55.792" v="583" actId="478"/>
          <ac:grpSpMkLst>
            <pc:docMk/>
            <pc:sldMk cId="3163178404" sldId="310"/>
            <ac:grpSpMk id="12" creationId="{00000000-0000-0000-0000-000000000000}"/>
          </ac:grpSpMkLst>
        </pc:grpChg>
        <pc:grpChg chg="del">
          <ac:chgData name="Ayesha Shafi" userId="75ef1296-0a29-4795-a39c-cc19b40d46a0" providerId="ADAL" clId="{37E9DFE0-8B56-A840-BDA9-B062D7628A2C}" dt="2025-06-27T20:05:55.792" v="583" actId="478"/>
          <ac:grpSpMkLst>
            <pc:docMk/>
            <pc:sldMk cId="3163178404" sldId="310"/>
            <ac:grpSpMk id="21" creationId="{00000000-0000-0000-0000-000000000000}"/>
          </ac:grpSpMkLst>
        </pc:grpChg>
        <pc:grpChg chg="del">
          <ac:chgData name="Ayesha Shafi" userId="75ef1296-0a29-4795-a39c-cc19b40d46a0" providerId="ADAL" clId="{37E9DFE0-8B56-A840-BDA9-B062D7628A2C}" dt="2025-06-27T20:05:55.792" v="583" actId="478"/>
          <ac:grpSpMkLst>
            <pc:docMk/>
            <pc:sldMk cId="3163178404" sldId="310"/>
            <ac:grpSpMk id="53" creationId="{00000000-0000-0000-0000-000000000000}"/>
          </ac:grpSpMkLst>
        </pc:grpChg>
        <pc:picChg chg="del">
          <ac:chgData name="Ayesha Shafi" userId="75ef1296-0a29-4795-a39c-cc19b40d46a0" providerId="ADAL" clId="{37E9DFE0-8B56-A840-BDA9-B062D7628A2C}" dt="2025-06-27T20:05:55.792" v="583" actId="478"/>
          <ac:picMkLst>
            <pc:docMk/>
            <pc:sldMk cId="3163178404" sldId="310"/>
            <ac:picMk id="5" creationId="{59A211A0-F989-A48D-54BC-02887C29E9EF}"/>
          </ac:picMkLst>
        </pc:picChg>
        <pc:picChg chg="add mod">
          <ac:chgData name="Ayesha Shafi" userId="75ef1296-0a29-4795-a39c-cc19b40d46a0" providerId="ADAL" clId="{37E9DFE0-8B56-A840-BDA9-B062D7628A2C}" dt="2025-06-27T20:06:17.418" v="591" actId="1076"/>
          <ac:picMkLst>
            <pc:docMk/>
            <pc:sldMk cId="3163178404" sldId="310"/>
            <ac:picMk id="9" creationId="{54516072-C1DB-378D-59AE-905B47A57FC2}"/>
          </ac:picMkLst>
        </pc:picChg>
        <pc:picChg chg="del">
          <ac:chgData name="Ayesha Shafi" userId="75ef1296-0a29-4795-a39c-cc19b40d46a0" providerId="ADAL" clId="{37E9DFE0-8B56-A840-BDA9-B062D7628A2C}" dt="2025-06-27T20:05:55.792" v="583" actId="478"/>
          <ac:picMkLst>
            <pc:docMk/>
            <pc:sldMk cId="3163178404" sldId="310"/>
            <ac:picMk id="13" creationId="{00000000-0000-0000-0000-000000000000}"/>
          </ac:picMkLst>
        </pc:picChg>
        <pc:picChg chg="del">
          <ac:chgData name="Ayesha Shafi" userId="75ef1296-0a29-4795-a39c-cc19b40d46a0" providerId="ADAL" clId="{37E9DFE0-8B56-A840-BDA9-B062D7628A2C}" dt="2025-06-27T20:05:55.792" v="583" actId="478"/>
          <ac:picMkLst>
            <pc:docMk/>
            <pc:sldMk cId="3163178404" sldId="310"/>
            <ac:picMk id="17" creationId="{00000000-0000-0000-0000-000000000000}"/>
          </ac:picMkLst>
        </pc:picChg>
        <pc:picChg chg="del">
          <ac:chgData name="Ayesha Shafi" userId="75ef1296-0a29-4795-a39c-cc19b40d46a0" providerId="ADAL" clId="{37E9DFE0-8B56-A840-BDA9-B062D7628A2C}" dt="2025-06-27T20:05:55.792" v="583" actId="478"/>
          <ac:picMkLst>
            <pc:docMk/>
            <pc:sldMk cId="3163178404" sldId="310"/>
            <ac:picMk id="61" creationId="{B4B3FB4B-6E36-3240-8335-F94C7F3F3D5C}"/>
          </ac:picMkLst>
        </pc:picChg>
        <pc:picChg chg="del">
          <ac:chgData name="Ayesha Shafi" userId="75ef1296-0a29-4795-a39c-cc19b40d46a0" providerId="ADAL" clId="{37E9DFE0-8B56-A840-BDA9-B062D7628A2C}" dt="2025-06-27T20:05:55.792" v="583" actId="478"/>
          <ac:picMkLst>
            <pc:docMk/>
            <pc:sldMk cId="3163178404" sldId="310"/>
            <ac:picMk id="67" creationId="{CAF2E142-1BB8-5049-BC01-EA7ACC9D722F}"/>
          </ac:picMkLst>
        </pc:picChg>
      </pc:sldChg>
      <pc:sldChg chg="add del">
        <pc:chgData name="Ayesha Shafi" userId="75ef1296-0a29-4795-a39c-cc19b40d46a0" providerId="ADAL" clId="{37E9DFE0-8B56-A840-BDA9-B062D7628A2C}" dt="2025-06-27T20:15:29.259" v="733"/>
        <pc:sldMkLst>
          <pc:docMk/>
          <pc:sldMk cId="3815356660" sldId="311"/>
        </pc:sldMkLst>
      </pc:sldChg>
      <pc:sldChg chg="delSp modSp add mod">
        <pc:chgData name="Ayesha Shafi" userId="75ef1296-0a29-4795-a39c-cc19b40d46a0" providerId="ADAL" clId="{37E9DFE0-8B56-A840-BDA9-B062D7628A2C}" dt="2025-06-27T20:15:54.298" v="757" actId="1076"/>
        <pc:sldMkLst>
          <pc:docMk/>
          <pc:sldMk cId="4103562211" sldId="311"/>
        </pc:sldMkLst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12" creationId="{AA54527A-52C5-BBF3-7D48-A87FD27AD812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13" creationId="{E81D3355-49CC-6F7C-BC4C-3363EC0973B8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15" creationId="{5EB790EB-3115-B1EA-2903-F1390F3BF454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20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23" creationId="{99F3484C-0266-18EA-E929-7A3EF97E18E4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24" creationId="{BE9BCFD1-9EE6-9B35-B83C-A2CF6191C00D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25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26" creationId="{7A0F1CBD-821E-C70B-5018-2A18133D17D8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28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33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39" creationId="{B836B065-FE5F-B397-629F-C1F63BAA4262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40" creationId="{AA638429-8EF1-EC50-7C68-8B94898FA707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42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43" creationId="{44982313-B1A4-0F8B-FDAD-99C2C09B0B6C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51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57" creationId="{00000000-0000-0000-0000-000000000000}"/>
          </ac:spMkLst>
        </pc:spChg>
        <pc:spChg chg="mod">
          <ac:chgData name="Ayesha Shafi" userId="75ef1296-0a29-4795-a39c-cc19b40d46a0" providerId="ADAL" clId="{37E9DFE0-8B56-A840-BDA9-B062D7628A2C}" dt="2025-06-27T20:15:54.298" v="757" actId="1076"/>
          <ac:spMkLst>
            <pc:docMk/>
            <pc:sldMk cId="4103562211" sldId="311"/>
            <ac:spMk id="60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62" creationId="{00000000-0000-0000-0000-000000000000}"/>
          </ac:spMkLst>
        </pc:spChg>
        <pc:spChg chg="del">
          <ac:chgData name="Ayesha Shafi" userId="75ef1296-0a29-4795-a39c-cc19b40d46a0" providerId="ADAL" clId="{37E9DFE0-8B56-A840-BDA9-B062D7628A2C}" dt="2025-06-27T20:15:50.028" v="756" actId="478"/>
          <ac:spMkLst>
            <pc:docMk/>
            <pc:sldMk cId="4103562211" sldId="311"/>
            <ac:spMk id="63" creationId="{00000000-0000-0000-0000-000000000000}"/>
          </ac:spMkLst>
        </pc:spChg>
        <pc:grpChg chg="del">
          <ac:chgData name="Ayesha Shafi" userId="75ef1296-0a29-4795-a39c-cc19b40d46a0" providerId="ADAL" clId="{37E9DFE0-8B56-A840-BDA9-B062D7628A2C}" dt="2025-06-27T20:15:50.028" v="756" actId="478"/>
          <ac:grpSpMkLst>
            <pc:docMk/>
            <pc:sldMk cId="4103562211" sldId="311"/>
            <ac:grpSpMk id="31" creationId="{00000000-0000-0000-0000-000000000000}"/>
          </ac:grpSpMkLst>
        </pc:grpChg>
        <pc:grpChg chg="del">
          <ac:chgData name="Ayesha Shafi" userId="75ef1296-0a29-4795-a39c-cc19b40d46a0" providerId="ADAL" clId="{37E9DFE0-8B56-A840-BDA9-B062D7628A2C}" dt="2025-06-27T20:15:50.028" v="756" actId="478"/>
          <ac:grpSpMkLst>
            <pc:docMk/>
            <pc:sldMk cId="4103562211" sldId="311"/>
            <ac:grpSpMk id="32" creationId="{00000000-0000-0000-0000-000000000000}"/>
          </ac:grpSpMkLst>
        </pc:grpChg>
        <pc:grpChg chg="del">
          <ac:chgData name="Ayesha Shafi" userId="75ef1296-0a29-4795-a39c-cc19b40d46a0" providerId="ADAL" clId="{37E9DFE0-8B56-A840-BDA9-B062D7628A2C}" dt="2025-06-27T20:15:50.028" v="756" actId="478"/>
          <ac:grpSpMkLst>
            <pc:docMk/>
            <pc:sldMk cId="4103562211" sldId="311"/>
            <ac:grpSpMk id="56" creationId="{00000000-0000-0000-0000-000000000000}"/>
          </ac:grpSpMkLst>
        </pc:grp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2" creationId="{00000000-0000-0000-0000-000000000000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4" creationId="{00000000-0000-0000-0000-000000000000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10" creationId="{3146C480-B6C4-18B1-CE39-DC5FEA78E4BB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11" creationId="{4E8E1AF0-BE8B-7741-EFA6-DFF2DAD10B9B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21" creationId="{B814F992-5B4B-5069-06C7-FF5A968BDF00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22" creationId="{F1AB533E-8BE3-AFE1-D2FD-74BFD9E925C9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30" creationId="{E25E21BC-88FE-ECE6-7936-590BFD97563C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38" creationId="{B363F136-A101-69F2-37BB-F268D1AE826A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41" creationId="{00000000-0000-0000-0000-000000000000}"/>
          </ac:picMkLst>
        </pc:picChg>
        <pc:picChg chg="del">
          <ac:chgData name="Ayesha Shafi" userId="75ef1296-0a29-4795-a39c-cc19b40d46a0" providerId="ADAL" clId="{37E9DFE0-8B56-A840-BDA9-B062D7628A2C}" dt="2025-06-27T20:15:50.028" v="756" actId="478"/>
          <ac:picMkLst>
            <pc:docMk/>
            <pc:sldMk cId="4103562211" sldId="311"/>
            <ac:picMk id="53" creationId="{00000000-0000-0000-0000-000000000000}"/>
          </ac:picMkLst>
        </pc:picChg>
      </pc:sldChg>
    </pc:docChg>
  </pc:docChgLst>
  <pc:docChgLst>
    <pc:chgData name="Ayesha Shafi" userId="75ef1296-0a29-4795-a39c-cc19b40d46a0" providerId="ADAL" clId="{6994838D-EB00-1245-9E22-229B6DE9868B}"/>
    <pc:docChg chg="undo custSel modSld">
      <pc:chgData name="Ayesha Shafi" userId="75ef1296-0a29-4795-a39c-cc19b40d46a0" providerId="ADAL" clId="{6994838D-EB00-1245-9E22-229B6DE9868B}" dt="2025-10-17T13:48:26.223" v="347" actId="20577"/>
      <pc:docMkLst>
        <pc:docMk/>
      </pc:docMkLst>
      <pc:sldChg chg="addSp delSp modSp mod">
        <pc:chgData name="Ayesha Shafi" userId="75ef1296-0a29-4795-a39c-cc19b40d46a0" providerId="ADAL" clId="{6994838D-EB00-1245-9E22-229B6DE9868B}" dt="2025-10-17T13:47:51.394" v="303" actId="1036"/>
        <pc:sldMkLst>
          <pc:docMk/>
          <pc:sldMk cId="2236825674" sldId="264"/>
        </pc:sldMkLst>
        <pc:spChg chg="add mod">
          <ac:chgData name="Ayesha Shafi" userId="75ef1296-0a29-4795-a39c-cc19b40d46a0" providerId="ADAL" clId="{6994838D-EB00-1245-9E22-229B6DE9868B}" dt="2025-10-17T13:45:31.219" v="229" actId="554"/>
          <ac:spMkLst>
            <pc:docMk/>
            <pc:sldMk cId="2236825674" sldId="264"/>
            <ac:spMk id="5" creationId="{29F1CE3A-9D95-6D68-F8A5-1401F60A7F63}"/>
          </ac:spMkLst>
        </pc:spChg>
        <pc:spChg chg="add mod">
          <ac:chgData name="Ayesha Shafi" userId="75ef1296-0a29-4795-a39c-cc19b40d46a0" providerId="ADAL" clId="{6994838D-EB00-1245-9E22-229B6DE9868B}" dt="2025-10-17T13:45:31.219" v="229" actId="554"/>
          <ac:spMkLst>
            <pc:docMk/>
            <pc:sldMk cId="2236825674" sldId="264"/>
            <ac:spMk id="8" creationId="{53798BE3-5192-F9C9-1537-15521A35C065}"/>
          </ac:spMkLst>
        </pc:spChg>
        <pc:spChg chg="add mod">
          <ac:chgData name="Ayesha Shafi" userId="75ef1296-0a29-4795-a39c-cc19b40d46a0" providerId="ADAL" clId="{6994838D-EB00-1245-9E22-229B6DE9868B}" dt="2025-10-17T13:45:31.219" v="229" actId="554"/>
          <ac:spMkLst>
            <pc:docMk/>
            <pc:sldMk cId="2236825674" sldId="264"/>
            <ac:spMk id="9" creationId="{945C55B5-18BD-8450-73E0-8B06B58AEE80}"/>
          </ac:spMkLst>
        </pc:spChg>
        <pc:spChg chg="mod">
          <ac:chgData name="Ayesha Shafi" userId="75ef1296-0a29-4795-a39c-cc19b40d46a0" providerId="ADAL" clId="{6994838D-EB00-1245-9E22-229B6DE9868B}" dt="2025-10-17T13:44:28.962" v="185" actId="164"/>
          <ac:spMkLst>
            <pc:docMk/>
            <pc:sldMk cId="2236825674" sldId="264"/>
            <ac:spMk id="20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44:28.962" v="185" actId="164"/>
          <ac:spMkLst>
            <pc:docMk/>
            <pc:sldMk cId="2236825674" sldId="264"/>
            <ac:spMk id="25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09:10.173" v="18" actId="164"/>
          <ac:spMkLst>
            <pc:docMk/>
            <pc:sldMk cId="2236825674" sldId="264"/>
            <ac:spMk id="28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44:28.962" v="185" actId="164"/>
          <ac:spMkLst>
            <pc:docMk/>
            <pc:sldMk cId="2236825674" sldId="264"/>
            <ac:spMk id="33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09:10.173" v="18" actId="164"/>
          <ac:spMkLst>
            <pc:docMk/>
            <pc:sldMk cId="2236825674" sldId="264"/>
            <ac:spMk id="42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45:24.981" v="228" actId="552"/>
          <ac:spMkLst>
            <pc:docMk/>
            <pc:sldMk cId="2236825674" sldId="264"/>
            <ac:spMk id="45" creationId="{A5F0FF25-1ABF-809E-5B79-F2B255A809C2}"/>
          </ac:spMkLst>
        </pc:spChg>
        <pc:spChg chg="mod">
          <ac:chgData name="Ayesha Shafi" userId="75ef1296-0a29-4795-a39c-cc19b40d46a0" providerId="ADAL" clId="{6994838D-EB00-1245-9E22-229B6DE9868B}" dt="2025-10-17T13:45:39.374" v="230" actId="554"/>
          <ac:spMkLst>
            <pc:docMk/>
            <pc:sldMk cId="2236825674" sldId="264"/>
            <ac:spMk id="46" creationId="{F6EB3F6F-2773-3159-CFD1-2FBB1C828E1F}"/>
          </ac:spMkLst>
        </pc:spChg>
        <pc:spChg chg="mod">
          <ac:chgData name="Ayesha Shafi" userId="75ef1296-0a29-4795-a39c-cc19b40d46a0" providerId="ADAL" clId="{6994838D-EB00-1245-9E22-229B6DE9868B}" dt="2025-10-17T13:09:10.173" v="18" actId="164"/>
          <ac:spMkLst>
            <pc:docMk/>
            <pc:sldMk cId="2236825674" sldId="264"/>
            <ac:spMk id="51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09:10.173" v="18" actId="164"/>
          <ac:spMkLst>
            <pc:docMk/>
            <pc:sldMk cId="2236825674" sldId="264"/>
            <ac:spMk id="57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45:24.981" v="228" actId="552"/>
          <ac:spMkLst>
            <pc:docMk/>
            <pc:sldMk cId="2236825674" sldId="264"/>
            <ac:spMk id="61" creationId="{7701D7EF-9B6B-8FF4-D02E-EF52617301E1}"/>
          </ac:spMkLst>
        </pc:spChg>
        <pc:spChg chg="del mod">
          <ac:chgData name="Ayesha Shafi" userId="75ef1296-0a29-4795-a39c-cc19b40d46a0" providerId="ADAL" clId="{6994838D-EB00-1245-9E22-229B6DE9868B}" dt="2025-10-17T13:44:31.974" v="186" actId="21"/>
          <ac:spMkLst>
            <pc:docMk/>
            <pc:sldMk cId="2236825674" sldId="264"/>
            <ac:spMk id="62" creationId="{00000000-0000-0000-0000-000000000000}"/>
          </ac:spMkLst>
        </pc:spChg>
        <pc:spChg chg="del mod">
          <ac:chgData name="Ayesha Shafi" userId="75ef1296-0a29-4795-a39c-cc19b40d46a0" providerId="ADAL" clId="{6994838D-EB00-1245-9E22-229B6DE9868B}" dt="2025-10-17T13:44:36.114" v="188" actId="21"/>
          <ac:spMkLst>
            <pc:docMk/>
            <pc:sldMk cId="2236825674" sldId="264"/>
            <ac:spMk id="63" creationId="{00000000-0000-0000-0000-000000000000}"/>
          </ac:spMkLst>
        </pc:spChg>
        <pc:spChg chg="mod">
          <ac:chgData name="Ayesha Shafi" userId="75ef1296-0a29-4795-a39c-cc19b40d46a0" providerId="ADAL" clId="{6994838D-EB00-1245-9E22-229B6DE9868B}" dt="2025-10-17T13:45:24.981" v="228" actId="552"/>
          <ac:spMkLst>
            <pc:docMk/>
            <pc:sldMk cId="2236825674" sldId="264"/>
            <ac:spMk id="64" creationId="{9EB15094-7E15-B1CA-36DC-E261A237F44B}"/>
          </ac:spMkLst>
        </pc:spChg>
        <pc:spChg chg="mod">
          <ac:chgData name="Ayesha Shafi" userId="75ef1296-0a29-4795-a39c-cc19b40d46a0" providerId="ADAL" clId="{6994838D-EB00-1245-9E22-229B6DE9868B}" dt="2025-10-17T13:45:39.374" v="230" actId="554"/>
          <ac:spMkLst>
            <pc:docMk/>
            <pc:sldMk cId="2236825674" sldId="264"/>
            <ac:spMk id="65" creationId="{277D677B-A15C-C572-0AAD-664E5CD52FC6}"/>
          </ac:spMkLst>
        </pc:spChg>
        <pc:grpChg chg="add mod">
          <ac:chgData name="Ayesha Shafi" userId="75ef1296-0a29-4795-a39c-cc19b40d46a0" providerId="ADAL" clId="{6994838D-EB00-1245-9E22-229B6DE9868B}" dt="2025-10-17T13:44:55.190" v="207" actId="14100"/>
          <ac:grpSpMkLst>
            <pc:docMk/>
            <pc:sldMk cId="2236825674" sldId="264"/>
            <ac:grpSpMk id="3" creationId="{E0839070-2442-5E41-672D-9E3A85567A9F}"/>
          </ac:grpSpMkLst>
        </pc:grpChg>
        <pc:grpChg chg="add mod">
          <ac:chgData name="Ayesha Shafi" userId="75ef1296-0a29-4795-a39c-cc19b40d46a0" providerId="ADAL" clId="{6994838D-EB00-1245-9E22-229B6DE9868B}" dt="2025-10-17T13:44:41.300" v="190" actId="14100"/>
          <ac:grpSpMkLst>
            <pc:docMk/>
            <pc:sldMk cId="2236825674" sldId="264"/>
            <ac:grpSpMk id="7" creationId="{E187FD5A-2791-0E0B-05F3-961E3AF8732E}"/>
          </ac:grpSpMkLst>
        </pc:grpChg>
        <pc:grpChg chg="mod">
          <ac:chgData name="Ayesha Shafi" userId="75ef1296-0a29-4795-a39c-cc19b40d46a0" providerId="ADAL" clId="{6994838D-EB00-1245-9E22-229B6DE9868B}" dt="2025-10-17T13:44:28.962" v="185" actId="164"/>
          <ac:grpSpMkLst>
            <pc:docMk/>
            <pc:sldMk cId="2236825674" sldId="264"/>
            <ac:grpSpMk id="31" creationId="{00000000-0000-0000-0000-000000000000}"/>
          </ac:grpSpMkLst>
        </pc:grpChg>
        <pc:grpChg chg="mod">
          <ac:chgData name="Ayesha Shafi" userId="75ef1296-0a29-4795-a39c-cc19b40d46a0" providerId="ADAL" clId="{6994838D-EB00-1245-9E22-229B6DE9868B}" dt="2025-10-17T13:44:28.962" v="185" actId="164"/>
          <ac:grpSpMkLst>
            <pc:docMk/>
            <pc:sldMk cId="2236825674" sldId="264"/>
            <ac:grpSpMk id="32" creationId="{00000000-0000-0000-0000-000000000000}"/>
          </ac:grpSpMkLst>
        </pc:grpChg>
        <pc:grpChg chg="mod">
          <ac:chgData name="Ayesha Shafi" userId="75ef1296-0a29-4795-a39c-cc19b40d46a0" providerId="ADAL" clId="{6994838D-EB00-1245-9E22-229B6DE9868B}" dt="2025-10-17T13:09:10.173" v="18" actId="164"/>
          <ac:grpSpMkLst>
            <pc:docMk/>
            <pc:sldMk cId="2236825674" sldId="264"/>
            <ac:grpSpMk id="56" creationId="{00000000-0000-0000-0000-000000000000}"/>
          </ac:grpSpMkLst>
        </pc:grpChg>
        <pc:picChg chg="mod">
          <ac:chgData name="Ayesha Shafi" userId="75ef1296-0a29-4795-a39c-cc19b40d46a0" providerId="ADAL" clId="{6994838D-EB00-1245-9E22-229B6DE9868B}" dt="2025-10-17T13:09:10.173" v="18" actId="164"/>
          <ac:picMkLst>
            <pc:docMk/>
            <pc:sldMk cId="2236825674" sldId="264"/>
            <ac:picMk id="2" creationId="{00000000-0000-0000-0000-000000000000}"/>
          </ac:picMkLst>
        </pc:picChg>
        <pc:picChg chg="mod">
          <ac:chgData name="Ayesha Shafi" userId="75ef1296-0a29-4795-a39c-cc19b40d46a0" providerId="ADAL" clId="{6994838D-EB00-1245-9E22-229B6DE9868B}" dt="2025-10-17T13:44:28.962" v="185" actId="164"/>
          <ac:picMkLst>
            <pc:docMk/>
            <pc:sldMk cId="2236825674" sldId="264"/>
            <ac:picMk id="4" creationId="{00000000-0000-0000-0000-000000000000}"/>
          </ac:picMkLst>
        </pc:picChg>
        <pc:picChg chg="add mod">
          <ac:chgData name="Ayesha Shafi" userId="75ef1296-0a29-4795-a39c-cc19b40d46a0" providerId="ADAL" clId="{6994838D-EB00-1245-9E22-229B6DE9868B}" dt="2025-10-17T13:47:51.394" v="303" actId="1036"/>
          <ac:picMkLst>
            <pc:docMk/>
            <pc:sldMk cId="2236825674" sldId="264"/>
            <ac:picMk id="6" creationId="{2D7F1324-A0A7-3257-8383-CE872C9C607F}"/>
          </ac:picMkLst>
        </pc:picChg>
        <pc:picChg chg="add mod">
          <ac:chgData name="Ayesha Shafi" userId="75ef1296-0a29-4795-a39c-cc19b40d46a0" providerId="ADAL" clId="{6994838D-EB00-1245-9E22-229B6DE9868B}" dt="2025-10-17T13:46:36.084" v="282" actId="14100"/>
          <ac:picMkLst>
            <pc:docMk/>
            <pc:sldMk cId="2236825674" sldId="264"/>
            <ac:picMk id="12" creationId="{5AE4BF83-35D5-7512-8EAC-8E7EB6F42306}"/>
          </ac:picMkLst>
        </pc:picChg>
        <pc:picChg chg="add mod">
          <ac:chgData name="Ayesha Shafi" userId="75ef1296-0a29-4795-a39c-cc19b40d46a0" providerId="ADAL" clId="{6994838D-EB00-1245-9E22-229B6DE9868B}" dt="2025-10-17T13:47:38.419" v="298" actId="1076"/>
          <ac:picMkLst>
            <pc:docMk/>
            <pc:sldMk cId="2236825674" sldId="264"/>
            <ac:picMk id="14" creationId="{8AE09996-F377-845D-CD75-667A2BD34266}"/>
          </ac:picMkLst>
        </pc:picChg>
        <pc:picChg chg="mod">
          <ac:chgData name="Ayesha Shafi" userId="75ef1296-0a29-4795-a39c-cc19b40d46a0" providerId="ADAL" clId="{6994838D-EB00-1245-9E22-229B6DE9868B}" dt="2025-10-17T13:09:10.173" v="18" actId="164"/>
          <ac:picMkLst>
            <pc:docMk/>
            <pc:sldMk cId="2236825674" sldId="264"/>
            <ac:picMk id="41" creationId="{00000000-0000-0000-0000-000000000000}"/>
          </ac:picMkLst>
        </pc:picChg>
        <pc:picChg chg="mod">
          <ac:chgData name="Ayesha Shafi" userId="75ef1296-0a29-4795-a39c-cc19b40d46a0" providerId="ADAL" clId="{6994838D-EB00-1245-9E22-229B6DE9868B}" dt="2025-10-17T13:09:10.173" v="18" actId="164"/>
          <ac:picMkLst>
            <pc:docMk/>
            <pc:sldMk cId="2236825674" sldId="264"/>
            <ac:picMk id="53" creationId="{00000000-0000-0000-0000-000000000000}"/>
          </ac:picMkLst>
        </pc:picChg>
      </pc:sldChg>
      <pc:sldChg chg="modSp mod">
        <pc:chgData name="Ayesha Shafi" userId="75ef1296-0a29-4795-a39c-cc19b40d46a0" providerId="ADAL" clId="{6994838D-EB00-1245-9E22-229B6DE9868B}" dt="2025-10-17T13:48:26.223" v="347" actId="20577"/>
        <pc:sldMkLst>
          <pc:docMk/>
          <pc:sldMk cId="4103562211" sldId="311"/>
        </pc:sldMkLst>
        <pc:spChg chg="mod">
          <ac:chgData name="Ayesha Shafi" userId="75ef1296-0a29-4795-a39c-cc19b40d46a0" providerId="ADAL" clId="{6994838D-EB00-1245-9E22-229B6DE9868B}" dt="2025-10-17T13:48:26.223" v="347" actId="20577"/>
          <ac:spMkLst>
            <pc:docMk/>
            <pc:sldMk cId="4103562211" sldId="311"/>
            <ac:spMk id="60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8F8050-E6EF-1C4B-9AE4-944569D04A0E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612A13-36FB-8C44-8A9F-05BEB0306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1600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177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884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19970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icture Placeholder 2"/>
          <p:cNvSpPr>
            <a:spLocks noGrp="1"/>
          </p:cNvSpPr>
          <p:nvPr>
            <p:ph type="pic" idx="1"/>
          </p:nvPr>
        </p:nvSpPr>
        <p:spPr>
          <a:xfrm>
            <a:off x="1" y="175570"/>
            <a:ext cx="4280003" cy="2917481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7" name="Picture Placeholder 2"/>
          <p:cNvSpPr>
            <a:spLocks noGrp="1"/>
          </p:cNvSpPr>
          <p:nvPr>
            <p:ph type="pic" idx="10"/>
          </p:nvPr>
        </p:nvSpPr>
        <p:spPr>
          <a:xfrm>
            <a:off x="1" y="3201045"/>
            <a:ext cx="4280003" cy="2917481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8" name="Picture Placeholder 2"/>
          <p:cNvSpPr>
            <a:spLocks noGrp="1"/>
          </p:cNvSpPr>
          <p:nvPr>
            <p:ph type="pic" idx="11"/>
          </p:nvPr>
        </p:nvSpPr>
        <p:spPr>
          <a:xfrm>
            <a:off x="1" y="6226521"/>
            <a:ext cx="4280003" cy="2917481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9" name="Picture Placeholder 2"/>
          <p:cNvSpPr>
            <a:spLocks noGrp="1"/>
          </p:cNvSpPr>
          <p:nvPr>
            <p:ph type="pic" idx="14"/>
          </p:nvPr>
        </p:nvSpPr>
        <p:spPr>
          <a:xfrm>
            <a:off x="5057794" y="191772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0" name="Picture Placeholder 2"/>
          <p:cNvSpPr>
            <a:spLocks noGrp="1"/>
          </p:cNvSpPr>
          <p:nvPr>
            <p:ph type="pic" idx="28"/>
          </p:nvPr>
        </p:nvSpPr>
        <p:spPr>
          <a:xfrm>
            <a:off x="5057794" y="1040596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1" name="Picture Placeholder 2"/>
          <p:cNvSpPr>
            <a:spLocks noGrp="1"/>
          </p:cNvSpPr>
          <p:nvPr>
            <p:ph type="pic" idx="29"/>
          </p:nvPr>
        </p:nvSpPr>
        <p:spPr>
          <a:xfrm>
            <a:off x="5057794" y="1889420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2" name="Picture Placeholder 2"/>
          <p:cNvSpPr>
            <a:spLocks noGrp="1"/>
          </p:cNvSpPr>
          <p:nvPr>
            <p:ph type="pic" idx="30"/>
          </p:nvPr>
        </p:nvSpPr>
        <p:spPr>
          <a:xfrm>
            <a:off x="5057794" y="2738244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4" name="Picture Placeholder 2"/>
          <p:cNvSpPr>
            <a:spLocks noGrp="1"/>
          </p:cNvSpPr>
          <p:nvPr>
            <p:ph type="pic" idx="31"/>
          </p:nvPr>
        </p:nvSpPr>
        <p:spPr>
          <a:xfrm>
            <a:off x="5057794" y="3201044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5" name="Picture Placeholder 2"/>
          <p:cNvSpPr>
            <a:spLocks noGrp="1"/>
          </p:cNvSpPr>
          <p:nvPr>
            <p:ph type="pic" idx="32"/>
          </p:nvPr>
        </p:nvSpPr>
        <p:spPr>
          <a:xfrm>
            <a:off x="5057794" y="4049868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6" name="Picture Placeholder 2"/>
          <p:cNvSpPr>
            <a:spLocks noGrp="1"/>
          </p:cNvSpPr>
          <p:nvPr>
            <p:ph type="pic" idx="33"/>
          </p:nvPr>
        </p:nvSpPr>
        <p:spPr>
          <a:xfrm>
            <a:off x="5057794" y="4898692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7" name="Picture Placeholder 2"/>
          <p:cNvSpPr>
            <a:spLocks noGrp="1"/>
          </p:cNvSpPr>
          <p:nvPr>
            <p:ph type="pic" idx="34"/>
          </p:nvPr>
        </p:nvSpPr>
        <p:spPr>
          <a:xfrm>
            <a:off x="5057794" y="5747516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8" name="Picture Placeholder 2"/>
          <p:cNvSpPr>
            <a:spLocks noGrp="1"/>
          </p:cNvSpPr>
          <p:nvPr>
            <p:ph type="pic" idx="35"/>
          </p:nvPr>
        </p:nvSpPr>
        <p:spPr>
          <a:xfrm>
            <a:off x="5057794" y="6239038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19" name="Picture Placeholder 2"/>
          <p:cNvSpPr>
            <a:spLocks noGrp="1"/>
          </p:cNvSpPr>
          <p:nvPr>
            <p:ph type="pic" idx="36"/>
          </p:nvPr>
        </p:nvSpPr>
        <p:spPr>
          <a:xfrm>
            <a:off x="5057794" y="7087862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20" name="Picture Placeholder 2"/>
          <p:cNvSpPr>
            <a:spLocks noGrp="1"/>
          </p:cNvSpPr>
          <p:nvPr>
            <p:ph type="pic" idx="37"/>
          </p:nvPr>
        </p:nvSpPr>
        <p:spPr>
          <a:xfrm>
            <a:off x="5057794" y="7936686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21" name="Picture Placeholder 2"/>
          <p:cNvSpPr>
            <a:spLocks noGrp="1"/>
          </p:cNvSpPr>
          <p:nvPr>
            <p:ph type="pic" idx="38"/>
          </p:nvPr>
        </p:nvSpPr>
        <p:spPr>
          <a:xfrm>
            <a:off x="5057794" y="8785508"/>
            <a:ext cx="420656" cy="36047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8185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42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395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262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570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937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335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285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550E0-27FA-434A-8E50-0A71B93C8E71}" type="datetimeFigureOut">
              <a:rPr lang="en-US" smtClean="0"/>
              <a:t>11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D5EF4-F789-0044-968B-BE383E251E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936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1" r:id="rId12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 Placeholder 356">
            <a:extLst>
              <a:ext uri="{FF2B5EF4-FFF2-40B4-BE49-F238E27FC236}">
                <a16:creationId xmlns:a16="http://schemas.microsoft.com/office/drawing/2014/main" id="{E07F2A6C-3C4E-D841-81EA-90184A4C530B}"/>
              </a:ext>
            </a:extLst>
          </p:cNvPr>
          <p:cNvSpPr txBox="1">
            <a:spLocks/>
          </p:cNvSpPr>
          <p:nvPr/>
        </p:nvSpPr>
        <p:spPr>
          <a:xfrm>
            <a:off x="11713" y="159179"/>
            <a:ext cx="6846287" cy="324631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etailed Media Conditions Utilized in this Study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ctr">
              <a:buNone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C0FFEF6-2C6E-0275-2888-B187B145C8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9834163"/>
              </p:ext>
            </p:extLst>
          </p:nvPr>
        </p:nvGraphicFramePr>
        <p:xfrm>
          <a:off x="1580902" y="636597"/>
          <a:ext cx="3696195" cy="6154266"/>
        </p:xfrm>
        <a:graphic>
          <a:graphicData uri="http://schemas.openxmlformats.org/drawingml/2006/table">
            <a:tbl>
              <a:tblPr firstRow="1" firstCol="1" bandRow="1"/>
              <a:tblGrid>
                <a:gridCol w="1231801">
                  <a:extLst>
                    <a:ext uri="{9D8B030D-6E8A-4147-A177-3AD203B41FA5}">
                      <a16:colId xmlns:a16="http://schemas.microsoft.com/office/drawing/2014/main" val="934644416"/>
                    </a:ext>
                  </a:extLst>
                </a:gridCol>
                <a:gridCol w="1232197">
                  <a:extLst>
                    <a:ext uri="{9D8B030D-6E8A-4147-A177-3AD203B41FA5}">
                      <a16:colId xmlns:a16="http://schemas.microsoft.com/office/drawing/2014/main" val="2041490697"/>
                    </a:ext>
                  </a:extLst>
                </a:gridCol>
                <a:gridCol w="1232197">
                  <a:extLst>
                    <a:ext uri="{9D8B030D-6E8A-4147-A177-3AD203B41FA5}">
                      <a16:colId xmlns:a16="http://schemas.microsoft.com/office/drawing/2014/main" val="3367456204"/>
                    </a:ext>
                  </a:extLst>
                </a:gridCol>
              </a:tblGrid>
              <a:tr h="13282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Rv1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4-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6815144"/>
                  </a:ext>
                </a:extLst>
              </a:tr>
              <a:tr h="11385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dia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MEM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MEM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8111638"/>
                  </a:ext>
                </a:extLst>
              </a:tr>
              <a:tr h="11385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ditives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scorbate (50µM-1mM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scorbate (1mM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8079046"/>
                  </a:ext>
                </a:extLst>
              </a:tr>
              <a:tr h="11385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tal Bovine Serum (10%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tal Bovine Serum (5%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7221444"/>
                  </a:ext>
                </a:extLst>
              </a:tr>
              <a:tr h="11385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nicillin (100 units/mL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nicillin (100 units/mL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4197044"/>
                  </a:ext>
                </a:extLst>
              </a:tr>
              <a:tr h="11385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reptomycin (100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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/mL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treptomycin (100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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/mL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9819841"/>
                  </a:ext>
                </a:extLst>
              </a:tr>
              <a:tr h="11385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Glutamine (0.292mg/mL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Glutamine (0.292mg/mL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4559265"/>
                  </a:ext>
                </a:extLst>
              </a:tr>
              <a:tr h="104363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1749032"/>
                  </a:ext>
                </a:extLst>
              </a:tr>
              <a:tr h="104363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i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tailed Media Conditions (mg/mL</a:t>
                      </a:r>
                      <a:r>
                        <a:rPr lang="en-US" sz="700" b="1" i="1" u="sng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091854"/>
                  </a:ext>
                </a:extLst>
              </a:tr>
              <a:tr h="104363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organic Salts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70033084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Cl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anhydrous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9263869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Cl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6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4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0089127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e(NO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9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2309147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2742214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Cl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6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3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1170739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SO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7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1243814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SO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anhydrous)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7.7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9042173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4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8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5427953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5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6970152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HCO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674171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ZnSO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7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5980974"/>
                  </a:ext>
                </a:extLst>
              </a:tr>
              <a:tr h="104363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ino Acids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69614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Argin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4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7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755623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Asparag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4250739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Cyst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2.57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308458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Cyst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H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.28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7702954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Glutam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4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7349442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lyc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7265084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Histid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Cl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9914392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Isoleuc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4.8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212526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 Leuc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4.8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1.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0796745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Lys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6.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2.6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2191661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Methion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8864485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Phenylalan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6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8317926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Ser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2795834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Threon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5.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8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144653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Tryptophan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9883201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Tyros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Na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H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3.79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1.89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3377413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-Valin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4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3476119"/>
                  </a:ext>
                </a:extLst>
              </a:tr>
              <a:tr h="104363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tamins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8025731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tin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8808699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-Calcium pantothenat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616781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oline chlorid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6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0923690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lic acid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2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25220712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-Inosito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2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7275169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noleic acid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1901390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L-Thioctic (lipoic) acid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2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8123293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icotinamid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8631696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yroxid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8509677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iboflavin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4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3293672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hiam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H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2576528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itamin B</a:t>
                      </a:r>
                      <a:r>
                        <a:rPr lang="en-US" sz="700" baseline="-25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36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0927121"/>
                  </a:ext>
                </a:extLst>
              </a:tr>
              <a:tr h="104363">
                <a:tc gridSpan="3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ther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4388122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-Glucos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00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00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9279560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henol red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Na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.00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3911412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utrescine 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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2HCl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16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2345673"/>
                  </a:ext>
                </a:extLst>
              </a:tr>
              <a:tr h="1043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odium pyruvate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0.00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2694" marR="426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849682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3178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345</TotalTime>
  <Words>289</Words>
  <Application>Microsoft Macintosh PowerPoint</Application>
  <PresentationFormat>On-screen Show (4:3)</PresentationFormat>
  <Paragraphs>16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Thomas Jeffers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o “C”, or not to “C”: Optimizing the conditions for pharmacological ascorbate in prostate cancer</dc:title>
  <dc:creator>TJU</dc:creator>
  <cp:lastModifiedBy>Shafi, Ayesha (NIH/NCI) [V]</cp:lastModifiedBy>
  <cp:revision>779</cp:revision>
  <cp:lastPrinted>2019-12-02T14:40:04Z</cp:lastPrinted>
  <dcterms:created xsi:type="dcterms:W3CDTF">2018-01-19T21:30:07Z</dcterms:created>
  <dcterms:modified xsi:type="dcterms:W3CDTF">2025-11-15T15:19:04Z</dcterms:modified>
</cp:coreProperties>
</file>